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9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267" r:id="rId2"/>
    <p:sldId id="266" r:id="rId3"/>
    <p:sldId id="265" r:id="rId4"/>
    <p:sldId id="263" r:id="rId5"/>
    <p:sldId id="262" r:id="rId6"/>
    <p:sldId id="264" r:id="rId7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88" autoAdjust="0"/>
    <p:restoredTop sz="94825" autoAdjust="0"/>
  </p:normalViewPr>
  <p:slideViewPr>
    <p:cSldViewPr snapToGrid="0">
      <p:cViewPr>
        <p:scale>
          <a:sx n="100" d="100"/>
          <a:sy n="100" d="100"/>
        </p:scale>
        <p:origin x="432" y="-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imed.uni-magdeburg.de\fme\Institute\TEF\alle\Manuscripts\Methylierung\oncogene\Revision\RAW%20data\figure%203\3A-B\V20210929%20ATP%20Assay%20with%20HeLa%20C8%20KO%20cells,%20different%20C8%20Mitations%20and%20Cd95%20treatment\V20210929%20Ergebnis%20n=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imed.uni-magdeburg.de\fme\Institute\TEF\alle\Manuscripts\Methylierung\oncogene\Revision\RAW%20data\figure%202\2F\V20210819%20Casp.3_7%20assay%20with%20cd95%20treatment%20and%20different%20Caspase-8%20Muutations\V20210819%20n=3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G:\Manuscripts\Methylierung\oncogene\Revision\RAW%20data\figure%202\2D\V20210729%20Casp.8%20assay%20with%20Casp.8%20mutations%20in%20HeLa%20KO%20and%20CD95%20treatment\V20210729%20Casp.8%20assay%20with%20Casp.8%20mutations%20in%20HeLa%20KO%20and%20CD95%20treatment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imed.uni-magdeburg.de\fme\Institute\TEF\Alle\Fabian\Experimente\2022\V20220111%20AMNIS-Experiment%20with%20HELa%20C8KO,%20different%20C8%20Mutations%20and%20CD95%20treatment\Auswertung%20n=%203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imed.uni-magdeburg.de\fme\Institute\TEF\Alle\Fabian\Experimente\2022\V20220324%20WB-Analysis_C3_%20of%20HeLa%20cells%20with%20C8%20mutations%20and%20CD95%20treatment\v20220410\V20220331%20Quantifizierung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imed.uni-magdeburg.de\fme\Institute\TEF\Alle\Fabian\Experimente\2022\V20220324%20WB-Analysis_C3_%20of%20HeLa%20cells%20with%20C8%20mutations%20and%20CD95%20treatment\v20220410\V20220331%20Quantifizierung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imed.uni-magdeburg.de\fme\Institute\TEF\Alle\Manuscripts\Methylierung\Figures\Assays\Caspase-3.7\AMI-5\V20190812%20Ergebnis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imed.uni-magdeburg.de\fme\Institute\TEF\Alle\Fabian\Experimente\Methylation_%20Revision\V20231204%20ATP-Assay%20after%20siRNA%20PRMT5%20KD%20in%20HeLa%20cells%20and%20CD95L%20treatment\analysis%202.0\reduing%20effect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\\imed.uni-magdeburg.de\fme\Institute\TEF\Alle\Fabian\Experimente\Methylation_%20Revision\V20231204%20ATP-Assay%20after%20siRNA%20PRMT5%20KD%20in%20HeLa%20cells%20and%20CD95L%20treatment\analysis%202.0\V20231212%20ATP%20with%20treatment%20n=3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566188865718161"/>
          <c:y val="0.2412118055555556"/>
          <c:w val="0.80190943041862583"/>
          <c:h val="0.6306374999999999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6h'!$N$3</c:f>
              <c:strCache>
                <c:ptCount val="1"/>
                <c:pt idx="0">
                  <c:v>untreated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6h'!$P$3,'6h'!$P$6,'6h'!$P$9,'6h'!$P$12,'6h'!$P$15)</c:f>
                <c:numCache>
                  <c:formatCode>General</c:formatCode>
                  <c:ptCount val="5"/>
                  <c:pt idx="0">
                    <c:v>1.7915041246767075E-2</c:v>
                  </c:pt>
                  <c:pt idx="1">
                    <c:v>2.4820890354037856E-2</c:v>
                  </c:pt>
                  <c:pt idx="2">
                    <c:v>5.006225764875828E-3</c:v>
                  </c:pt>
                  <c:pt idx="3">
                    <c:v>7.0099145909968078E-3</c:v>
                  </c:pt>
                  <c:pt idx="4">
                    <c:v>4.2705447893249425E-3</c:v>
                  </c:pt>
                </c:numCache>
              </c:numRef>
            </c:plus>
            <c:minus>
              <c:numRef>
                <c:f>('6h'!$P$3,'6h'!$P$6,'6h'!$P$9,'6h'!$P$12,'6h'!$P$15)</c:f>
                <c:numCache>
                  <c:formatCode>General</c:formatCode>
                  <c:ptCount val="5"/>
                  <c:pt idx="0">
                    <c:v>1.7915041246767075E-2</c:v>
                  </c:pt>
                  <c:pt idx="1">
                    <c:v>2.4820890354037856E-2</c:v>
                  </c:pt>
                  <c:pt idx="2">
                    <c:v>5.006225764875828E-3</c:v>
                  </c:pt>
                  <c:pt idx="3">
                    <c:v>7.0099145909968078E-3</c:v>
                  </c:pt>
                  <c:pt idx="4">
                    <c:v>4.2705447893249425E-3</c:v>
                  </c:pt>
                </c:numCache>
              </c:numRef>
            </c:minus>
            <c:spPr>
              <a:solidFill>
                <a:schemeClr val="tx1"/>
              </a:solidFill>
              <a:ln w="3175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cat>
            <c:strRef>
              <c:f>'6h'!$AD$4:$AH$4</c:f>
              <c:strCache>
                <c:ptCount val="5"/>
                <c:pt idx="0">
                  <c:v>vector </c:v>
                </c:pt>
                <c:pt idx="1">
                  <c:v>R233H</c:v>
                </c:pt>
                <c:pt idx="2">
                  <c:v>R435Q</c:v>
                </c:pt>
                <c:pt idx="3">
                  <c:v>WT</c:v>
                </c:pt>
                <c:pt idx="4">
                  <c:v>KO</c:v>
                </c:pt>
              </c:strCache>
            </c:strRef>
          </c:cat>
          <c:val>
            <c:numRef>
              <c:f>('6h'!$O$3,'6h'!$O$6,'6h'!$O$9,'6h'!$O$12,'6h'!$O$15)</c:f>
              <c:numCache>
                <c:formatCode>0.000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8D8-483B-8CAB-9F56B608F91D}"/>
            </c:ext>
          </c:extLst>
        </c:ser>
        <c:ser>
          <c:idx val="1"/>
          <c:order val="1"/>
          <c:tx>
            <c:strRef>
              <c:f>'6h'!$N$4</c:f>
              <c:strCache>
                <c:ptCount val="1"/>
                <c:pt idx="0">
                  <c:v>500 ng/ml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6h'!$P$4,'6h'!$P$7,'6h'!$P$10,'6h'!$P$13,'6h'!$P$16)</c:f>
                <c:numCache>
                  <c:formatCode>General</c:formatCode>
                  <c:ptCount val="5"/>
                  <c:pt idx="0">
                    <c:v>5.7433397808125321E-2</c:v>
                  </c:pt>
                  <c:pt idx="1">
                    <c:v>3.2432471354610984E-2</c:v>
                  </c:pt>
                  <c:pt idx="2">
                    <c:v>2.8805037252469294E-2</c:v>
                  </c:pt>
                  <c:pt idx="3">
                    <c:v>6.3822079502716206E-2</c:v>
                  </c:pt>
                  <c:pt idx="4">
                    <c:v>2.3747610782145073E-2</c:v>
                  </c:pt>
                </c:numCache>
              </c:numRef>
            </c:plus>
            <c:minus>
              <c:numRef>
                <c:f>('6h'!$P$4,'6h'!$P$7,'6h'!$P$10,'6h'!$P$13,'6h'!$P$16)</c:f>
                <c:numCache>
                  <c:formatCode>General</c:formatCode>
                  <c:ptCount val="5"/>
                  <c:pt idx="0">
                    <c:v>5.7433397808125321E-2</c:v>
                  </c:pt>
                  <c:pt idx="1">
                    <c:v>3.2432471354610984E-2</c:v>
                  </c:pt>
                  <c:pt idx="2">
                    <c:v>2.8805037252469294E-2</c:v>
                  </c:pt>
                  <c:pt idx="3">
                    <c:v>6.3822079502716206E-2</c:v>
                  </c:pt>
                  <c:pt idx="4">
                    <c:v>2.3747610782145073E-2</c:v>
                  </c:pt>
                </c:numCache>
              </c:numRef>
            </c:minus>
            <c:spPr>
              <a:solidFill>
                <a:schemeClr val="tx1"/>
              </a:solidFill>
              <a:ln w="3175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cat>
            <c:strRef>
              <c:f>'6h'!$AD$4:$AH$4</c:f>
              <c:strCache>
                <c:ptCount val="5"/>
                <c:pt idx="0">
                  <c:v>vector </c:v>
                </c:pt>
                <c:pt idx="1">
                  <c:v>R233H</c:v>
                </c:pt>
                <c:pt idx="2">
                  <c:v>R435Q</c:v>
                </c:pt>
                <c:pt idx="3">
                  <c:v>WT</c:v>
                </c:pt>
                <c:pt idx="4">
                  <c:v>KO</c:v>
                </c:pt>
              </c:strCache>
            </c:strRef>
          </c:cat>
          <c:val>
            <c:numRef>
              <c:f>('6h'!$O$4,'6h'!$O$7,'6h'!$O$10,'6h'!$O$13,'6h'!$O$16)</c:f>
              <c:numCache>
                <c:formatCode>0.000</c:formatCode>
                <c:ptCount val="5"/>
                <c:pt idx="0">
                  <c:v>0.9964335745718832</c:v>
                </c:pt>
                <c:pt idx="1">
                  <c:v>0.97922357990759135</c:v>
                </c:pt>
                <c:pt idx="2">
                  <c:v>0.92301499390318265</c:v>
                </c:pt>
                <c:pt idx="3">
                  <c:v>0.8445436424159164</c:v>
                </c:pt>
                <c:pt idx="4">
                  <c:v>0.970627781341445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8D8-483B-8CAB-9F56B608F91D}"/>
            </c:ext>
          </c:extLst>
        </c:ser>
        <c:ser>
          <c:idx val="2"/>
          <c:order val="2"/>
          <c:tx>
            <c:strRef>
              <c:f>'6h'!$N$5</c:f>
              <c:strCache>
                <c:ptCount val="1"/>
                <c:pt idx="0">
                  <c:v>1000 ng/ml</c:v>
                </c:pt>
              </c:strCache>
            </c:strRef>
          </c:tx>
          <c:spPr>
            <a:solidFill>
              <a:schemeClr val="dk1">
                <a:tint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6h'!$P$5,'6h'!$P$8,'6h'!$P$11,'6h'!$P$14,'6h'!$P$17)</c:f>
                <c:numCache>
                  <c:formatCode>General</c:formatCode>
                  <c:ptCount val="5"/>
                  <c:pt idx="0">
                    <c:v>6.5523119381802247E-2</c:v>
                  </c:pt>
                  <c:pt idx="1">
                    <c:v>3.3081954176285455E-2</c:v>
                  </c:pt>
                  <c:pt idx="2">
                    <c:v>2.4426835541627154E-2</c:v>
                  </c:pt>
                  <c:pt idx="3">
                    <c:v>5.1553136362291828E-2</c:v>
                  </c:pt>
                  <c:pt idx="4">
                    <c:v>2.9616766848906819E-2</c:v>
                  </c:pt>
                </c:numCache>
              </c:numRef>
            </c:plus>
            <c:minus>
              <c:numRef>
                <c:f>('6h'!$P$5,'6h'!$P$8,'6h'!$P$11,'6h'!$P$14,'6h'!$P$17)</c:f>
                <c:numCache>
                  <c:formatCode>General</c:formatCode>
                  <c:ptCount val="5"/>
                  <c:pt idx="0">
                    <c:v>6.5523119381802247E-2</c:v>
                  </c:pt>
                  <c:pt idx="1">
                    <c:v>3.3081954176285455E-2</c:v>
                  </c:pt>
                  <c:pt idx="2">
                    <c:v>2.4426835541627154E-2</c:v>
                  </c:pt>
                  <c:pt idx="3">
                    <c:v>5.1553136362291828E-2</c:v>
                  </c:pt>
                  <c:pt idx="4">
                    <c:v>2.9616766848906819E-2</c:v>
                  </c:pt>
                </c:numCache>
              </c:numRef>
            </c:minus>
            <c:spPr>
              <a:solidFill>
                <a:schemeClr val="tx1"/>
              </a:solidFill>
              <a:ln w="3175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cat>
            <c:strRef>
              <c:f>'6h'!$AD$4:$AH$4</c:f>
              <c:strCache>
                <c:ptCount val="5"/>
                <c:pt idx="0">
                  <c:v>vector </c:v>
                </c:pt>
                <c:pt idx="1">
                  <c:v>R233H</c:v>
                </c:pt>
                <c:pt idx="2">
                  <c:v>R435Q</c:v>
                </c:pt>
                <c:pt idx="3">
                  <c:v>WT</c:v>
                </c:pt>
                <c:pt idx="4">
                  <c:v>KO</c:v>
                </c:pt>
              </c:strCache>
            </c:strRef>
          </c:cat>
          <c:val>
            <c:numRef>
              <c:f>('6h'!$O$5,'6h'!$O$8,'6h'!$O$11,'6h'!$O$14,'6h'!$O$17)</c:f>
              <c:numCache>
                <c:formatCode>0.000</c:formatCode>
                <c:ptCount val="5"/>
                <c:pt idx="0">
                  <c:v>0.96416031661862622</c:v>
                </c:pt>
                <c:pt idx="1">
                  <c:v>0.94982357616265922</c:v>
                </c:pt>
                <c:pt idx="2">
                  <c:v>0.90353342215393939</c:v>
                </c:pt>
                <c:pt idx="3">
                  <c:v>0.74166914678244955</c:v>
                </c:pt>
                <c:pt idx="4">
                  <c:v>0.945544988523318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8D8-483B-8CAB-9F56B608F9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4784640"/>
        <c:axId val="214794624"/>
      </c:barChart>
      <c:catAx>
        <c:axId val="214784640"/>
        <c:scaling>
          <c:orientation val="minMax"/>
        </c:scaling>
        <c:delete val="0"/>
        <c:axPos val="b"/>
        <c:numFmt formatCode="#,##0" sourceLinked="0"/>
        <c:majorTickMark val="out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214794624"/>
        <c:crosses val="autoZero"/>
        <c:auto val="0"/>
        <c:lblAlgn val="ctr"/>
        <c:lblOffset val="100"/>
        <c:tickLblSkip val="1"/>
        <c:tickMarkSkip val="1"/>
        <c:noMultiLvlLbl val="0"/>
      </c:catAx>
      <c:valAx>
        <c:axId val="214794624"/>
        <c:scaling>
          <c:orientation val="minMax"/>
          <c:max val="1.3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norm.cell viability  [RU]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#,##0.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214784640"/>
        <c:crossesAt val="1"/>
        <c:crossBetween val="between"/>
        <c:majorUnit val="0.5"/>
        <c:minorUnit val="4.0000000000000008E-2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9470553134969906"/>
          <c:y val="2.9524999999999999E-2"/>
          <c:w val="0.35904245640165772"/>
          <c:h val="0.2049583231567007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</c:chart>
  <c:spPr>
    <a:noFill/>
    <a:ln w="6350" cap="flat" cmpd="sng" algn="ctr">
      <a:noFill/>
      <a:prstDash val="solid"/>
      <a:miter lim="800000"/>
    </a:ln>
    <a:effectLst/>
  </c:spPr>
  <c:txPr>
    <a:bodyPr/>
    <a:lstStyle/>
    <a:p>
      <a:pPr>
        <a:defRPr sz="6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393124999999999"/>
          <c:y val="0.16107986111111114"/>
          <c:w val="0.76380277777777783"/>
          <c:h val="0.7159750000000000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abelle1!$P$3</c:f>
              <c:strCache>
                <c:ptCount val="1"/>
                <c:pt idx="0">
                  <c:v>untreated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Tabelle1!$R$15:$R$17,Tabelle1!$R$3:$R$5)</c:f>
                <c:numCache>
                  <c:formatCode>General</c:formatCode>
                  <c:ptCount val="6"/>
                  <c:pt idx="0">
                    <c:v>1.356197837424915E-2</c:v>
                  </c:pt>
                  <c:pt idx="1">
                    <c:v>0.13048501888474379</c:v>
                  </c:pt>
                  <c:pt idx="2">
                    <c:v>7.0222236125982412E-2</c:v>
                  </c:pt>
                  <c:pt idx="3">
                    <c:v>6.1131114410950128E-2</c:v>
                  </c:pt>
                  <c:pt idx="4">
                    <c:v>6.1593883678169786E-2</c:v>
                  </c:pt>
                  <c:pt idx="5">
                    <c:v>2.5634632175619603E-2</c:v>
                  </c:pt>
                </c:numCache>
              </c:numRef>
            </c:plus>
            <c:minus>
              <c:numRef>
                <c:f>(Tabelle1!$R$15:$R$17,Tabelle1!$R$3:$R$5)</c:f>
                <c:numCache>
                  <c:formatCode>General</c:formatCode>
                  <c:ptCount val="6"/>
                  <c:pt idx="0">
                    <c:v>1.356197837424915E-2</c:v>
                  </c:pt>
                  <c:pt idx="1">
                    <c:v>0.13048501888474379</c:v>
                  </c:pt>
                  <c:pt idx="2">
                    <c:v>7.0222236125982412E-2</c:v>
                  </c:pt>
                  <c:pt idx="3">
                    <c:v>6.1131114410950128E-2</c:v>
                  </c:pt>
                  <c:pt idx="4">
                    <c:v>6.1593883678169786E-2</c:v>
                  </c:pt>
                  <c:pt idx="5">
                    <c:v>2.5634632175619603E-2</c:v>
                  </c:pt>
                </c:numCache>
              </c:numRef>
            </c:minus>
            <c:spPr>
              <a:solidFill>
                <a:schemeClr val="tx1"/>
              </a:solidFill>
              <a:ln w="317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(Tabelle1!$O$3,Tabelle1!$O$6,Tabelle1!$O$9,Tabelle1!$O$12)</c:f>
              <c:strCache>
                <c:ptCount val="4"/>
                <c:pt idx="0">
                  <c:v>vector</c:v>
                </c:pt>
                <c:pt idx="1">
                  <c:v>R233H</c:v>
                </c:pt>
                <c:pt idx="2">
                  <c:v>R435Q</c:v>
                </c:pt>
                <c:pt idx="3">
                  <c:v>WT</c:v>
                </c:pt>
              </c:strCache>
            </c:strRef>
          </c:cat>
          <c:val>
            <c:numRef>
              <c:f>(Tabelle1!$Q$3,Tabelle1!$Q$6,Tabelle1!$Q$9,Tabelle1!$Q$12)</c:f>
              <c:numCache>
                <c:formatCode>0.000</c:formatCode>
                <c:ptCount val="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CE0-4C14-AE35-80FB258E3C74}"/>
            </c:ext>
          </c:extLst>
        </c:ser>
        <c:ser>
          <c:idx val="1"/>
          <c:order val="1"/>
          <c:tx>
            <c:strRef>
              <c:f>Tabelle1!$P$5</c:f>
              <c:strCache>
                <c:ptCount val="1"/>
                <c:pt idx="0">
                  <c:v>500 ng/ml CD95L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Tabelle1!$R$18:$R$20,Tabelle1!$R$6:$R$8)</c:f>
                <c:numCache>
                  <c:formatCode>General</c:formatCode>
                  <c:ptCount val="6"/>
                  <c:pt idx="0">
                    <c:v>4.1686669187528405E-2</c:v>
                  </c:pt>
                  <c:pt idx="1">
                    <c:v>8.4443862689958404E-2</c:v>
                  </c:pt>
                  <c:pt idx="2">
                    <c:v>0.17714052392374705</c:v>
                  </c:pt>
                  <c:pt idx="3">
                    <c:v>2.0065096556028134E-2</c:v>
                  </c:pt>
                  <c:pt idx="4">
                    <c:v>0.13939585989658893</c:v>
                  </c:pt>
                  <c:pt idx="5">
                    <c:v>0.18339398459444634</c:v>
                  </c:pt>
                </c:numCache>
              </c:numRef>
            </c:plus>
            <c:minus>
              <c:numRef>
                <c:f>(Tabelle1!$R$18:$R$20,Tabelle1!$R$6:$R$8)</c:f>
                <c:numCache>
                  <c:formatCode>General</c:formatCode>
                  <c:ptCount val="6"/>
                  <c:pt idx="0">
                    <c:v>4.1686669187528405E-2</c:v>
                  </c:pt>
                  <c:pt idx="1">
                    <c:v>8.4443862689958404E-2</c:v>
                  </c:pt>
                  <c:pt idx="2">
                    <c:v>0.17714052392374705</c:v>
                  </c:pt>
                  <c:pt idx="3">
                    <c:v>2.0065096556028134E-2</c:v>
                  </c:pt>
                  <c:pt idx="4">
                    <c:v>0.13939585989658893</c:v>
                  </c:pt>
                  <c:pt idx="5">
                    <c:v>0.18339398459444634</c:v>
                  </c:pt>
                </c:numCache>
              </c:numRef>
            </c:minus>
            <c:spPr>
              <a:solidFill>
                <a:schemeClr val="tx1"/>
              </a:solidFill>
              <a:ln w="317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(Tabelle1!$O$3,Tabelle1!$O$6,Tabelle1!$O$9,Tabelle1!$O$12)</c:f>
              <c:strCache>
                <c:ptCount val="4"/>
                <c:pt idx="0">
                  <c:v>vector</c:v>
                </c:pt>
                <c:pt idx="1">
                  <c:v>R233H</c:v>
                </c:pt>
                <c:pt idx="2">
                  <c:v>R435Q</c:v>
                </c:pt>
                <c:pt idx="3">
                  <c:v>WT</c:v>
                </c:pt>
              </c:strCache>
            </c:strRef>
          </c:cat>
          <c:val>
            <c:numRef>
              <c:f>(Tabelle1!$Q$5,Tabelle1!$Q$8,Tabelle1!$Q$11,Tabelle1!$Q$14)</c:f>
              <c:numCache>
                <c:formatCode>0.000</c:formatCode>
                <c:ptCount val="4"/>
                <c:pt idx="0">
                  <c:v>0.85326444786557731</c:v>
                </c:pt>
                <c:pt idx="1">
                  <c:v>1.3189494589023665</c:v>
                </c:pt>
                <c:pt idx="2">
                  <c:v>1.6350649363973526</c:v>
                </c:pt>
                <c:pt idx="3">
                  <c:v>2.47801158864608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CE0-4C14-AE35-80FB258E3C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2731648"/>
        <c:axId val="72778880"/>
      </c:barChart>
      <c:catAx>
        <c:axId val="72731648"/>
        <c:scaling>
          <c:orientation val="minMax"/>
        </c:scaling>
        <c:delete val="0"/>
        <c:axPos val="b"/>
        <c:numFmt formatCode="#,##0" sourceLinked="0"/>
        <c:majorTickMark val="out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72778880"/>
        <c:crosses val="autoZero"/>
        <c:auto val="0"/>
        <c:lblAlgn val="ctr"/>
        <c:lblOffset val="100"/>
        <c:tickLblSkip val="1"/>
        <c:tickMarkSkip val="1"/>
        <c:noMultiLvlLbl val="0"/>
      </c:catAx>
      <c:valAx>
        <c:axId val="7277888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norm. casp. 3/7 activity [RU]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#,##0.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72731648"/>
        <c:crossesAt val="1"/>
        <c:crossBetween val="between"/>
        <c:majorUnit val="0.5"/>
        <c:minorUnit val="4.0000000000000008E-2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0680625"/>
          <c:y val="0.30059930555555553"/>
          <c:w val="0.41128124999999999"/>
          <c:h val="0.2078680555555555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</c:chart>
  <c:spPr>
    <a:noFill/>
    <a:ln w="6350" cap="flat" cmpd="sng" algn="ctr">
      <a:noFill/>
      <a:prstDash val="solid"/>
      <a:miter lim="800000"/>
    </a:ln>
    <a:effectLst/>
  </c:spPr>
  <c:txPr>
    <a:bodyPr/>
    <a:lstStyle/>
    <a:p>
      <a:pPr>
        <a:defRPr sz="6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398472222222221"/>
          <c:y val="0.21399652777777778"/>
          <c:w val="0.74476249999999999"/>
          <c:h val="0.6745736111111110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uswertung Statistik'!$B$21:$C$21</c:f>
              <c:strCache>
                <c:ptCount val="2"/>
                <c:pt idx="0">
                  <c:v>untreated 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Auswertung Statistik'!$C$23,'Auswertung Statistik'!$G$23,'Auswertung Statistik'!$K$23,'Auswertung Statistik'!$O$23)</c:f>
                <c:numCache>
                  <c:formatCode>General</c:formatCode>
                  <c:ptCount val="4"/>
                  <c:pt idx="0">
                    <c:v>2.9416644563341754E-2</c:v>
                  </c:pt>
                  <c:pt idx="1">
                    <c:v>8.6723383633150478E-2</c:v>
                  </c:pt>
                  <c:pt idx="2">
                    <c:v>5.5217541824262167E-2</c:v>
                  </c:pt>
                  <c:pt idx="3">
                    <c:v>8.7619233130096827E-2</c:v>
                  </c:pt>
                </c:numCache>
              </c:numRef>
            </c:plus>
            <c:minus>
              <c:numRef>
                <c:f>('Auswertung Statistik'!$C$23,'Auswertung Statistik'!$G$23,'Auswertung Statistik'!$K$23,'Auswertung Statistik'!$O$23)</c:f>
                <c:numCache>
                  <c:formatCode>General</c:formatCode>
                  <c:ptCount val="4"/>
                  <c:pt idx="0">
                    <c:v>2.9416644563341754E-2</c:v>
                  </c:pt>
                  <c:pt idx="1">
                    <c:v>8.6723383633150478E-2</c:v>
                  </c:pt>
                  <c:pt idx="2">
                    <c:v>5.5217541824262167E-2</c:v>
                  </c:pt>
                  <c:pt idx="3">
                    <c:v>8.7619233130096827E-2</c:v>
                  </c:pt>
                </c:numCache>
              </c:numRef>
            </c:minus>
            <c:spPr>
              <a:solidFill>
                <a:schemeClr val="tx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cat>
            <c:strRef>
              <c:f>'Auswertung Statistik'!$C$26:$F$26</c:f>
              <c:strCache>
                <c:ptCount val="4"/>
                <c:pt idx="0">
                  <c:v>vector</c:v>
                </c:pt>
                <c:pt idx="1">
                  <c:v>R233H</c:v>
                </c:pt>
                <c:pt idx="2">
                  <c:v>R435Q</c:v>
                </c:pt>
                <c:pt idx="3">
                  <c:v>WT</c:v>
                </c:pt>
              </c:strCache>
            </c:strRef>
          </c:cat>
          <c:val>
            <c:numRef>
              <c:f>('Auswertung Statistik'!$B$23,'Auswertung Statistik'!$F$23,'Auswertung Statistik'!$J$23,'Auswertung Statistik'!$N$23)</c:f>
              <c:numCache>
                <c:formatCode>General</c:formatCode>
                <c:ptCount val="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D42-4B40-B308-F78E9306C9BC}"/>
            </c:ext>
          </c:extLst>
        </c:ser>
        <c:ser>
          <c:idx val="1"/>
          <c:order val="1"/>
          <c:tx>
            <c:strRef>
              <c:f>'Auswertung Statistik'!$D$21:$E$21</c:f>
              <c:strCache>
                <c:ptCount val="2"/>
                <c:pt idx="0">
                  <c:v>500 ng/ml CD95L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Auswertung Statistik'!$E$23,'Auswertung Statistik'!$I$23,'Auswertung Statistik'!$M$23,'Auswertung Statistik'!$Q$23)</c:f>
                <c:numCache>
                  <c:formatCode>General</c:formatCode>
                  <c:ptCount val="4"/>
                  <c:pt idx="0">
                    <c:v>9.3482079227046766E-2</c:v>
                  </c:pt>
                  <c:pt idx="1">
                    <c:v>0.15061189465759517</c:v>
                  </c:pt>
                  <c:pt idx="2">
                    <c:v>0.23799155401672936</c:v>
                  </c:pt>
                  <c:pt idx="3">
                    <c:v>0.28718552629767524</c:v>
                  </c:pt>
                </c:numCache>
              </c:numRef>
            </c:plus>
            <c:minus>
              <c:numRef>
                <c:f>('Auswertung Statistik'!$E$23,'Auswertung Statistik'!$I$23,'Auswertung Statistik'!$M$23,'Auswertung Statistik'!$Q$23)</c:f>
                <c:numCache>
                  <c:formatCode>General</c:formatCode>
                  <c:ptCount val="4"/>
                  <c:pt idx="0">
                    <c:v>9.3482079227046766E-2</c:v>
                  </c:pt>
                  <c:pt idx="1">
                    <c:v>0.15061189465759517</c:v>
                  </c:pt>
                  <c:pt idx="2">
                    <c:v>0.23799155401672936</c:v>
                  </c:pt>
                  <c:pt idx="3">
                    <c:v>0.28718552629767524</c:v>
                  </c:pt>
                </c:numCache>
              </c:numRef>
            </c:minus>
            <c:spPr>
              <a:solidFill>
                <a:schemeClr val="tx1"/>
              </a:solidFill>
              <a:ln w="6350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cat>
            <c:strRef>
              <c:f>'Auswertung Statistik'!$C$26:$F$26</c:f>
              <c:strCache>
                <c:ptCount val="4"/>
                <c:pt idx="0">
                  <c:v>vector</c:v>
                </c:pt>
                <c:pt idx="1">
                  <c:v>R233H</c:v>
                </c:pt>
                <c:pt idx="2">
                  <c:v>R435Q</c:v>
                </c:pt>
                <c:pt idx="3">
                  <c:v>WT</c:v>
                </c:pt>
              </c:strCache>
            </c:strRef>
          </c:cat>
          <c:val>
            <c:numRef>
              <c:f>('Auswertung Statistik'!$D$23,'Auswertung Statistik'!$H$23,'Auswertung Statistik'!$L$23,'Auswertung Statistik'!$P$23)</c:f>
              <c:numCache>
                <c:formatCode>General</c:formatCode>
                <c:ptCount val="4"/>
                <c:pt idx="0">
                  <c:v>1.0100795269183185</c:v>
                </c:pt>
                <c:pt idx="1">
                  <c:v>1.1891020885917394</c:v>
                </c:pt>
                <c:pt idx="2">
                  <c:v>1.122465925311922</c:v>
                </c:pt>
                <c:pt idx="3">
                  <c:v>2.42442527152042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D42-4B40-B308-F78E9306C9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2731648"/>
        <c:axId val="72778880"/>
      </c:barChart>
      <c:catAx>
        <c:axId val="72731648"/>
        <c:scaling>
          <c:orientation val="minMax"/>
        </c:scaling>
        <c:delete val="0"/>
        <c:axPos val="b"/>
        <c:numFmt formatCode="#,##0" sourceLinked="0"/>
        <c:majorTickMark val="out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72778880"/>
        <c:crosses val="autoZero"/>
        <c:auto val="0"/>
        <c:lblAlgn val="ctr"/>
        <c:lblOffset val="100"/>
        <c:tickLblSkip val="1"/>
        <c:tickMarkSkip val="1"/>
        <c:noMultiLvlLbl val="0"/>
      </c:catAx>
      <c:valAx>
        <c:axId val="72778880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dirty="0" smtClean="0"/>
                  <a:t>norm.</a:t>
                </a:r>
                <a:r>
                  <a:rPr lang="de-DE" baseline="0" dirty="0" smtClean="0"/>
                  <a:t> casp.8 </a:t>
                </a:r>
                <a:r>
                  <a:rPr lang="de-DE" baseline="0" dirty="0" err="1" smtClean="0"/>
                  <a:t>activity</a:t>
                </a:r>
                <a:r>
                  <a:rPr lang="de-DE" baseline="0" dirty="0" smtClean="0"/>
                  <a:t> </a:t>
                </a:r>
                <a:r>
                  <a:rPr lang="de-DE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[</a:t>
                </a:r>
                <a:r>
                  <a:rPr lang="de-DE" dirty="0" smtClean="0"/>
                  <a:t>RU]</a:t>
                </a:r>
                <a:endParaRPr lang="de-DE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72731648"/>
        <c:crossesAt val="1"/>
        <c:crossBetween val="between"/>
        <c:minorUnit val="4.0000000000000008E-2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8022569444444447"/>
          <c:y val="0.29908125000000002"/>
          <c:w val="0.41621666666666668"/>
          <c:h val="0.254572222222222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</c:chart>
  <c:spPr>
    <a:noFill/>
    <a:ln w="6350" cap="flat" cmpd="sng" algn="ctr">
      <a:noFill/>
      <a:prstDash val="solid"/>
      <a:miter lim="800000"/>
    </a:ln>
    <a:effectLst/>
  </c:spPr>
  <c:txPr>
    <a:bodyPr/>
    <a:lstStyle/>
    <a:p>
      <a:pPr>
        <a:defRPr sz="6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547761647869948"/>
          <c:y val="4.7999444444444428E-2"/>
          <c:w val="0.78265418031862732"/>
          <c:h val="0.7791958974358974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uswertung standard'!$U$5</c:f>
              <c:strCache>
                <c:ptCount val="1"/>
                <c:pt idx="0">
                  <c:v>An+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Auswertung standard'!$P$4,'Auswertung standard'!$P$7,'Auswertung standard'!$P$10,'Auswertung standard'!$P$13,'Auswertung standard'!$P$16)</c:f>
                <c:numCache>
                  <c:formatCode>General</c:formatCode>
                  <c:ptCount val="5"/>
                  <c:pt idx="0">
                    <c:v>0.30220199646373386</c:v>
                  </c:pt>
                  <c:pt idx="1">
                    <c:v>0.15368175630901112</c:v>
                  </c:pt>
                  <c:pt idx="2">
                    <c:v>0.61274693163019733</c:v>
                  </c:pt>
                  <c:pt idx="3">
                    <c:v>0.6417609593056347</c:v>
                  </c:pt>
                  <c:pt idx="4">
                    <c:v>3.2578880776765047</c:v>
                  </c:pt>
                </c:numCache>
              </c:numRef>
            </c:plus>
            <c:minus>
              <c:numRef>
                <c:f>('Auswertung standard'!$P$4,'Auswertung standard'!$P$7,'Auswertung standard'!$P$10,'Auswertung standard'!$P$13,'Auswertung standard'!$P$16)</c:f>
                <c:numCache>
                  <c:formatCode>General</c:formatCode>
                  <c:ptCount val="5"/>
                  <c:pt idx="0">
                    <c:v>0.30220199646373386</c:v>
                  </c:pt>
                  <c:pt idx="1">
                    <c:v>0.15368175630901112</c:v>
                  </c:pt>
                  <c:pt idx="2">
                    <c:v>0.61274693163019733</c:v>
                  </c:pt>
                  <c:pt idx="3">
                    <c:v>0.6417609593056347</c:v>
                  </c:pt>
                  <c:pt idx="4">
                    <c:v>3.2578880776765047</c:v>
                  </c:pt>
                </c:numCache>
              </c:numRef>
            </c:minus>
            <c:spPr>
              <a:solidFill>
                <a:schemeClr val="tx1"/>
              </a:solidFill>
              <a:ln w="3175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cat>
            <c:strRef>
              <c:f>('Auswertung standard'!$I$3,'Auswertung standard'!$I$6,'Auswertung standard'!$I$9,'Auswertung standard'!$I$12,'Auswertung standard'!$I$15)</c:f>
              <c:strCache>
                <c:ptCount val="5"/>
                <c:pt idx="0">
                  <c:v>KO</c:v>
                </c:pt>
                <c:pt idx="1">
                  <c:v>vector</c:v>
                </c:pt>
                <c:pt idx="2">
                  <c:v>R233H</c:v>
                </c:pt>
                <c:pt idx="3">
                  <c:v>R435Q</c:v>
                </c:pt>
                <c:pt idx="4">
                  <c:v>WT</c:v>
                </c:pt>
              </c:strCache>
            </c:strRef>
          </c:cat>
          <c:val>
            <c:numRef>
              <c:f>('Auswertung standard'!$O$4,'Auswertung standard'!$O$7,'Auswertung standard'!$O$10,'Auswertung standard'!$O$13,'Auswertung standard'!$O$16)</c:f>
              <c:numCache>
                <c:formatCode>General</c:formatCode>
                <c:ptCount val="5"/>
                <c:pt idx="0">
                  <c:v>0.50319999999999998</c:v>
                </c:pt>
                <c:pt idx="1">
                  <c:v>0.46083333333333326</c:v>
                </c:pt>
                <c:pt idx="2">
                  <c:v>1.5331333333333335</c:v>
                </c:pt>
                <c:pt idx="3">
                  <c:v>2.4648333333333334</c:v>
                </c:pt>
                <c:pt idx="4">
                  <c:v>14.3907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A6D-4828-B41F-271C164BF3F1}"/>
            </c:ext>
          </c:extLst>
        </c:ser>
        <c:ser>
          <c:idx val="1"/>
          <c:order val="1"/>
          <c:tx>
            <c:strRef>
              <c:f>'Auswertung standard'!$V$5</c:f>
              <c:strCache>
                <c:ptCount val="1"/>
                <c:pt idx="0">
                  <c:v>An+/ PI+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Auswertung standard'!$N$4,'Auswertung standard'!$N$7,'Auswertung standard'!$N$10,'Auswertung standard'!$N$13,'Auswertung standard'!$N$16)</c:f>
                <c:numCache>
                  <c:formatCode>General</c:formatCode>
                  <c:ptCount val="5"/>
                  <c:pt idx="0">
                    <c:v>0.185773320653604</c:v>
                  </c:pt>
                  <c:pt idx="1">
                    <c:v>0.83333783065453093</c:v>
                  </c:pt>
                  <c:pt idx="2">
                    <c:v>0.93500370409248568</c:v>
                  </c:pt>
                  <c:pt idx="3">
                    <c:v>1.284755401709688</c:v>
                  </c:pt>
                  <c:pt idx="4">
                    <c:v>4.2843228270832512</c:v>
                  </c:pt>
                </c:numCache>
              </c:numRef>
            </c:plus>
            <c:minus>
              <c:numRef>
                <c:f>('Auswertung standard'!$N$4,'Auswertung standard'!$N$7,'Auswertung standard'!$N$10,'Auswertung standard'!$N$13,'Auswertung standard'!$N$16)</c:f>
                <c:numCache>
                  <c:formatCode>General</c:formatCode>
                  <c:ptCount val="5"/>
                  <c:pt idx="0">
                    <c:v>0.185773320653604</c:v>
                  </c:pt>
                  <c:pt idx="1">
                    <c:v>0.83333783065453093</c:v>
                  </c:pt>
                  <c:pt idx="2">
                    <c:v>0.93500370409248568</c:v>
                  </c:pt>
                  <c:pt idx="3">
                    <c:v>1.284755401709688</c:v>
                  </c:pt>
                  <c:pt idx="4">
                    <c:v>4.2843228270832512</c:v>
                  </c:pt>
                </c:numCache>
              </c:numRef>
            </c:minus>
            <c:spPr>
              <a:solidFill>
                <a:schemeClr val="tx1"/>
              </a:solidFill>
              <a:ln w="3175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errBars>
          <c:cat>
            <c:strRef>
              <c:f>('Auswertung standard'!$I$3,'Auswertung standard'!$I$6,'Auswertung standard'!$I$9,'Auswertung standard'!$I$12,'Auswertung standard'!$I$15)</c:f>
              <c:strCache>
                <c:ptCount val="5"/>
                <c:pt idx="0">
                  <c:v>KO</c:v>
                </c:pt>
                <c:pt idx="1">
                  <c:v>vector</c:v>
                </c:pt>
                <c:pt idx="2">
                  <c:v>R233H</c:v>
                </c:pt>
                <c:pt idx="3">
                  <c:v>R435Q</c:v>
                </c:pt>
                <c:pt idx="4">
                  <c:v>WT</c:v>
                </c:pt>
              </c:strCache>
            </c:strRef>
          </c:cat>
          <c:val>
            <c:numRef>
              <c:f>('Auswertung standard'!$M$4,'Auswertung standard'!$M$7,'Auswertung standard'!$M$10,'Auswertung standard'!$M$13,'Auswertung standard'!$M$16)</c:f>
              <c:numCache>
                <c:formatCode>General</c:formatCode>
                <c:ptCount val="5"/>
                <c:pt idx="0">
                  <c:v>1.405</c:v>
                </c:pt>
                <c:pt idx="1">
                  <c:v>2.2235999999999998</c:v>
                </c:pt>
                <c:pt idx="2">
                  <c:v>3.2602999999999995</c:v>
                </c:pt>
                <c:pt idx="3">
                  <c:v>3.0291333333333328</c:v>
                </c:pt>
                <c:pt idx="4">
                  <c:v>10.4647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A6D-4828-B41F-271C164BF3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2731648"/>
        <c:axId val="72778880"/>
      </c:barChart>
      <c:catAx>
        <c:axId val="72731648"/>
        <c:scaling>
          <c:orientation val="minMax"/>
        </c:scaling>
        <c:delete val="0"/>
        <c:axPos val="b"/>
        <c:numFmt formatCode="#,##0" sourceLinked="0"/>
        <c:majorTickMark val="out"/>
        <c:minorTickMark val="none"/>
        <c:tickLblPos val="low"/>
        <c:spPr>
          <a:noFill/>
          <a:ln w="9525" cap="flat" cmpd="sng" algn="ctr">
            <a:solidFill>
              <a:schemeClr val="tx1">
                <a:tint val="75000"/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72778880"/>
        <c:crosses val="autoZero"/>
        <c:auto val="0"/>
        <c:lblAlgn val="ctr"/>
        <c:lblOffset val="100"/>
        <c:tickLblSkip val="1"/>
        <c:tickMarkSkip val="1"/>
        <c:noMultiLvlLbl val="0"/>
      </c:catAx>
      <c:valAx>
        <c:axId val="72778880"/>
        <c:scaling>
          <c:orientation val="minMax"/>
          <c:max val="4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dirty="0" err="1" smtClean="0"/>
                  <a:t>gated</a:t>
                </a:r>
                <a:r>
                  <a:rPr lang="de-DE" dirty="0" smtClean="0"/>
                  <a:t> </a:t>
                </a:r>
                <a:r>
                  <a:rPr lang="de-DE" dirty="0" err="1" smtClean="0"/>
                  <a:t>postive</a:t>
                </a:r>
                <a:r>
                  <a:rPr lang="de-DE" dirty="0" smtClean="0"/>
                  <a:t> </a:t>
                </a:r>
                <a:r>
                  <a:rPr lang="de-DE" dirty="0" err="1"/>
                  <a:t>cells</a:t>
                </a:r>
                <a:r>
                  <a:rPr lang="de-DE" dirty="0"/>
                  <a:t> [%]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tint val="75000"/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72731648"/>
        <c:crossesAt val="1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9966085271317829"/>
          <c:y val="2.1690256410256407E-2"/>
          <c:w val="0.32913113695090446"/>
          <c:h val="0.1552731623931623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</c:chart>
  <c:spPr>
    <a:noFill/>
    <a:ln w="6350" cap="flat" cmpd="sng" algn="ctr">
      <a:noFill/>
      <a:prstDash val="solid"/>
      <a:miter lim="800000"/>
    </a:ln>
    <a:effectLst/>
  </c:spPr>
  <c:txPr>
    <a:bodyPr/>
    <a:lstStyle/>
    <a:p>
      <a:pPr>
        <a:defRPr sz="6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724920634920635"/>
          <c:y val="4.2333333333333334E-2"/>
          <c:w val="0.82883333333333331"/>
          <c:h val="0.895036666666666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abelle1!$A$5</c:f>
              <c:strCache>
                <c:ptCount val="1"/>
                <c:pt idx="0">
                  <c:v>Caspase-3 (p19)</c:v>
                </c:pt>
              </c:strCache>
            </c:strRef>
          </c:tx>
          <c:invertIfNegative val="0"/>
          <c:cat>
            <c:strRef>
              <c:f>Tabelle1!$M$15:$M$24</c:f>
              <c:strCache>
                <c:ptCount val="10"/>
                <c:pt idx="0">
                  <c:v>Vektor control</c:v>
                </c:pt>
                <c:pt idx="1">
                  <c:v>Vektor  500 ng/ml</c:v>
                </c:pt>
                <c:pt idx="2">
                  <c:v>R233H control</c:v>
                </c:pt>
                <c:pt idx="3">
                  <c:v>R233H 500 ng/ml</c:v>
                </c:pt>
                <c:pt idx="4">
                  <c:v>R435Q control</c:v>
                </c:pt>
                <c:pt idx="5">
                  <c:v>R435Q 500 ng/ml</c:v>
                </c:pt>
                <c:pt idx="6">
                  <c:v>WT control</c:v>
                </c:pt>
                <c:pt idx="7">
                  <c:v>WT 500 ng/ml</c:v>
                </c:pt>
                <c:pt idx="8">
                  <c:v>KO control</c:v>
                </c:pt>
                <c:pt idx="9">
                  <c:v>KO 500 ng/ml</c:v>
                </c:pt>
              </c:strCache>
            </c:strRef>
          </c:cat>
          <c:val>
            <c:numRef>
              <c:f>(Tabelle1!$C$5,Tabelle1!$E$5,Tabelle1!$G$5,Tabelle1!$I$5,Tabelle1!$K$5,Tabelle1!$M$5,Tabelle1!$O$5,Tabelle1!$Q$5,Tabelle1!$S$5,Tabelle1!$U$5)</c:f>
              <c:numCache>
                <c:formatCode>General</c:formatCode>
                <c:ptCount val="10"/>
                <c:pt idx="0">
                  <c:v>3.2856975717915723E-2</c:v>
                </c:pt>
                <c:pt idx="1">
                  <c:v>1.6510159690169241E-2</c:v>
                </c:pt>
                <c:pt idx="2">
                  <c:v>0.12062801635363192</c:v>
                </c:pt>
                <c:pt idx="3">
                  <c:v>0.56873700000000005</c:v>
                </c:pt>
                <c:pt idx="4">
                  <c:v>3.8894348066991768E-2</c:v>
                </c:pt>
                <c:pt idx="5">
                  <c:v>0.6681103397052689</c:v>
                </c:pt>
                <c:pt idx="6">
                  <c:v>0.14441268650470118</c:v>
                </c:pt>
                <c:pt idx="7">
                  <c:v>1.4847876085565339</c:v>
                </c:pt>
                <c:pt idx="8">
                  <c:v>5.6873140476464891E-2</c:v>
                </c:pt>
                <c:pt idx="9">
                  <c:v>1.224223464232245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866-484F-B184-623132E1CD62}"/>
            </c:ext>
          </c:extLst>
        </c:ser>
        <c:ser>
          <c:idx val="1"/>
          <c:order val="1"/>
          <c:tx>
            <c:strRef>
              <c:f>Tabelle1!$A$6</c:f>
              <c:strCache>
                <c:ptCount val="1"/>
                <c:pt idx="0">
                  <c:v>Caspase-3 (p17)</c:v>
                </c:pt>
              </c:strCache>
            </c:strRef>
          </c:tx>
          <c:invertIfNegative val="0"/>
          <c:cat>
            <c:strRef>
              <c:f>Tabelle1!$M$15:$M$24</c:f>
              <c:strCache>
                <c:ptCount val="10"/>
                <c:pt idx="0">
                  <c:v>Vektor control</c:v>
                </c:pt>
                <c:pt idx="1">
                  <c:v>Vektor  500 ng/ml</c:v>
                </c:pt>
                <c:pt idx="2">
                  <c:v>R233H control</c:v>
                </c:pt>
                <c:pt idx="3">
                  <c:v>R233H 500 ng/ml</c:v>
                </c:pt>
                <c:pt idx="4">
                  <c:v>R435Q control</c:v>
                </c:pt>
                <c:pt idx="5">
                  <c:v>R435Q 500 ng/ml</c:v>
                </c:pt>
                <c:pt idx="6">
                  <c:v>WT control</c:v>
                </c:pt>
                <c:pt idx="7">
                  <c:v>WT 500 ng/ml</c:v>
                </c:pt>
                <c:pt idx="8">
                  <c:v>KO control</c:v>
                </c:pt>
                <c:pt idx="9">
                  <c:v>KO 500 ng/ml</c:v>
                </c:pt>
              </c:strCache>
            </c:strRef>
          </c:cat>
          <c:val>
            <c:numRef>
              <c:f>(Tabelle1!$C$6,Tabelle1!$E$6,Tabelle1!$G$6,Tabelle1!$I$6,Tabelle1!$K$6,Tabelle1!$M$6,Tabelle1!$O$6,Tabelle1!$Q$6,Tabelle1!$S$6,Tabelle1!$U$6)</c:f>
              <c:numCache>
                <c:formatCode>General</c:formatCode>
                <c:ptCount val="10"/>
                <c:pt idx="0">
                  <c:v>7.1208288418046689E-2</c:v>
                </c:pt>
                <c:pt idx="1">
                  <c:v>5.2380194477918494E-2</c:v>
                </c:pt>
                <c:pt idx="2">
                  <c:v>0.22182840982447513</c:v>
                </c:pt>
                <c:pt idx="3">
                  <c:v>0.58130000000000004</c:v>
                </c:pt>
                <c:pt idx="4">
                  <c:v>0.12567691257457902</c:v>
                </c:pt>
                <c:pt idx="5">
                  <c:v>0.28185867276932014</c:v>
                </c:pt>
                <c:pt idx="6">
                  <c:v>0.10679554465727775</c:v>
                </c:pt>
                <c:pt idx="7">
                  <c:v>1.4847876085565339</c:v>
                </c:pt>
                <c:pt idx="8">
                  <c:v>7.1185869115154926E-2</c:v>
                </c:pt>
                <c:pt idx="9">
                  <c:v>3.32750950564545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866-484F-B184-623132E1CD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7798912"/>
        <c:axId val="47805184"/>
      </c:barChart>
      <c:catAx>
        <c:axId val="4779891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47805184"/>
        <c:crosses val="autoZero"/>
        <c:auto val="1"/>
        <c:lblAlgn val="ctr"/>
        <c:lblOffset val="100"/>
        <c:noMultiLvlLbl val="0"/>
      </c:catAx>
      <c:valAx>
        <c:axId val="478051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de-DE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orm.  </a:t>
                </a:r>
                <a:r>
                  <a:rPr lang="de-DE" sz="6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protein</a:t>
                </a:r>
                <a:r>
                  <a:rPr lang="de-DE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6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mount</a:t>
                </a:r>
                <a:r>
                  <a:rPr lang="de-DE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6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gainst</a:t>
                </a:r>
                <a:r>
                  <a:rPr lang="de-DE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6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r>
                  <a:rPr lang="de-DE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[RU</a:t>
                </a:r>
                <a:r>
                  <a:rPr lang="de-DE" sz="7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]</a:t>
                </a:r>
                <a:endParaRPr lang="de-DE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de-DE"/>
          </a:p>
        </c:txPr>
        <c:crossAx val="4779891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4049246031746035"/>
          <c:y val="0.10853222222222222"/>
          <c:w val="0.41685555555555565"/>
          <c:h val="0.20437999999999998"/>
        </c:manualLayout>
      </c:layout>
      <c:overlay val="0"/>
      <c:txPr>
        <a:bodyPr/>
        <a:lstStyle/>
        <a:p>
          <a:pPr>
            <a:defRPr sz="600"/>
          </a:pPr>
          <a:endParaRPr lang="de-DE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777619047619049"/>
          <c:y val="7.7611111111111117E-2"/>
          <c:w val="0.82948134920634908"/>
          <c:h val="0.8447777777777777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abelle1!$A$8</c:f>
              <c:strCache>
                <c:ptCount val="1"/>
                <c:pt idx="0">
                  <c:v>Caspase-8 (p43)</c:v>
                </c:pt>
              </c:strCache>
            </c:strRef>
          </c:tx>
          <c:invertIfNegative val="0"/>
          <c:val>
            <c:numRef>
              <c:f>(Tabelle1!$C$8,Tabelle1!$E$8,Tabelle1!$G$8,Tabelle1!$I$8,Tabelle1!$K$8,Tabelle1!$M$8,Tabelle1!$O$8,Tabelle1!$Q$8,Tabelle1!$S$8,Tabelle1!$U$8)</c:f>
              <c:numCache>
                <c:formatCode>General</c:formatCode>
                <c:ptCount val="10"/>
                <c:pt idx="0">
                  <c:v>2.3208660992479223E-2</c:v>
                </c:pt>
                <c:pt idx="1">
                  <c:v>1.9602404068423486E-2</c:v>
                </c:pt>
                <c:pt idx="2">
                  <c:v>0.37777197135040425</c:v>
                </c:pt>
                <c:pt idx="3">
                  <c:v>0.81736299999999995</c:v>
                </c:pt>
                <c:pt idx="4">
                  <c:v>0.15260647693216639</c:v>
                </c:pt>
                <c:pt idx="5">
                  <c:v>0.79062561040602097</c:v>
                </c:pt>
                <c:pt idx="6">
                  <c:v>0.33319899931489649</c:v>
                </c:pt>
                <c:pt idx="7">
                  <c:v>1.4847876085565339</c:v>
                </c:pt>
                <c:pt idx="8">
                  <c:v>6.8080438132558152E-2</c:v>
                </c:pt>
                <c:pt idx="9">
                  <c:v>0.17901104697786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4D1-4503-93D9-BCF5AAB4D9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7798912"/>
        <c:axId val="47805184"/>
      </c:barChart>
      <c:catAx>
        <c:axId val="4779891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47805184"/>
        <c:crosses val="autoZero"/>
        <c:auto val="1"/>
        <c:lblAlgn val="ctr"/>
        <c:lblOffset val="100"/>
        <c:noMultiLvlLbl val="0"/>
      </c:catAx>
      <c:valAx>
        <c:axId val="478051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de-DE" sz="600" dirty="0" smtClean="0"/>
                  <a:t>norm. </a:t>
                </a:r>
                <a:r>
                  <a:rPr lang="de-DE" sz="600" dirty="0" err="1"/>
                  <a:t>protein</a:t>
                </a:r>
                <a:r>
                  <a:rPr lang="de-DE" sz="600" dirty="0"/>
                  <a:t> </a:t>
                </a:r>
                <a:r>
                  <a:rPr lang="de-DE" sz="600" dirty="0" err="1" smtClean="0"/>
                  <a:t>amount</a:t>
                </a:r>
                <a:r>
                  <a:rPr lang="de-DE" sz="600" baseline="0" dirty="0" smtClean="0"/>
                  <a:t> </a:t>
                </a:r>
                <a:r>
                  <a:rPr lang="de-DE" sz="600" baseline="0" dirty="0" err="1" smtClean="0"/>
                  <a:t>against</a:t>
                </a:r>
                <a:r>
                  <a:rPr lang="de-DE" sz="600" baseline="0" dirty="0" smtClean="0"/>
                  <a:t> </a:t>
                </a:r>
                <a:r>
                  <a:rPr lang="de-DE" sz="600" baseline="0" dirty="0" err="1" smtClean="0"/>
                  <a:t>actin</a:t>
                </a:r>
                <a:r>
                  <a:rPr lang="de-DE" sz="600" baseline="0" dirty="0" smtClean="0"/>
                  <a:t> </a:t>
                </a:r>
                <a:r>
                  <a:rPr lang="de-DE" sz="600" baseline="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[RU]</a:t>
                </a:r>
                <a:endParaRPr lang="de-DE" sz="60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/>
            </a:pPr>
            <a:endParaRPr lang="de-DE"/>
          </a:p>
        </c:txPr>
        <c:crossAx val="4779891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9602738095238101"/>
          <c:y val="0.10579944444444446"/>
          <c:w val="0.42599642857142855"/>
          <c:h val="9.6956111111111118E-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7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977638888888888"/>
          <c:y val="0.17379145299145299"/>
          <c:w val="0.73368750000000005"/>
          <c:h val="0.797117777777777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n=2+4'!$M$3</c:f>
              <c:strCache>
                <c:ptCount val="1"/>
                <c:pt idx="0">
                  <c:v>2h+2h pre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n=2+4'!$P$3:$P$10</c:f>
                <c:numCache>
                  <c:formatCode>General</c:formatCode>
                  <c:ptCount val="8"/>
                  <c:pt idx="0">
                    <c:v>5.9304244674162267E-2</c:v>
                  </c:pt>
                  <c:pt idx="1">
                    <c:v>0.52836684765161768</c:v>
                  </c:pt>
                  <c:pt idx="2">
                    <c:v>0.1698443787861805</c:v>
                  </c:pt>
                  <c:pt idx="3">
                    <c:v>0.31127147602232058</c:v>
                  </c:pt>
                  <c:pt idx="4">
                    <c:v>0.26833672416411225</c:v>
                  </c:pt>
                  <c:pt idx="5">
                    <c:v>0.38302963545974272</c:v>
                  </c:pt>
                  <c:pt idx="6">
                    <c:v>0.38561423653886545</c:v>
                  </c:pt>
                  <c:pt idx="7">
                    <c:v>0.1251494896221427</c:v>
                  </c:pt>
                </c:numCache>
              </c:numRef>
            </c:plus>
            <c:minus>
              <c:numRef>
                <c:f>'n=2+4'!$P$3:$P$10</c:f>
                <c:numCache>
                  <c:formatCode>General</c:formatCode>
                  <c:ptCount val="8"/>
                  <c:pt idx="0">
                    <c:v>5.9304244674162267E-2</c:v>
                  </c:pt>
                  <c:pt idx="1">
                    <c:v>0.52836684765161768</c:v>
                  </c:pt>
                  <c:pt idx="2">
                    <c:v>0.1698443787861805</c:v>
                  </c:pt>
                  <c:pt idx="3">
                    <c:v>0.31127147602232058</c:v>
                  </c:pt>
                  <c:pt idx="4">
                    <c:v>0.26833672416411225</c:v>
                  </c:pt>
                  <c:pt idx="5">
                    <c:v>0.38302963545974272</c:v>
                  </c:pt>
                  <c:pt idx="6">
                    <c:v>0.38561423653886545</c:v>
                  </c:pt>
                  <c:pt idx="7">
                    <c:v>0.1251494896221427</c:v>
                  </c:pt>
                </c:numCache>
              </c:numRef>
            </c:minus>
            <c:spPr>
              <a:ln w="3175"/>
            </c:spPr>
          </c:errBars>
          <c:cat>
            <c:strRef>
              <c:f>'n=3'!$N$3:$N$10</c:f>
              <c:strCache>
                <c:ptCount val="8"/>
                <c:pt idx="0">
                  <c:v>unstimuliert</c:v>
                </c:pt>
                <c:pt idx="1">
                  <c:v>CD95</c:v>
                </c:pt>
                <c:pt idx="2">
                  <c:v>10µM AMI5</c:v>
                </c:pt>
                <c:pt idx="3">
                  <c:v>50µM AMI5</c:v>
                </c:pt>
                <c:pt idx="4">
                  <c:v>100µM AMI5</c:v>
                </c:pt>
                <c:pt idx="5">
                  <c:v>CD95+10µM AMI5</c:v>
                </c:pt>
                <c:pt idx="6">
                  <c:v>CD95+50µM AMI5</c:v>
                </c:pt>
                <c:pt idx="7">
                  <c:v>CD95+100µM AMI5</c:v>
                </c:pt>
              </c:strCache>
            </c:strRef>
          </c:cat>
          <c:val>
            <c:numRef>
              <c:f>'n=2+4'!$O$3:$O$10</c:f>
              <c:numCache>
                <c:formatCode>0.000</c:formatCode>
                <c:ptCount val="8"/>
                <c:pt idx="0">
                  <c:v>1</c:v>
                </c:pt>
                <c:pt idx="1">
                  <c:v>2.8891136911336304</c:v>
                </c:pt>
                <c:pt idx="2">
                  <c:v>0.96655167212988502</c:v>
                </c:pt>
                <c:pt idx="3">
                  <c:v>0.4364714693401513</c:v>
                </c:pt>
                <c:pt idx="4">
                  <c:v>0.39576115171691012</c:v>
                </c:pt>
                <c:pt idx="5">
                  <c:v>2.4913197957408024</c:v>
                </c:pt>
                <c:pt idx="6">
                  <c:v>2.430411035377702</c:v>
                </c:pt>
                <c:pt idx="7">
                  <c:v>1.4466685970825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08B-4543-B7BA-381BE191314F}"/>
            </c:ext>
          </c:extLst>
        </c:ser>
        <c:ser>
          <c:idx val="1"/>
          <c:order val="1"/>
          <c:tx>
            <c:strRef>
              <c:f>'n=2+4'!$M$11</c:f>
              <c:strCache>
                <c:ptCount val="1"/>
                <c:pt idx="0">
                  <c:v>2h+1h pre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'n=2+4'!$P$11:$P$18</c:f>
                <c:numCache>
                  <c:formatCode>General</c:formatCode>
                  <c:ptCount val="8"/>
                  <c:pt idx="0">
                    <c:v>2.7788697578599014E-2</c:v>
                  </c:pt>
                  <c:pt idx="1">
                    <c:v>0.71615411476482926</c:v>
                  </c:pt>
                  <c:pt idx="2">
                    <c:v>0.40559085667600092</c:v>
                  </c:pt>
                  <c:pt idx="3">
                    <c:v>6.4249056983060882E-2</c:v>
                  </c:pt>
                  <c:pt idx="4">
                    <c:v>0.10418255107290562</c:v>
                  </c:pt>
                  <c:pt idx="5">
                    <c:v>0.53249283024190874</c:v>
                  </c:pt>
                  <c:pt idx="6">
                    <c:v>0.18376915449439876</c:v>
                  </c:pt>
                  <c:pt idx="7">
                    <c:v>0.31273591344223467</c:v>
                  </c:pt>
                </c:numCache>
              </c:numRef>
            </c:plus>
            <c:minus>
              <c:numRef>
                <c:f>'n=2+4'!$P$11:$P$18</c:f>
                <c:numCache>
                  <c:formatCode>General</c:formatCode>
                  <c:ptCount val="8"/>
                  <c:pt idx="0">
                    <c:v>2.7788697578599014E-2</c:v>
                  </c:pt>
                  <c:pt idx="1">
                    <c:v>0.71615411476482926</c:v>
                  </c:pt>
                  <c:pt idx="2">
                    <c:v>0.40559085667600092</c:v>
                  </c:pt>
                  <c:pt idx="3">
                    <c:v>6.4249056983060882E-2</c:v>
                  </c:pt>
                  <c:pt idx="4">
                    <c:v>0.10418255107290562</c:v>
                  </c:pt>
                  <c:pt idx="5">
                    <c:v>0.53249283024190874</c:v>
                  </c:pt>
                  <c:pt idx="6">
                    <c:v>0.18376915449439876</c:v>
                  </c:pt>
                  <c:pt idx="7">
                    <c:v>0.31273591344223467</c:v>
                  </c:pt>
                </c:numCache>
              </c:numRef>
            </c:minus>
            <c:spPr>
              <a:ln w="3175"/>
            </c:spPr>
          </c:errBars>
          <c:cat>
            <c:strRef>
              <c:f>'n=3'!$N$3:$N$10</c:f>
              <c:strCache>
                <c:ptCount val="8"/>
                <c:pt idx="0">
                  <c:v>unstimuliert</c:v>
                </c:pt>
                <c:pt idx="1">
                  <c:v>CD95</c:v>
                </c:pt>
                <c:pt idx="2">
                  <c:v>10µM AMI5</c:v>
                </c:pt>
                <c:pt idx="3">
                  <c:v>50µM AMI5</c:v>
                </c:pt>
                <c:pt idx="4">
                  <c:v>100µM AMI5</c:v>
                </c:pt>
                <c:pt idx="5">
                  <c:v>CD95+10µM AMI5</c:v>
                </c:pt>
                <c:pt idx="6">
                  <c:v>CD95+50µM AMI5</c:v>
                </c:pt>
                <c:pt idx="7">
                  <c:v>CD95+100µM AMI5</c:v>
                </c:pt>
              </c:strCache>
            </c:strRef>
          </c:cat>
          <c:val>
            <c:numRef>
              <c:f>'n=2+4'!$O$11:$O$18</c:f>
              <c:numCache>
                <c:formatCode>0.000</c:formatCode>
                <c:ptCount val="8"/>
                <c:pt idx="0">
                  <c:v>1</c:v>
                </c:pt>
                <c:pt idx="1">
                  <c:v>2.3915155674124997</c:v>
                </c:pt>
                <c:pt idx="2">
                  <c:v>1.2779582828166418</c:v>
                </c:pt>
                <c:pt idx="3">
                  <c:v>0.61584090995877583</c:v>
                </c:pt>
                <c:pt idx="4">
                  <c:v>0.39194564521721104</c:v>
                </c:pt>
                <c:pt idx="5">
                  <c:v>2.1478849056572753</c:v>
                </c:pt>
                <c:pt idx="6">
                  <c:v>1.8227534189995025</c:v>
                </c:pt>
                <c:pt idx="7">
                  <c:v>0.996857947577741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08B-4543-B7BA-381BE19131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8398976"/>
        <c:axId val="99394304"/>
      </c:barChart>
      <c:catAx>
        <c:axId val="98398976"/>
        <c:scaling>
          <c:orientation val="minMax"/>
        </c:scaling>
        <c:delete val="1"/>
        <c:axPos val="b"/>
        <c:numFmt formatCode="#,##0" sourceLinked="0"/>
        <c:majorTickMark val="out"/>
        <c:minorTickMark val="none"/>
        <c:tickLblPos val="low"/>
        <c:crossAx val="99394304"/>
        <c:crosses val="autoZero"/>
        <c:auto val="0"/>
        <c:lblAlgn val="ctr"/>
        <c:lblOffset val="100"/>
        <c:tickLblSkip val="1"/>
        <c:tickMarkSkip val="1"/>
        <c:noMultiLvlLbl val="0"/>
      </c:catAx>
      <c:valAx>
        <c:axId val="9939430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6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de-DE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orm. casp.3/7 </a:t>
                </a:r>
                <a:r>
                  <a:rPr lang="de-DE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ctivity</a:t>
                </a:r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[</a:t>
                </a:r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RU]</a:t>
                </a:r>
              </a:p>
            </c:rich>
          </c:tx>
          <c:layout/>
          <c:overlay val="0"/>
        </c:title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6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98398976"/>
        <c:crossesAt val="1"/>
        <c:crossBetween val="between"/>
      </c:valAx>
    </c:plotArea>
    <c:legend>
      <c:legendPos val="r"/>
      <c:layout>
        <c:manualLayout>
          <c:xMode val="edge"/>
          <c:yMode val="edge"/>
          <c:x val="0.23425694444444445"/>
          <c:y val="3.3488888888888952E-3"/>
          <c:w val="0.70841666666666669"/>
          <c:h val="0.15006222222222224"/>
        </c:manualLayout>
      </c:layout>
      <c:overlay val="0"/>
      <c:txPr>
        <a:bodyPr/>
        <a:lstStyle/>
        <a:p>
          <a:pPr>
            <a:defRPr sz="600">
              <a:latin typeface="Arial" panose="020B0604020202020204" pitchFamily="34" charset="0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</c:chart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785277777777778"/>
          <c:y val="5.7981666666666661E-2"/>
          <c:w val="0.74277222222222217"/>
          <c:h val="0.74350320793234181"/>
        </c:manualLayout>
      </c:layout>
      <c:scatterChart>
        <c:scatterStyle val="smoothMarker"/>
        <c:varyColors val="0"/>
        <c:ser>
          <c:idx val="0"/>
          <c:order val="0"/>
          <c:tx>
            <c:strRef>
              <c:f>Tabelle1!$A$2</c:f>
              <c:strCache>
                <c:ptCount val="1"/>
                <c:pt idx="0">
                  <c:v>untransfected</c:v>
                </c:pt>
              </c:strCache>
            </c:strRef>
          </c:tx>
          <c:spPr>
            <a:ln w="19050" cap="rnd">
              <a:solidFill>
                <a:schemeClr val="accent3">
                  <a:shade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shade val="65000"/>
                </a:schemeClr>
              </a:solidFill>
              <a:ln w="9525">
                <a:solidFill>
                  <a:schemeClr val="accent3">
                    <a:shade val="65000"/>
                  </a:schemeClr>
                </a:solidFill>
              </a:ln>
              <a:effectLst/>
            </c:spPr>
          </c:marker>
          <c:xVal>
            <c:numRef>
              <c:f>Tabelle1!$B$2:$B$4</c:f>
              <c:numCache>
                <c:formatCode>General</c:formatCode>
                <c:ptCount val="3"/>
                <c:pt idx="0">
                  <c:v>0</c:v>
                </c:pt>
                <c:pt idx="1">
                  <c:v>125</c:v>
                </c:pt>
                <c:pt idx="2">
                  <c:v>250</c:v>
                </c:pt>
              </c:numCache>
            </c:numRef>
          </c:xVal>
          <c:yVal>
            <c:numRef>
              <c:f>Tabelle1!$E$2:$E$4</c:f>
              <c:numCache>
                <c:formatCode>General</c:formatCode>
                <c:ptCount val="3"/>
                <c:pt idx="0">
                  <c:v>0</c:v>
                </c:pt>
                <c:pt idx="1">
                  <c:v>0.21013292967042485</c:v>
                </c:pt>
                <c:pt idx="2">
                  <c:v>0.4864235150128187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8F9F-43DE-9E31-8BF7D2A79E10}"/>
            </c:ext>
          </c:extLst>
        </c:ser>
        <c:ser>
          <c:idx val="1"/>
          <c:order val="1"/>
          <c:tx>
            <c:strRef>
              <c:f>Tabelle1!$A$5</c:f>
              <c:strCache>
                <c:ptCount val="1"/>
                <c:pt idx="0">
                  <c:v>siRNA control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Tabelle1!$B$2:$B$4</c:f>
              <c:numCache>
                <c:formatCode>General</c:formatCode>
                <c:ptCount val="3"/>
                <c:pt idx="0">
                  <c:v>0</c:v>
                </c:pt>
                <c:pt idx="1">
                  <c:v>125</c:v>
                </c:pt>
                <c:pt idx="2">
                  <c:v>250</c:v>
                </c:pt>
              </c:numCache>
            </c:numRef>
          </c:xVal>
          <c:yVal>
            <c:numRef>
              <c:f>Tabelle1!$E$5:$E$7</c:f>
              <c:numCache>
                <c:formatCode>General</c:formatCode>
                <c:ptCount val="3"/>
                <c:pt idx="0">
                  <c:v>0</c:v>
                </c:pt>
                <c:pt idx="1">
                  <c:v>0.21222281263452447</c:v>
                </c:pt>
                <c:pt idx="2">
                  <c:v>0.46636346127333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F9F-43DE-9E31-8BF7D2A79E10}"/>
            </c:ext>
          </c:extLst>
        </c:ser>
        <c:ser>
          <c:idx val="2"/>
          <c:order val="2"/>
          <c:tx>
            <c:strRef>
              <c:f>Tabelle1!$A$8</c:f>
              <c:strCache>
                <c:ptCount val="1"/>
                <c:pt idx="0">
                  <c:v>siRNA PRMT5</c:v>
                </c:pt>
              </c:strCache>
            </c:strRef>
          </c:tx>
          <c:spPr>
            <a:ln w="19050" cap="rnd">
              <a:solidFill>
                <a:schemeClr val="accent3">
                  <a:tint val="6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tint val="65000"/>
                </a:schemeClr>
              </a:solidFill>
              <a:ln w="9525">
                <a:solidFill>
                  <a:schemeClr val="accent3">
                    <a:tint val="65000"/>
                  </a:schemeClr>
                </a:solidFill>
              </a:ln>
              <a:effectLst/>
            </c:spPr>
          </c:marker>
          <c:xVal>
            <c:numRef>
              <c:f>Tabelle1!$B$2:$B$4</c:f>
              <c:numCache>
                <c:formatCode>General</c:formatCode>
                <c:ptCount val="3"/>
                <c:pt idx="0">
                  <c:v>0</c:v>
                </c:pt>
                <c:pt idx="1">
                  <c:v>125</c:v>
                </c:pt>
                <c:pt idx="2">
                  <c:v>250</c:v>
                </c:pt>
              </c:numCache>
            </c:numRef>
          </c:xVal>
          <c:yVal>
            <c:numRef>
              <c:f>Tabelle1!$E$8:$E$10</c:f>
              <c:numCache>
                <c:formatCode>General</c:formatCode>
                <c:ptCount val="3"/>
                <c:pt idx="0">
                  <c:v>0</c:v>
                </c:pt>
                <c:pt idx="1">
                  <c:v>3.1583208529286422E-2</c:v>
                </c:pt>
                <c:pt idx="2">
                  <c:v>0.1764016019760055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2-8F9F-43DE-9E31-8BF7D2A79E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85697024"/>
        <c:axId val="585691448"/>
      </c:scatterChart>
      <c:valAx>
        <c:axId val="585697024"/>
        <c:scaling>
          <c:orientation val="minMax"/>
          <c:max val="25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dirty="0"/>
                  <a:t>6h CD95L [</a:t>
                </a:r>
                <a:r>
                  <a:rPr lang="de-DE" dirty="0" err="1"/>
                  <a:t>ng</a:t>
                </a:r>
                <a:r>
                  <a:rPr lang="de-DE" dirty="0"/>
                  <a:t>/ml]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585691448"/>
        <c:crosses val="autoZero"/>
        <c:crossBetween val="midCat"/>
      </c:valAx>
      <c:valAx>
        <c:axId val="5856914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b="1" dirty="0" smtClean="0"/>
                  <a:t>norm. </a:t>
                </a:r>
                <a:r>
                  <a:rPr lang="de-DE" b="1" dirty="0" err="1" smtClean="0"/>
                  <a:t>cell</a:t>
                </a:r>
                <a:r>
                  <a:rPr lang="de-DE" b="1" dirty="0" smtClean="0"/>
                  <a:t> </a:t>
                </a:r>
                <a:r>
                  <a:rPr lang="de-DE" b="1" dirty="0" err="1" smtClean="0"/>
                  <a:t>viability</a:t>
                </a:r>
                <a:r>
                  <a:rPr lang="de-DE" b="1" dirty="0" smtClean="0"/>
                  <a:t> </a:t>
                </a:r>
                <a:r>
                  <a:rPr lang="de-DE" b="1" dirty="0" err="1"/>
                  <a:t>loss</a:t>
                </a:r>
                <a:r>
                  <a:rPr lang="de-DE" b="1" dirty="0"/>
                  <a:t> [RU]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585697024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16824956255468065"/>
          <c:y val="7.7256124234470688E-2"/>
          <c:w val="0.52240333333333333"/>
          <c:h val="0.1899650043744531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928888888888888"/>
          <c:y val="0.17207685185185184"/>
          <c:w val="0.73748055555555558"/>
          <c:h val="0.7559844281209815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abelle1!$N$3</c:f>
              <c:strCache>
                <c:ptCount val="1"/>
                <c:pt idx="0">
                  <c:v>untreated</c:v>
                </c:pt>
              </c:strCache>
            </c:strRef>
          </c:tx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Tabelle1!$P$3,Tabelle1!$P$6,Tabelle1!$P$9)</c:f>
                <c:numCache>
                  <c:formatCode>General</c:formatCode>
                  <c:ptCount val="3"/>
                  <c:pt idx="0">
                    <c:v>3.4464998356600142E-2</c:v>
                  </c:pt>
                  <c:pt idx="1">
                    <c:v>5.2485295539483064E-2</c:v>
                  </c:pt>
                  <c:pt idx="2">
                    <c:v>5.3251176514917536E-2</c:v>
                  </c:pt>
                </c:numCache>
              </c:numRef>
            </c:plus>
            <c:minus>
              <c:numRef>
                <c:f>(Tabelle1!$P$3,Tabelle1!$P$6,Tabelle1!$P$9)</c:f>
                <c:numCache>
                  <c:formatCode>General</c:formatCode>
                  <c:ptCount val="3"/>
                  <c:pt idx="0">
                    <c:v>3.4464998356600142E-2</c:v>
                  </c:pt>
                  <c:pt idx="1">
                    <c:v>5.2485295539483064E-2</c:v>
                  </c:pt>
                  <c:pt idx="2">
                    <c:v>5.3251176514917536E-2</c:v>
                  </c:pt>
                </c:numCache>
              </c:numRef>
            </c:minus>
            <c:spPr>
              <a:solidFill>
                <a:schemeClr val="tx1"/>
              </a:solidFill>
              <a:ln w="317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([1]Sheet0!$M$31,[1]Sheet0!$M$37,[1]Sheet0!$M$43)</c:f>
              <c:strCache>
                <c:ptCount val="3"/>
                <c:pt idx="0">
                  <c:v>untransfected</c:v>
                </c:pt>
                <c:pt idx="1">
                  <c:v>siRNA control</c:v>
                </c:pt>
                <c:pt idx="2">
                  <c:v>siRNA PRMT5</c:v>
                </c:pt>
              </c:strCache>
            </c:strRef>
          </c:cat>
          <c:val>
            <c:numRef>
              <c:f>(Tabelle1!$O$3,Tabelle1!$O$6,Tabelle1!$O$9)</c:f>
              <c:numCache>
                <c:formatCode>0.000</c:formatCode>
                <c:ptCount val="3"/>
                <c:pt idx="0">
                  <c:v>1</c:v>
                </c:pt>
                <c:pt idx="1">
                  <c:v>0.96063205805932872</c:v>
                </c:pt>
                <c:pt idx="2">
                  <c:v>0.668640602335620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C14-4F8A-88A0-F2E839AB67AC}"/>
            </c:ext>
          </c:extLst>
        </c:ser>
        <c:ser>
          <c:idx val="1"/>
          <c:order val="1"/>
          <c:tx>
            <c:strRef>
              <c:f>Tabelle1!$N$4</c:f>
              <c:strCache>
                <c:ptCount val="1"/>
                <c:pt idx="0">
                  <c:v>125ng/ml CD95L</c:v>
                </c:pt>
              </c:strCache>
            </c:strRef>
          </c:tx>
          <c:spPr>
            <a:solidFill>
              <a:schemeClr val="dk1">
                <a:tint val="5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Tabelle1!$P$4,Tabelle1!$P$7,Tabelle1!$P$10)</c:f>
                <c:numCache>
                  <c:formatCode>General</c:formatCode>
                  <c:ptCount val="3"/>
                  <c:pt idx="0">
                    <c:v>3.2076979591271822E-2</c:v>
                  </c:pt>
                  <c:pt idx="1">
                    <c:v>3.181326081398389E-2</c:v>
                  </c:pt>
                  <c:pt idx="2">
                    <c:v>8.8541825657696319E-2</c:v>
                  </c:pt>
                </c:numCache>
              </c:numRef>
            </c:plus>
            <c:minus>
              <c:numRef>
                <c:f>(Tabelle1!$P$4,Tabelle1!$P$7,Tabelle1!$P$10)</c:f>
                <c:numCache>
                  <c:formatCode>General</c:formatCode>
                  <c:ptCount val="3"/>
                  <c:pt idx="0">
                    <c:v>3.2076979591271822E-2</c:v>
                  </c:pt>
                  <c:pt idx="1">
                    <c:v>3.181326081398389E-2</c:v>
                  </c:pt>
                  <c:pt idx="2">
                    <c:v>8.8541825657696319E-2</c:v>
                  </c:pt>
                </c:numCache>
              </c:numRef>
            </c:minus>
            <c:spPr>
              <a:solidFill>
                <a:schemeClr val="tx1"/>
              </a:solidFill>
              <a:ln w="317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([1]Sheet0!$M$31,[1]Sheet0!$M$37,[1]Sheet0!$M$43)</c:f>
              <c:strCache>
                <c:ptCount val="3"/>
                <c:pt idx="0">
                  <c:v>untransfected</c:v>
                </c:pt>
                <c:pt idx="1">
                  <c:v>siRNA control</c:v>
                </c:pt>
                <c:pt idx="2">
                  <c:v>siRNA PRMT5</c:v>
                </c:pt>
              </c:strCache>
            </c:strRef>
          </c:cat>
          <c:val>
            <c:numRef>
              <c:f>(Tabelle1!$O$4,Tabelle1!$O$7,Tabelle1!$O$10)</c:f>
              <c:numCache>
                <c:formatCode>0.000</c:formatCode>
                <c:ptCount val="3"/>
                <c:pt idx="0">
                  <c:v>0.78986707032957515</c:v>
                </c:pt>
                <c:pt idx="1">
                  <c:v>0.74840924542480425</c:v>
                </c:pt>
                <c:pt idx="2">
                  <c:v>0.63705739380633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C14-4F8A-88A0-F2E839AB67AC}"/>
            </c:ext>
          </c:extLst>
        </c:ser>
        <c:ser>
          <c:idx val="2"/>
          <c:order val="2"/>
          <c:tx>
            <c:strRef>
              <c:f>Tabelle1!$N$5</c:f>
              <c:strCache>
                <c:ptCount val="1"/>
                <c:pt idx="0">
                  <c:v>250ng/ml CD95L</c:v>
                </c:pt>
              </c:strCache>
            </c:strRef>
          </c:tx>
          <c:spPr>
            <a:solidFill>
              <a:schemeClr val="dk1">
                <a:tint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Tabelle1!$P$5,Tabelle1!$P$8,Tabelle1!$P$11)</c:f>
                <c:numCache>
                  <c:formatCode>General</c:formatCode>
                  <c:ptCount val="3"/>
                  <c:pt idx="0">
                    <c:v>3.3504672811197053E-2</c:v>
                  </c:pt>
                  <c:pt idx="1">
                    <c:v>3.863120060835494E-2</c:v>
                  </c:pt>
                  <c:pt idx="2">
                    <c:v>2.9375699544758924E-2</c:v>
                  </c:pt>
                </c:numCache>
              </c:numRef>
            </c:plus>
            <c:minus>
              <c:numRef>
                <c:f>(Tabelle1!$P$5,Tabelle1!$P$8,Tabelle1!$P$11)</c:f>
                <c:numCache>
                  <c:formatCode>General</c:formatCode>
                  <c:ptCount val="3"/>
                  <c:pt idx="0">
                    <c:v>3.3504672811197053E-2</c:v>
                  </c:pt>
                  <c:pt idx="1">
                    <c:v>3.863120060835494E-2</c:v>
                  </c:pt>
                  <c:pt idx="2">
                    <c:v>2.9375699544758924E-2</c:v>
                  </c:pt>
                </c:numCache>
              </c:numRef>
            </c:minus>
            <c:spPr>
              <a:solidFill>
                <a:schemeClr val="tx1"/>
              </a:solidFill>
              <a:ln w="3175" cap="flat" cmpd="sng" algn="ctr">
                <a:solidFill>
                  <a:schemeClr val="tx1">
                    <a:shade val="95000"/>
                    <a:satMod val="105000"/>
                  </a:schemeClr>
                </a:solidFill>
                <a:prstDash val="solid"/>
                <a:round/>
              </a:ln>
              <a:effectLst/>
            </c:spPr>
          </c:errBars>
          <c:cat>
            <c:strRef>
              <c:f>([1]Sheet0!$M$31,[1]Sheet0!$M$37,[1]Sheet0!$M$43)</c:f>
              <c:strCache>
                <c:ptCount val="3"/>
                <c:pt idx="0">
                  <c:v>untransfected</c:v>
                </c:pt>
                <c:pt idx="1">
                  <c:v>siRNA control</c:v>
                </c:pt>
                <c:pt idx="2">
                  <c:v>siRNA PRMT5</c:v>
                </c:pt>
              </c:strCache>
            </c:strRef>
          </c:cat>
          <c:val>
            <c:numRef>
              <c:f>(Tabelle1!$O$5,Tabelle1!$O$8,Tabelle1!$O$11)</c:f>
              <c:numCache>
                <c:formatCode>0.000</c:formatCode>
                <c:ptCount val="3"/>
                <c:pt idx="0">
                  <c:v>0.51357648498718123</c:v>
                </c:pt>
                <c:pt idx="1">
                  <c:v>0.49426859678599672</c:v>
                </c:pt>
                <c:pt idx="2">
                  <c:v>0.492239000359615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C14-4F8A-88A0-F2E839AB67A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8201600"/>
        <c:axId val="188277120"/>
      </c:barChart>
      <c:catAx>
        <c:axId val="188201600"/>
        <c:scaling>
          <c:orientation val="minMax"/>
        </c:scaling>
        <c:delete val="1"/>
        <c:axPos val="b"/>
        <c:numFmt formatCode="#,##0" sourceLinked="0"/>
        <c:majorTickMark val="out"/>
        <c:minorTickMark val="none"/>
        <c:tickLblPos val="low"/>
        <c:crossAx val="188277120"/>
        <c:crosses val="autoZero"/>
        <c:auto val="0"/>
        <c:lblAlgn val="ctr"/>
        <c:lblOffset val="100"/>
        <c:tickLblSkip val="1"/>
        <c:tickMarkSkip val="1"/>
        <c:noMultiLvlLbl val="0"/>
      </c:catAx>
      <c:valAx>
        <c:axId val="188277120"/>
        <c:scaling>
          <c:orientation val="minMax"/>
          <c:max val="1.190000000000000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dirty="0"/>
                  <a:t>norm</a:t>
                </a:r>
                <a:r>
                  <a:rPr lang="de-DE" dirty="0" smtClean="0"/>
                  <a:t>. </a:t>
                </a:r>
                <a:r>
                  <a:rPr lang="de-DE" dirty="0" err="1" smtClean="0"/>
                  <a:t>cell</a:t>
                </a:r>
                <a:r>
                  <a:rPr lang="de-DE" dirty="0" smtClean="0"/>
                  <a:t> </a:t>
                </a:r>
                <a:r>
                  <a:rPr lang="de-DE" dirty="0" err="1"/>
                  <a:t>viability</a:t>
                </a:r>
                <a:r>
                  <a:rPr lang="de-DE" dirty="0"/>
                  <a:t> [RU]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#,##0.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tint val="75000"/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88201600"/>
        <c:crossesAt val="1"/>
        <c:crossBetween val="between"/>
        <c:majorUnit val="0.2"/>
        <c:minorUnit val="4.0000000000000008E-2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"/>
          <c:y val="0"/>
          <c:w val="1"/>
          <c:h val="0.1390009259259259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gap"/>
    <c:showDLblsOverMax val="0"/>
  </c:chart>
  <c:spPr>
    <a:noFill/>
    <a:ln w="6350" cap="flat" cmpd="sng" algn="ctr">
      <a:noFill/>
      <a:prstDash val="solid"/>
      <a:miter lim="800000"/>
    </a:ln>
    <a:effectLst/>
  </c:spPr>
  <c:txPr>
    <a:bodyPr/>
    <a:lstStyle/>
    <a:p>
      <a:pPr>
        <a:defRPr sz="6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withinLinear" id="16">
  <a:schemeClr val="accent3"/>
</cs:colorStyle>
</file>

<file path=ppt/charts/colors6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90F815-1036-4EC8-91EE-6B5AB5BBCAE7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A997409-B50A-4E23-BCB5-88C415E11C6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58919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239963" y="1241425"/>
            <a:ext cx="2317750" cy="3349625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Treated and untreated</a:t>
            </a:r>
            <a:r>
              <a:rPr lang="en-GB" baseline="0" dirty="0" smtClean="0"/>
              <a:t> samples in HeLa C8 KO cells after transfection</a:t>
            </a:r>
            <a:endParaRPr lang="en-GB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1CE42B-8B87-4A5E-BDC5-E9749FFDD3B4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06239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239963" y="1241425"/>
            <a:ext cx="2317750" cy="3349625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A997409-B50A-4E23-BCB5-88C415E11C6E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680054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239963" y="1241425"/>
            <a:ext cx="2317750" cy="3349625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A997409-B50A-4E23-BCB5-88C415E11C6E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89207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90E5A-804E-4CD6-B929-A90AA5BE9C49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7132D-5907-424B-937C-88E5A7228B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65805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90E5A-804E-4CD6-B929-A90AA5BE9C49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7132D-5907-424B-937C-88E5A7228B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21848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90E5A-804E-4CD6-B929-A90AA5BE9C49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7132D-5907-424B-937C-88E5A7228B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0919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90E5A-804E-4CD6-B929-A90AA5BE9C49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7132D-5907-424B-937C-88E5A7228B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30805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90E5A-804E-4CD6-B929-A90AA5BE9C49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7132D-5907-424B-937C-88E5A7228B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4673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90E5A-804E-4CD6-B929-A90AA5BE9C49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7132D-5907-424B-937C-88E5A7228B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12553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90E5A-804E-4CD6-B929-A90AA5BE9C49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7132D-5907-424B-937C-88E5A7228B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59751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90E5A-804E-4CD6-B929-A90AA5BE9C49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7132D-5907-424B-937C-88E5A7228B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08529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90E5A-804E-4CD6-B929-A90AA5BE9C49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7132D-5907-424B-937C-88E5A7228B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23018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90E5A-804E-4CD6-B929-A90AA5BE9C49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7132D-5907-424B-937C-88E5A7228B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6780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490E5A-804E-4CD6-B929-A90AA5BE9C49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7132D-5907-424B-937C-88E5A7228B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05220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490E5A-804E-4CD6-B929-A90AA5BE9C49}" type="datetimeFigureOut">
              <a:rPr lang="en-GB" smtClean="0"/>
              <a:t>26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D7132D-5907-424B-937C-88E5A7228B5C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4875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png"/><Relationship Id="rId7" Type="http://schemas.openxmlformats.org/officeDocument/2006/relationships/image" Target="../media/image6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png"/><Relationship Id="rId10" Type="http://schemas.openxmlformats.org/officeDocument/2006/relationships/image" Target="../media/image9.tiff"/><Relationship Id="rId4" Type="http://schemas.openxmlformats.org/officeDocument/2006/relationships/image" Target="../media/image3.png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tiff"/><Relationship Id="rId13" Type="http://schemas.openxmlformats.org/officeDocument/2006/relationships/image" Target="../media/image22.tiff"/><Relationship Id="rId18" Type="http://schemas.openxmlformats.org/officeDocument/2006/relationships/image" Target="../media/image27.tiff"/><Relationship Id="rId26" Type="http://schemas.openxmlformats.org/officeDocument/2006/relationships/image" Target="../media/image35.tiff"/><Relationship Id="rId3" Type="http://schemas.openxmlformats.org/officeDocument/2006/relationships/image" Target="../media/image12.tiff"/><Relationship Id="rId21" Type="http://schemas.openxmlformats.org/officeDocument/2006/relationships/image" Target="../media/image30.tiff"/><Relationship Id="rId7" Type="http://schemas.openxmlformats.org/officeDocument/2006/relationships/image" Target="../media/image16.tiff"/><Relationship Id="rId12" Type="http://schemas.openxmlformats.org/officeDocument/2006/relationships/image" Target="../media/image21.tiff"/><Relationship Id="rId17" Type="http://schemas.openxmlformats.org/officeDocument/2006/relationships/image" Target="../media/image26.tiff"/><Relationship Id="rId25" Type="http://schemas.openxmlformats.org/officeDocument/2006/relationships/image" Target="../media/image34.tiff"/><Relationship Id="rId2" Type="http://schemas.openxmlformats.org/officeDocument/2006/relationships/image" Target="../media/image11.tiff"/><Relationship Id="rId16" Type="http://schemas.openxmlformats.org/officeDocument/2006/relationships/image" Target="../media/image25.tiff"/><Relationship Id="rId20" Type="http://schemas.openxmlformats.org/officeDocument/2006/relationships/image" Target="../media/image29.tiff"/><Relationship Id="rId29" Type="http://schemas.openxmlformats.org/officeDocument/2006/relationships/image" Target="../media/image38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tiff"/><Relationship Id="rId11" Type="http://schemas.openxmlformats.org/officeDocument/2006/relationships/image" Target="../media/image20.tiff"/><Relationship Id="rId24" Type="http://schemas.openxmlformats.org/officeDocument/2006/relationships/image" Target="../media/image33.tiff"/><Relationship Id="rId5" Type="http://schemas.openxmlformats.org/officeDocument/2006/relationships/image" Target="../media/image14.tiff"/><Relationship Id="rId15" Type="http://schemas.openxmlformats.org/officeDocument/2006/relationships/image" Target="../media/image24.tiff"/><Relationship Id="rId23" Type="http://schemas.openxmlformats.org/officeDocument/2006/relationships/image" Target="../media/image32.tiff"/><Relationship Id="rId28" Type="http://schemas.openxmlformats.org/officeDocument/2006/relationships/image" Target="../media/image37.tiff"/><Relationship Id="rId10" Type="http://schemas.openxmlformats.org/officeDocument/2006/relationships/image" Target="../media/image19.tiff"/><Relationship Id="rId19" Type="http://schemas.openxmlformats.org/officeDocument/2006/relationships/image" Target="../media/image28.tiff"/><Relationship Id="rId4" Type="http://schemas.openxmlformats.org/officeDocument/2006/relationships/image" Target="../media/image13.tiff"/><Relationship Id="rId9" Type="http://schemas.openxmlformats.org/officeDocument/2006/relationships/image" Target="../media/image18.tiff"/><Relationship Id="rId14" Type="http://schemas.openxmlformats.org/officeDocument/2006/relationships/image" Target="../media/image23.tiff"/><Relationship Id="rId22" Type="http://schemas.openxmlformats.org/officeDocument/2006/relationships/image" Target="../media/image31.tiff"/><Relationship Id="rId27" Type="http://schemas.openxmlformats.org/officeDocument/2006/relationships/image" Target="../media/image36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tiff"/><Relationship Id="rId2" Type="http://schemas.openxmlformats.org/officeDocument/2006/relationships/image" Target="../media/image39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tiff"/><Relationship Id="rId13" Type="http://schemas.openxmlformats.org/officeDocument/2006/relationships/chart" Target="../charts/chart5.xml"/><Relationship Id="rId18" Type="http://schemas.openxmlformats.org/officeDocument/2006/relationships/image" Target="../media/image50.tiff"/><Relationship Id="rId3" Type="http://schemas.openxmlformats.org/officeDocument/2006/relationships/chart" Target="../charts/chart1.xml"/><Relationship Id="rId7" Type="http://schemas.openxmlformats.org/officeDocument/2006/relationships/image" Target="../media/image41.tiff"/><Relationship Id="rId12" Type="http://schemas.openxmlformats.org/officeDocument/2006/relationships/image" Target="../media/image46.tiff"/><Relationship Id="rId17" Type="http://schemas.openxmlformats.org/officeDocument/2006/relationships/image" Target="../media/image49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48.tiff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11" Type="http://schemas.openxmlformats.org/officeDocument/2006/relationships/image" Target="../media/image45.tiff"/><Relationship Id="rId5" Type="http://schemas.openxmlformats.org/officeDocument/2006/relationships/chart" Target="../charts/chart3.xml"/><Relationship Id="rId15" Type="http://schemas.openxmlformats.org/officeDocument/2006/relationships/image" Target="../media/image47.tiff"/><Relationship Id="rId10" Type="http://schemas.openxmlformats.org/officeDocument/2006/relationships/image" Target="../media/image44.tiff"/><Relationship Id="rId4" Type="http://schemas.openxmlformats.org/officeDocument/2006/relationships/chart" Target="../charts/chart2.xml"/><Relationship Id="rId9" Type="http://schemas.openxmlformats.org/officeDocument/2006/relationships/image" Target="../media/image43.tiff"/><Relationship Id="rId14" Type="http://schemas.openxmlformats.org/officeDocument/2006/relationships/chart" Target="../charts/chart6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6.tiff"/><Relationship Id="rId13" Type="http://schemas.openxmlformats.org/officeDocument/2006/relationships/image" Target="../media/image61.tiff"/><Relationship Id="rId3" Type="http://schemas.openxmlformats.org/officeDocument/2006/relationships/image" Target="../media/image51.tiff"/><Relationship Id="rId7" Type="http://schemas.openxmlformats.org/officeDocument/2006/relationships/image" Target="../media/image55.tiff"/><Relationship Id="rId12" Type="http://schemas.openxmlformats.org/officeDocument/2006/relationships/image" Target="../media/image60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4.tiff"/><Relationship Id="rId11" Type="http://schemas.openxmlformats.org/officeDocument/2006/relationships/image" Target="../media/image59.tiff"/><Relationship Id="rId5" Type="http://schemas.openxmlformats.org/officeDocument/2006/relationships/image" Target="../media/image53.tiff"/><Relationship Id="rId10" Type="http://schemas.openxmlformats.org/officeDocument/2006/relationships/image" Target="../media/image58.tiff"/><Relationship Id="rId4" Type="http://schemas.openxmlformats.org/officeDocument/2006/relationships/image" Target="../media/image52.tiff"/><Relationship Id="rId9" Type="http://schemas.openxmlformats.org/officeDocument/2006/relationships/image" Target="../media/image57.tiff"/><Relationship Id="rId14" Type="http://schemas.openxmlformats.org/officeDocument/2006/relationships/image" Target="../media/image62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9.xml"/><Relationship Id="rId4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817750" y="254991"/>
            <a:ext cx="1387569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63" dirty="0">
                <a:latin typeface="Arial" panose="020B0604020202020204" pitchFamily="34" charset="0"/>
                <a:cs typeface="Arial" panose="020B0604020202020204" pitchFamily="34" charset="0"/>
              </a:rPr>
              <a:t>Fig. 1 </a:t>
            </a:r>
          </a:p>
        </p:txBody>
      </p:sp>
      <p:sp>
        <p:nvSpPr>
          <p:cNvPr id="35" name="TextBox 11">
            <a:extLst>
              <a:ext uri="{FF2B5EF4-FFF2-40B4-BE49-F238E27FC236}">
                <a16:creationId xmlns:a16="http://schemas.microsoft.com/office/drawing/2014/main" id="{2C66F5B0-5532-0B40-4A43-38648223F69E}"/>
              </a:ext>
            </a:extLst>
          </p:cNvPr>
          <p:cNvSpPr txBox="1"/>
          <p:nvPr/>
        </p:nvSpPr>
        <p:spPr>
          <a:xfrm>
            <a:off x="752769" y="722621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DE" dirty="0">
                <a:latin typeface="Arial" panose="020B0604020202020204" pitchFamily="34" charset="0"/>
                <a:cs typeface="Arial" panose="020B0604020202020204" pitchFamily="34" charset="0"/>
              </a:rPr>
              <a:t>PRMT5</a:t>
            </a: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3248" y="1025747"/>
            <a:ext cx="5041253" cy="3960000"/>
          </a:xfrm>
          <a:prstGeom prst="rect">
            <a:avLst/>
          </a:prstGeom>
        </p:spPr>
      </p:pic>
      <p:grpSp>
        <p:nvGrpSpPr>
          <p:cNvPr id="6" name="Gruppieren 5"/>
          <p:cNvGrpSpPr/>
          <p:nvPr/>
        </p:nvGrpSpPr>
        <p:grpSpPr>
          <a:xfrm>
            <a:off x="2634377" y="4023707"/>
            <a:ext cx="4221079" cy="902816"/>
            <a:chOff x="1598797" y="6120674"/>
            <a:chExt cx="4002486" cy="902816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3"/>
            <a:srcRect l="43485"/>
            <a:stretch/>
          </p:blipFill>
          <p:spPr>
            <a:xfrm>
              <a:off x="1598797" y="6120674"/>
              <a:ext cx="2050903" cy="902816"/>
            </a:xfrm>
            <a:prstGeom prst="rect">
              <a:avLst/>
            </a:prstGeom>
          </p:spPr>
        </p:pic>
        <p:sp>
          <p:nvSpPr>
            <p:cNvPr id="10" name="Textfeld 9"/>
            <p:cNvSpPr txBox="1"/>
            <p:nvPr/>
          </p:nvSpPr>
          <p:spPr>
            <a:xfrm>
              <a:off x="3552793" y="6713256"/>
              <a:ext cx="1729648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95-co-IP stimulated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3552793" y="6547689"/>
              <a:ext cx="1729648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95-co-IP untreated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3550380" y="6376374"/>
              <a:ext cx="2050903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de-DE" sz="900" dirty="0" smtClean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caspase-8-co-IP</a:t>
              </a:r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stimulated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feld 3"/>
            <p:cNvSpPr txBox="1"/>
            <p:nvPr/>
          </p:nvSpPr>
          <p:spPr>
            <a:xfrm>
              <a:off x="3552793" y="6215491"/>
              <a:ext cx="1729648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spase-8-co-IP untreated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7" name="Grafik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33538" y="5415448"/>
            <a:ext cx="2880000" cy="1836242"/>
          </a:xfrm>
          <a:prstGeom prst="rect">
            <a:avLst/>
          </a:prstGeom>
        </p:spPr>
      </p:pic>
      <p:sp>
        <p:nvSpPr>
          <p:cNvPr id="17" name="Textfeld 16"/>
          <p:cNvSpPr txBox="1"/>
          <p:nvPr/>
        </p:nvSpPr>
        <p:spPr>
          <a:xfrm>
            <a:off x="1341091" y="5040497"/>
            <a:ext cx="672364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Input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2329390" y="5057967"/>
            <a:ext cx="834563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caspase-8-co-IP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Gerade Verbindung 14"/>
          <p:cNvCxnSpPr/>
          <p:nvPr/>
        </p:nvCxnSpPr>
        <p:spPr>
          <a:xfrm flipH="1">
            <a:off x="1173273" y="5246241"/>
            <a:ext cx="1008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1" name="Gerade Verbindung 14"/>
          <p:cNvCxnSpPr/>
          <p:nvPr/>
        </p:nvCxnSpPr>
        <p:spPr>
          <a:xfrm flipH="1" flipV="1">
            <a:off x="2489902" y="5246241"/>
            <a:ext cx="468000" cy="1188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3" name="Textfeld 42"/>
          <p:cNvSpPr txBox="1"/>
          <p:nvPr/>
        </p:nvSpPr>
        <p:spPr>
          <a:xfrm>
            <a:off x="-154496" y="5247429"/>
            <a:ext cx="1288035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15min CD95L [166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ng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/ml]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Grafik 4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70049" y="7970001"/>
            <a:ext cx="2776741" cy="1836000"/>
          </a:xfrm>
          <a:prstGeom prst="rect">
            <a:avLst/>
          </a:prstGeom>
        </p:spPr>
      </p:pic>
      <p:sp>
        <p:nvSpPr>
          <p:cNvPr id="47" name="Textfeld 46"/>
          <p:cNvSpPr txBox="1"/>
          <p:nvPr/>
        </p:nvSpPr>
        <p:spPr>
          <a:xfrm>
            <a:off x="3026343" y="5064207"/>
            <a:ext cx="834563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Beads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Gerade Verbindung 14"/>
          <p:cNvCxnSpPr/>
          <p:nvPr/>
        </p:nvCxnSpPr>
        <p:spPr>
          <a:xfrm flipH="1">
            <a:off x="3344533" y="5256215"/>
            <a:ext cx="21123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49" name="Textfeld 48"/>
          <p:cNvSpPr txBox="1"/>
          <p:nvPr/>
        </p:nvSpPr>
        <p:spPr>
          <a:xfrm>
            <a:off x="1170049" y="5247429"/>
            <a:ext cx="258848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-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1686500" y="5247429"/>
            <a:ext cx="258848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-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>
            <a:off x="1447932" y="5247429"/>
            <a:ext cx="258848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+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1964383" y="5247429"/>
            <a:ext cx="258848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+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2515583" y="5247429"/>
            <a:ext cx="258848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-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2793466" y="5247429"/>
            <a:ext cx="258848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+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3309917" y="5247429"/>
            <a:ext cx="258848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+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241653" y="638352"/>
            <a:ext cx="1415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8" name="Textfeld 57"/>
          <p:cNvSpPr txBox="1"/>
          <p:nvPr/>
        </p:nvSpPr>
        <p:spPr>
          <a:xfrm>
            <a:off x="1813" y="4953401"/>
            <a:ext cx="1415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9" name="Textfeld 58"/>
          <p:cNvSpPr txBox="1"/>
          <p:nvPr/>
        </p:nvSpPr>
        <p:spPr>
          <a:xfrm>
            <a:off x="1376749" y="7588178"/>
            <a:ext cx="672364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Input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feld 59"/>
          <p:cNvSpPr txBox="1"/>
          <p:nvPr/>
        </p:nvSpPr>
        <p:spPr>
          <a:xfrm>
            <a:off x="2365048" y="7605648"/>
            <a:ext cx="834563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CD95-co-IP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Gerade Verbindung 14"/>
          <p:cNvCxnSpPr/>
          <p:nvPr/>
        </p:nvCxnSpPr>
        <p:spPr>
          <a:xfrm flipH="1">
            <a:off x="1208931" y="7793922"/>
            <a:ext cx="1008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2" name="Gerade Verbindung 14"/>
          <p:cNvCxnSpPr/>
          <p:nvPr/>
        </p:nvCxnSpPr>
        <p:spPr>
          <a:xfrm flipH="1" flipV="1">
            <a:off x="2525560" y="7793922"/>
            <a:ext cx="468000" cy="1188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3" name="Textfeld 62"/>
          <p:cNvSpPr txBox="1"/>
          <p:nvPr/>
        </p:nvSpPr>
        <p:spPr>
          <a:xfrm>
            <a:off x="-154496" y="7795110"/>
            <a:ext cx="1323137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15min CD95L [166 </a:t>
            </a:r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ng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/ml] 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feld 65"/>
          <p:cNvSpPr txBox="1"/>
          <p:nvPr/>
        </p:nvSpPr>
        <p:spPr>
          <a:xfrm>
            <a:off x="1187047" y="7795110"/>
            <a:ext cx="258848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-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feld 66"/>
          <p:cNvSpPr txBox="1"/>
          <p:nvPr/>
        </p:nvSpPr>
        <p:spPr>
          <a:xfrm>
            <a:off x="1722158" y="7795110"/>
            <a:ext cx="258848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-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feld 67"/>
          <p:cNvSpPr txBox="1"/>
          <p:nvPr/>
        </p:nvSpPr>
        <p:spPr>
          <a:xfrm>
            <a:off x="1464930" y="7795110"/>
            <a:ext cx="258848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+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feld 68"/>
          <p:cNvSpPr txBox="1"/>
          <p:nvPr/>
        </p:nvSpPr>
        <p:spPr>
          <a:xfrm>
            <a:off x="1987601" y="7795110"/>
            <a:ext cx="258848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+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2470378" y="7795110"/>
            <a:ext cx="258848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-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2773144" y="7795110"/>
            <a:ext cx="258848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+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1813" y="7580484"/>
            <a:ext cx="1415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5" name="Textfeld 74"/>
          <p:cNvSpPr txBox="1"/>
          <p:nvPr/>
        </p:nvSpPr>
        <p:spPr>
          <a:xfrm>
            <a:off x="3281643" y="5258235"/>
            <a:ext cx="834563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M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3254793" y="7778421"/>
            <a:ext cx="834563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M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1132010" y="4855515"/>
            <a:ext cx="27288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KW 6.4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1168640" y="7407844"/>
            <a:ext cx="269226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KW 6.4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4" name="Grafik 53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8" t="50698" r="1892" b="36338"/>
          <a:stretch/>
        </p:blipFill>
        <p:spPr>
          <a:xfrm>
            <a:off x="4613104" y="6168295"/>
            <a:ext cx="1800000" cy="27251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4" name="Textfeld 63"/>
          <p:cNvSpPr txBox="1"/>
          <p:nvPr/>
        </p:nvSpPr>
        <p:spPr>
          <a:xfrm>
            <a:off x="6352207" y="6262608"/>
            <a:ext cx="3481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25</a:t>
            </a:r>
          </a:p>
        </p:txBody>
      </p:sp>
      <p:sp>
        <p:nvSpPr>
          <p:cNvPr id="65" name="Textfeld 64"/>
          <p:cNvSpPr txBox="1"/>
          <p:nvPr/>
        </p:nvSpPr>
        <p:spPr>
          <a:xfrm>
            <a:off x="4037405" y="6137125"/>
            <a:ext cx="63054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EndoG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1" name="Grafik 70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2" t="4440" r="4385" b="83865"/>
          <a:stretch/>
        </p:blipFill>
        <p:spPr>
          <a:xfrm>
            <a:off x="4613104" y="6449275"/>
            <a:ext cx="1800000" cy="24774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3" name="Textfeld 72"/>
          <p:cNvSpPr txBox="1"/>
          <p:nvPr/>
        </p:nvSpPr>
        <p:spPr>
          <a:xfrm>
            <a:off x="6352207" y="6455517"/>
            <a:ext cx="3749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100</a:t>
            </a:r>
          </a:p>
        </p:txBody>
      </p:sp>
      <p:sp>
        <p:nvSpPr>
          <p:cNvPr id="77" name="Textfeld 76"/>
          <p:cNvSpPr txBox="1"/>
          <p:nvPr/>
        </p:nvSpPr>
        <p:spPr>
          <a:xfrm>
            <a:off x="3990066" y="6480293"/>
            <a:ext cx="67788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PARP1 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8" name="Grafik 77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175" b="55586"/>
          <a:stretch/>
        </p:blipFill>
        <p:spPr>
          <a:xfrm>
            <a:off x="4613104" y="6693180"/>
            <a:ext cx="1800000" cy="19013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9" name="Textfeld 78"/>
          <p:cNvSpPr txBox="1"/>
          <p:nvPr/>
        </p:nvSpPr>
        <p:spPr>
          <a:xfrm>
            <a:off x="4149191" y="6646715"/>
            <a:ext cx="51875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0" name="Grafik 79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7" t="13331" r="1625" b="77512"/>
          <a:stretch/>
        </p:blipFill>
        <p:spPr>
          <a:xfrm>
            <a:off x="4613104" y="5655812"/>
            <a:ext cx="1800000" cy="18748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1" name="Textfeld 80"/>
          <p:cNvSpPr txBox="1"/>
          <p:nvPr/>
        </p:nvSpPr>
        <p:spPr>
          <a:xfrm>
            <a:off x="6352207" y="5617117"/>
            <a:ext cx="3481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75</a:t>
            </a:r>
          </a:p>
        </p:txBody>
      </p:sp>
      <p:sp>
        <p:nvSpPr>
          <p:cNvPr id="82" name="Textfeld 81"/>
          <p:cNvSpPr txBox="1"/>
          <p:nvPr/>
        </p:nvSpPr>
        <p:spPr>
          <a:xfrm>
            <a:off x="3990560" y="5656567"/>
            <a:ext cx="67738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PRMT5 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3" name="Grafik 82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659" r="821" b="61069"/>
          <a:stretch/>
        </p:blipFill>
        <p:spPr>
          <a:xfrm>
            <a:off x="4613104" y="5851831"/>
            <a:ext cx="1800000" cy="17052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4" name="Textfeld 83"/>
          <p:cNvSpPr txBox="1"/>
          <p:nvPr/>
        </p:nvSpPr>
        <p:spPr>
          <a:xfrm>
            <a:off x="4102336" y="5805824"/>
            <a:ext cx="56561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WD45 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feld 84"/>
          <p:cNvSpPr txBox="1"/>
          <p:nvPr/>
        </p:nvSpPr>
        <p:spPr>
          <a:xfrm>
            <a:off x="6352207" y="5879061"/>
            <a:ext cx="3481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37</a:t>
            </a:r>
          </a:p>
        </p:txBody>
      </p:sp>
      <p:pic>
        <p:nvPicPr>
          <p:cNvPr id="86" name="Grafik 85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714" b="84201"/>
          <a:stretch/>
        </p:blipFill>
        <p:spPr>
          <a:xfrm>
            <a:off x="4613104" y="6026281"/>
            <a:ext cx="1800000" cy="14626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7" name="Textfeld 86"/>
          <p:cNvSpPr txBox="1"/>
          <p:nvPr/>
        </p:nvSpPr>
        <p:spPr>
          <a:xfrm>
            <a:off x="4080792" y="5994799"/>
            <a:ext cx="58715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RIOK1 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feld 87"/>
          <p:cNvSpPr txBox="1"/>
          <p:nvPr/>
        </p:nvSpPr>
        <p:spPr>
          <a:xfrm>
            <a:off x="6352207" y="5954826"/>
            <a:ext cx="4135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100</a:t>
            </a:r>
          </a:p>
        </p:txBody>
      </p:sp>
      <p:sp>
        <p:nvSpPr>
          <p:cNvPr id="89" name="Textfeld 88"/>
          <p:cNvSpPr txBox="1"/>
          <p:nvPr/>
        </p:nvSpPr>
        <p:spPr>
          <a:xfrm>
            <a:off x="4603059" y="5299185"/>
            <a:ext cx="803834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cytoso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feld 89"/>
          <p:cNvSpPr txBox="1"/>
          <p:nvPr/>
        </p:nvSpPr>
        <p:spPr>
          <a:xfrm>
            <a:off x="5633260" y="5299185"/>
            <a:ext cx="770951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nucleus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Gerade Verbindung 14"/>
          <p:cNvCxnSpPr/>
          <p:nvPr/>
        </p:nvCxnSpPr>
        <p:spPr>
          <a:xfrm flipH="1" flipV="1">
            <a:off x="4614893" y="5477986"/>
            <a:ext cx="792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2" name="Textfeld 91"/>
          <p:cNvSpPr txBox="1"/>
          <p:nvPr/>
        </p:nvSpPr>
        <p:spPr>
          <a:xfrm>
            <a:off x="6352207" y="5481258"/>
            <a:ext cx="37497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feld 92"/>
          <p:cNvSpPr txBox="1"/>
          <p:nvPr/>
        </p:nvSpPr>
        <p:spPr>
          <a:xfrm>
            <a:off x="4640527" y="5481826"/>
            <a:ext cx="13319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4" name="Textfeld 93"/>
          <p:cNvSpPr txBox="1"/>
          <p:nvPr/>
        </p:nvSpPr>
        <p:spPr>
          <a:xfrm>
            <a:off x="4762753" y="5481826"/>
            <a:ext cx="29010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95" name="Textfeld 94"/>
          <p:cNvSpPr txBox="1"/>
          <p:nvPr/>
        </p:nvSpPr>
        <p:spPr>
          <a:xfrm>
            <a:off x="4968594" y="5481826"/>
            <a:ext cx="2896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96" name="Textfeld 95"/>
          <p:cNvSpPr txBox="1"/>
          <p:nvPr/>
        </p:nvSpPr>
        <p:spPr>
          <a:xfrm>
            <a:off x="5616721" y="5481826"/>
            <a:ext cx="13319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7" name="Textfeld 96"/>
          <p:cNvSpPr txBox="1"/>
          <p:nvPr/>
        </p:nvSpPr>
        <p:spPr>
          <a:xfrm>
            <a:off x="5740698" y="5481826"/>
            <a:ext cx="3152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98" name="Textfeld 97"/>
          <p:cNvSpPr txBox="1"/>
          <p:nvPr/>
        </p:nvSpPr>
        <p:spPr>
          <a:xfrm>
            <a:off x="5931168" y="5481826"/>
            <a:ext cx="32714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99" name="Textfeld 98"/>
          <p:cNvSpPr txBox="1"/>
          <p:nvPr/>
        </p:nvSpPr>
        <p:spPr>
          <a:xfrm>
            <a:off x="6182175" y="5481826"/>
            <a:ext cx="3378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cxnSp>
        <p:nvCxnSpPr>
          <p:cNvPr id="100" name="Gerade Verbindung 14"/>
          <p:cNvCxnSpPr/>
          <p:nvPr/>
        </p:nvCxnSpPr>
        <p:spPr>
          <a:xfrm flipH="1">
            <a:off x="5612211" y="5477986"/>
            <a:ext cx="792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1" name="Textfeld 100"/>
          <p:cNvSpPr txBox="1"/>
          <p:nvPr/>
        </p:nvSpPr>
        <p:spPr>
          <a:xfrm>
            <a:off x="5169001" y="5481826"/>
            <a:ext cx="30335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02" name="Textfeld 101"/>
          <p:cNvSpPr txBox="1"/>
          <p:nvPr/>
        </p:nvSpPr>
        <p:spPr>
          <a:xfrm>
            <a:off x="4603059" y="5185066"/>
            <a:ext cx="1801151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200 </a:t>
            </a:r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ng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/ml CD95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feld 102"/>
          <p:cNvSpPr txBox="1"/>
          <p:nvPr/>
        </p:nvSpPr>
        <p:spPr>
          <a:xfrm>
            <a:off x="5390868" y="5481826"/>
            <a:ext cx="2423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04" name="Textfeld 103"/>
          <p:cNvSpPr txBox="1"/>
          <p:nvPr/>
        </p:nvSpPr>
        <p:spPr>
          <a:xfrm>
            <a:off x="6352207" y="6740543"/>
            <a:ext cx="3481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37</a:t>
            </a:r>
          </a:p>
        </p:txBody>
      </p:sp>
      <p:sp>
        <p:nvSpPr>
          <p:cNvPr id="105" name="Textfeld 104"/>
          <p:cNvSpPr txBox="1"/>
          <p:nvPr/>
        </p:nvSpPr>
        <p:spPr>
          <a:xfrm>
            <a:off x="4195561" y="4962954"/>
            <a:ext cx="1742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6" name="Textfeld 105"/>
          <p:cNvSpPr txBox="1"/>
          <p:nvPr/>
        </p:nvSpPr>
        <p:spPr>
          <a:xfrm>
            <a:off x="4613104" y="4978634"/>
            <a:ext cx="18000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KW 6.4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feld 106"/>
          <p:cNvSpPr txBox="1"/>
          <p:nvPr/>
        </p:nvSpPr>
        <p:spPr>
          <a:xfrm>
            <a:off x="3023448" y="7603881"/>
            <a:ext cx="834563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Beads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Gerade Verbindung 14"/>
          <p:cNvCxnSpPr/>
          <p:nvPr/>
        </p:nvCxnSpPr>
        <p:spPr>
          <a:xfrm flipH="1">
            <a:off x="3341638" y="7795889"/>
            <a:ext cx="21123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9" name="Textfeld 108"/>
          <p:cNvSpPr txBox="1"/>
          <p:nvPr/>
        </p:nvSpPr>
        <p:spPr>
          <a:xfrm>
            <a:off x="3307022" y="7787103"/>
            <a:ext cx="258848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+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33990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476180" y="922115"/>
            <a:ext cx="2791046" cy="1240941"/>
            <a:chOff x="1079205" y="1671622"/>
            <a:chExt cx="2791046" cy="1240941"/>
          </a:xfrm>
        </p:grpSpPr>
        <p:pic>
          <p:nvPicPr>
            <p:cNvPr id="4" name="Picture 2" descr="G:\AG_Lavrik\Fabian\Experimente\V20190625 Casp.8 Co-IP with pre IP and SKw 6.4 cells+ CD95 treatment\V20190626\2.prmt5\marker+Wohlfromm, Fabian 2019-07-26 09hr 58min_Exposure_120.0sec.tif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67" t="14891" r="14780" b="76640"/>
            <a:stretch/>
          </p:blipFill>
          <p:spPr bwMode="auto">
            <a:xfrm>
              <a:off x="2001582" y="2133067"/>
              <a:ext cx="1462500" cy="15934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" name="Picture 3" descr="G:\AG_Lavrik\Fabian\Experimente\V20190625 Casp.8 Co-IP with pre IP and SKw 6.4 cells+ CD95 treatment\V20190626\3.wd45\s.e..ti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66" t="21664" r="13946" b="64214"/>
            <a:stretch/>
          </p:blipFill>
          <p:spPr bwMode="auto">
            <a:xfrm>
              <a:off x="2001582" y="2286531"/>
              <a:ext cx="1462500" cy="24288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" name="Picture 5" descr="G:\AG_Lavrik\Fabian\Experimente\V20190625 Casp.8 Co-IP with pre IP and SKw 6.4 cells+ CD95 treatment\V20190626\4.riok1\s.e..ti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511" r="13838" b="80080"/>
            <a:stretch/>
          </p:blipFill>
          <p:spPr bwMode="auto">
            <a:xfrm>
              <a:off x="2001582" y="2514288"/>
              <a:ext cx="1462500" cy="16964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" name="Picture 2" descr="G:\AG_Lavrik\Fabian\Experimente\V20190625 Casp.8 Co-IP with pre IP and SKw 6.4 cells+ CD95 treatment\V20190626\6.Casp.8\marker+Wohlfromm, Fabian 2019-08-06 10hr 22min_Exposure_16.5sec.tif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17" t="24407" r="11439" b="65074"/>
            <a:stretch/>
          </p:blipFill>
          <p:spPr bwMode="auto">
            <a:xfrm>
              <a:off x="2001582" y="2680379"/>
              <a:ext cx="1462500" cy="18796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Textfeld 7"/>
            <p:cNvSpPr txBox="1"/>
            <p:nvPr/>
          </p:nvSpPr>
          <p:spPr>
            <a:xfrm>
              <a:off x="1975956" y="1803166"/>
              <a:ext cx="672364" cy="18466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Input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2640569" y="1803166"/>
              <a:ext cx="834563" cy="18466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caspase-8-co-IP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" name="Gerade Verbindung 14"/>
            <p:cNvCxnSpPr/>
            <p:nvPr/>
          </p:nvCxnSpPr>
          <p:spPr>
            <a:xfrm flipH="1" flipV="1">
              <a:off x="2004819" y="1961530"/>
              <a:ext cx="6435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Textfeld 10"/>
            <p:cNvSpPr txBox="1"/>
            <p:nvPr/>
          </p:nvSpPr>
          <p:spPr>
            <a:xfrm>
              <a:off x="1224629" y="2145062"/>
              <a:ext cx="8248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PRMT5 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3466147" y="2121548"/>
              <a:ext cx="3210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75</a:t>
              </a:r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3466147" y="1964824"/>
              <a:ext cx="40410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2013990" y="1964824"/>
              <a:ext cx="10821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2087345" y="1964824"/>
              <a:ext cx="28215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2271477" y="1964824"/>
              <a:ext cx="31003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2703443" y="1964824"/>
              <a:ext cx="10821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2780936" y="1964824"/>
              <a:ext cx="28627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2930134" y="1964824"/>
              <a:ext cx="31028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3101963" y="1964824"/>
              <a:ext cx="29392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3357892" y="1964824"/>
              <a:ext cx="8130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cxnSp>
          <p:nvCxnSpPr>
            <p:cNvPr id="22" name="Gerade Verbindung 14"/>
            <p:cNvCxnSpPr/>
            <p:nvPr/>
          </p:nvCxnSpPr>
          <p:spPr>
            <a:xfrm flipH="1" flipV="1">
              <a:off x="2688052" y="1961530"/>
              <a:ext cx="7605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Textfeld 22"/>
            <p:cNvSpPr txBox="1"/>
            <p:nvPr/>
          </p:nvSpPr>
          <p:spPr>
            <a:xfrm>
              <a:off x="2453486" y="1964824"/>
              <a:ext cx="29269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1221481" y="2312989"/>
              <a:ext cx="8248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WD45 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3466147" y="2226921"/>
              <a:ext cx="3630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</a:p>
          </p:txBody>
        </p:sp>
        <p:sp>
          <p:nvSpPr>
            <p:cNvPr id="26" name="Textfeld 25"/>
            <p:cNvSpPr txBox="1"/>
            <p:nvPr/>
          </p:nvSpPr>
          <p:spPr>
            <a:xfrm>
              <a:off x="3466147" y="2390560"/>
              <a:ext cx="3630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</a:p>
          </p:txBody>
        </p:sp>
        <p:sp>
          <p:nvSpPr>
            <p:cNvPr id="27" name="Textfeld 26"/>
            <p:cNvSpPr txBox="1"/>
            <p:nvPr/>
          </p:nvSpPr>
          <p:spPr>
            <a:xfrm>
              <a:off x="1221481" y="2522241"/>
              <a:ext cx="8248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RIOK1 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feld 27"/>
            <p:cNvSpPr txBox="1"/>
            <p:nvPr/>
          </p:nvSpPr>
          <p:spPr>
            <a:xfrm>
              <a:off x="3466147" y="2557450"/>
              <a:ext cx="3210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75</a:t>
              </a:r>
            </a:p>
          </p:txBody>
        </p:sp>
        <p:sp>
          <p:nvSpPr>
            <p:cNvPr id="29" name="Textfeld 28"/>
            <p:cNvSpPr txBox="1"/>
            <p:nvPr/>
          </p:nvSpPr>
          <p:spPr>
            <a:xfrm>
              <a:off x="3466147" y="2474029"/>
              <a:ext cx="40410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100</a:t>
              </a:r>
            </a:p>
          </p:txBody>
        </p:sp>
        <p:sp>
          <p:nvSpPr>
            <p:cNvPr id="30" name="Textfeld 29"/>
            <p:cNvSpPr txBox="1"/>
            <p:nvPr/>
          </p:nvSpPr>
          <p:spPr>
            <a:xfrm>
              <a:off x="1079205" y="2694623"/>
              <a:ext cx="97028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procaspase-8a/b 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feld 30"/>
            <p:cNvSpPr txBox="1"/>
            <p:nvPr/>
          </p:nvSpPr>
          <p:spPr>
            <a:xfrm>
              <a:off x="3466147" y="2727897"/>
              <a:ext cx="3210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</a:p>
          </p:txBody>
        </p:sp>
        <p:sp>
          <p:nvSpPr>
            <p:cNvPr id="32" name="Textfeld 31"/>
            <p:cNvSpPr txBox="1"/>
            <p:nvPr/>
          </p:nvSpPr>
          <p:spPr>
            <a:xfrm>
              <a:off x="1281114" y="1964824"/>
              <a:ext cx="70711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[min]</a:t>
              </a:r>
            </a:p>
          </p:txBody>
        </p:sp>
        <p:sp>
          <p:nvSpPr>
            <p:cNvPr id="33" name="Textfeld 32"/>
            <p:cNvSpPr txBox="1"/>
            <p:nvPr/>
          </p:nvSpPr>
          <p:spPr>
            <a:xfrm>
              <a:off x="1998561" y="1671622"/>
              <a:ext cx="1465522" cy="184666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166 </a:t>
              </a:r>
              <a:r>
                <a:rPr lang="de-DE" sz="6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ng</a:t>
              </a:r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/ml CD95L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Gruppieren 2"/>
          <p:cNvGrpSpPr/>
          <p:nvPr/>
        </p:nvGrpSpPr>
        <p:grpSpPr>
          <a:xfrm>
            <a:off x="373619" y="2613106"/>
            <a:ext cx="2837807" cy="2654250"/>
            <a:chOff x="335519" y="3253270"/>
            <a:chExt cx="2837807" cy="2654250"/>
          </a:xfrm>
        </p:grpSpPr>
        <p:sp>
          <p:nvSpPr>
            <p:cNvPr id="36" name="Textfeld 35"/>
            <p:cNvSpPr txBox="1"/>
            <p:nvPr/>
          </p:nvSpPr>
          <p:spPr>
            <a:xfrm>
              <a:off x="2717938" y="3542358"/>
              <a:ext cx="41105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feld 36"/>
            <p:cNvSpPr txBox="1"/>
            <p:nvPr/>
          </p:nvSpPr>
          <p:spPr>
            <a:xfrm>
              <a:off x="1546336" y="3253270"/>
              <a:ext cx="102988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250 ng/mL CD95L </a:t>
              </a:r>
            </a:p>
          </p:txBody>
        </p:sp>
        <p:sp>
          <p:nvSpPr>
            <p:cNvPr id="38" name="Textfeld 37"/>
            <p:cNvSpPr txBox="1"/>
            <p:nvPr/>
          </p:nvSpPr>
          <p:spPr>
            <a:xfrm>
              <a:off x="1425282" y="3564976"/>
              <a:ext cx="20435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9" name="Textfeld 38"/>
            <p:cNvSpPr txBox="1"/>
            <p:nvPr/>
          </p:nvSpPr>
          <p:spPr>
            <a:xfrm>
              <a:off x="1806034" y="3564976"/>
              <a:ext cx="21106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40" name="Textfeld 39"/>
            <p:cNvSpPr txBox="1"/>
            <p:nvPr/>
          </p:nvSpPr>
          <p:spPr>
            <a:xfrm>
              <a:off x="1986268" y="3564976"/>
              <a:ext cx="20435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1" name="Textfeld 40"/>
            <p:cNvSpPr txBox="1"/>
            <p:nvPr/>
          </p:nvSpPr>
          <p:spPr>
            <a:xfrm>
              <a:off x="2125000" y="3564976"/>
              <a:ext cx="26851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42" name="Textfeld 41"/>
            <p:cNvSpPr txBox="1"/>
            <p:nvPr/>
          </p:nvSpPr>
          <p:spPr>
            <a:xfrm>
              <a:off x="1295909" y="3408924"/>
              <a:ext cx="73690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caspase-8-IP</a:t>
              </a:r>
            </a:p>
          </p:txBody>
        </p:sp>
        <p:sp>
          <p:nvSpPr>
            <p:cNvPr id="43" name="Textfeld 42"/>
            <p:cNvSpPr txBox="1"/>
            <p:nvPr/>
          </p:nvSpPr>
          <p:spPr>
            <a:xfrm>
              <a:off x="2386117" y="3564976"/>
              <a:ext cx="13768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4" name="Textfeld 43"/>
            <p:cNvSpPr txBox="1"/>
            <p:nvPr/>
          </p:nvSpPr>
          <p:spPr>
            <a:xfrm>
              <a:off x="2501899" y="3564976"/>
              <a:ext cx="24655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45" name="Textfeld 44"/>
            <p:cNvSpPr txBox="1"/>
            <p:nvPr/>
          </p:nvSpPr>
          <p:spPr>
            <a:xfrm>
              <a:off x="1884922" y="3408924"/>
              <a:ext cx="59454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rkin-IP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feld 45"/>
            <p:cNvSpPr txBox="1"/>
            <p:nvPr/>
          </p:nvSpPr>
          <p:spPr>
            <a:xfrm>
              <a:off x="2287249" y="3408924"/>
              <a:ext cx="59454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47" name="Textfeld 46"/>
            <p:cNvSpPr txBox="1"/>
            <p:nvPr/>
          </p:nvSpPr>
          <p:spPr>
            <a:xfrm>
              <a:off x="2717938" y="4120692"/>
              <a:ext cx="33991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-75</a:t>
              </a:r>
            </a:p>
          </p:txBody>
        </p:sp>
        <p:sp>
          <p:nvSpPr>
            <p:cNvPr id="48" name="Textfeld 47"/>
            <p:cNvSpPr txBox="1"/>
            <p:nvPr/>
          </p:nvSpPr>
          <p:spPr>
            <a:xfrm>
              <a:off x="1552641" y="3564976"/>
              <a:ext cx="3189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9" name="Grafik 48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10" t="25337" r="9852" b="57572"/>
            <a:stretch/>
          </p:blipFill>
          <p:spPr>
            <a:xfrm>
              <a:off x="1431834" y="3731419"/>
              <a:ext cx="1316250" cy="33127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0" name="Textfeld 49"/>
            <p:cNvSpPr txBox="1"/>
            <p:nvPr/>
          </p:nvSpPr>
          <p:spPr>
            <a:xfrm>
              <a:off x="2717938" y="3693065"/>
              <a:ext cx="45538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</a:p>
          </p:txBody>
        </p:sp>
        <p:sp>
          <p:nvSpPr>
            <p:cNvPr id="51" name="Textfeld 50"/>
            <p:cNvSpPr txBox="1"/>
            <p:nvPr/>
          </p:nvSpPr>
          <p:spPr>
            <a:xfrm>
              <a:off x="2717938" y="3921398"/>
              <a:ext cx="33991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</a:p>
          </p:txBody>
        </p:sp>
        <p:pic>
          <p:nvPicPr>
            <p:cNvPr id="52" name="Grafik 51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357" r="9499" b="81626"/>
            <a:stretch/>
          </p:blipFill>
          <p:spPr>
            <a:xfrm>
              <a:off x="1431834" y="4071040"/>
              <a:ext cx="1316250" cy="17695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3" name="Textfeld 52"/>
            <p:cNvSpPr txBox="1"/>
            <p:nvPr/>
          </p:nvSpPr>
          <p:spPr>
            <a:xfrm>
              <a:off x="758517" y="3812459"/>
              <a:ext cx="71620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WD45</a:t>
              </a:r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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feld 53"/>
            <p:cNvSpPr txBox="1"/>
            <p:nvPr/>
          </p:nvSpPr>
          <p:spPr>
            <a:xfrm>
              <a:off x="758517" y="4066146"/>
              <a:ext cx="71620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RIOK1</a:t>
              </a:r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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5" name="Grafik 54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59" t="19746" r="12674" b="8871"/>
            <a:stretch/>
          </p:blipFill>
          <p:spPr>
            <a:xfrm>
              <a:off x="1431834" y="4256346"/>
              <a:ext cx="1316250" cy="136418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6" name="Textfeld 55"/>
            <p:cNvSpPr txBox="1"/>
            <p:nvPr/>
          </p:nvSpPr>
          <p:spPr>
            <a:xfrm>
              <a:off x="2717938" y="4324463"/>
              <a:ext cx="33991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</a:p>
          </p:txBody>
        </p:sp>
        <p:sp>
          <p:nvSpPr>
            <p:cNvPr id="57" name="Textfeld 56"/>
            <p:cNvSpPr txBox="1"/>
            <p:nvPr/>
          </p:nvSpPr>
          <p:spPr>
            <a:xfrm>
              <a:off x="2717938" y="4560538"/>
              <a:ext cx="33991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</a:p>
          </p:txBody>
        </p:sp>
        <p:sp>
          <p:nvSpPr>
            <p:cNvPr id="58" name="Textfeld 57"/>
            <p:cNvSpPr txBox="1"/>
            <p:nvPr/>
          </p:nvSpPr>
          <p:spPr>
            <a:xfrm>
              <a:off x="335519" y="4509012"/>
              <a:ext cx="113920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caspase-8 (p43/ p41)</a:t>
              </a:r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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feld 58"/>
            <p:cNvSpPr txBox="1"/>
            <p:nvPr/>
          </p:nvSpPr>
          <p:spPr>
            <a:xfrm>
              <a:off x="454901" y="5430723"/>
              <a:ext cx="101982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caspase-8 (p18)</a:t>
              </a:r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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feld 59"/>
            <p:cNvSpPr txBox="1"/>
            <p:nvPr/>
          </p:nvSpPr>
          <p:spPr>
            <a:xfrm>
              <a:off x="2717938" y="4944792"/>
              <a:ext cx="33991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-25</a:t>
              </a:r>
            </a:p>
          </p:txBody>
        </p:sp>
        <p:pic>
          <p:nvPicPr>
            <p:cNvPr id="61" name="Grafik 60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93" t="46661" r="10387" b="40195"/>
            <a:stretch/>
          </p:blipFill>
          <p:spPr>
            <a:xfrm>
              <a:off x="1431834" y="5615264"/>
              <a:ext cx="1316250" cy="27427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2" name="Textfeld 61"/>
            <p:cNvSpPr txBox="1"/>
            <p:nvPr/>
          </p:nvSpPr>
          <p:spPr>
            <a:xfrm>
              <a:off x="454901" y="5620528"/>
              <a:ext cx="101982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FADD</a:t>
              </a:r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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feld 62"/>
            <p:cNvSpPr txBox="1"/>
            <p:nvPr/>
          </p:nvSpPr>
          <p:spPr>
            <a:xfrm>
              <a:off x="2717938" y="5722854"/>
              <a:ext cx="33991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-25</a:t>
              </a:r>
            </a:p>
          </p:txBody>
        </p:sp>
        <p:sp>
          <p:nvSpPr>
            <p:cNvPr id="64" name="Textfeld 63"/>
            <p:cNvSpPr txBox="1"/>
            <p:nvPr/>
          </p:nvSpPr>
          <p:spPr>
            <a:xfrm>
              <a:off x="459509" y="4274390"/>
              <a:ext cx="101521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procaspase-8 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5" name="Gerade Verbindung 14"/>
            <p:cNvCxnSpPr/>
            <p:nvPr/>
          </p:nvCxnSpPr>
          <p:spPr>
            <a:xfrm flipH="1">
              <a:off x="1431834" y="3564347"/>
              <a:ext cx="512297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6" name="Gerade Verbindung 14"/>
            <p:cNvCxnSpPr/>
            <p:nvPr/>
          </p:nvCxnSpPr>
          <p:spPr>
            <a:xfrm flipH="1">
              <a:off x="1996118" y="3564347"/>
              <a:ext cx="3510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7" name="Gerade Verbindung 14"/>
            <p:cNvCxnSpPr/>
            <p:nvPr/>
          </p:nvCxnSpPr>
          <p:spPr>
            <a:xfrm flipH="1">
              <a:off x="2400724" y="3564347"/>
              <a:ext cx="3510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68" name="Textfeld 67"/>
            <p:cNvSpPr txBox="1"/>
            <p:nvPr/>
          </p:nvSpPr>
          <p:spPr>
            <a:xfrm>
              <a:off x="746345" y="3564976"/>
              <a:ext cx="70711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[h]</a:t>
              </a:r>
            </a:p>
          </p:txBody>
        </p:sp>
      </p:grpSp>
      <p:pic>
        <p:nvPicPr>
          <p:cNvPr id="71" name="Grafik 70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67" t="25045" r="46438" b="64040"/>
          <a:stretch/>
        </p:blipFill>
        <p:spPr>
          <a:xfrm>
            <a:off x="4151083" y="3073679"/>
            <a:ext cx="731250" cy="40049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2" name="Grafik 71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61" t="9332" r="35889" b="81890"/>
          <a:stretch/>
        </p:blipFill>
        <p:spPr>
          <a:xfrm>
            <a:off x="4151083" y="3471367"/>
            <a:ext cx="731250" cy="22776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3" name="Grafik 72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98" t="22562" r="35769" b="66416"/>
          <a:stretch/>
        </p:blipFill>
        <p:spPr>
          <a:xfrm>
            <a:off x="4151083" y="5455518"/>
            <a:ext cx="731250" cy="30881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4" name="Grafik 73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44" t="22190" r="33305" b="16474"/>
          <a:stretch/>
        </p:blipFill>
        <p:spPr>
          <a:xfrm>
            <a:off x="4151083" y="3695545"/>
            <a:ext cx="731250" cy="15076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5" name="Grafik 74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28" t="53240" r="35798" b="36804"/>
          <a:stretch/>
        </p:blipFill>
        <p:spPr>
          <a:xfrm>
            <a:off x="4151083" y="5203223"/>
            <a:ext cx="731250" cy="26769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6" name="Textfeld 75"/>
          <p:cNvSpPr txBox="1"/>
          <p:nvPr/>
        </p:nvSpPr>
        <p:spPr>
          <a:xfrm>
            <a:off x="4096803" y="2553961"/>
            <a:ext cx="93992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250 ng/mL CD95L </a:t>
            </a:r>
          </a:p>
        </p:txBody>
      </p:sp>
      <p:sp>
        <p:nvSpPr>
          <p:cNvPr id="77" name="Textfeld 76"/>
          <p:cNvSpPr txBox="1"/>
          <p:nvPr/>
        </p:nvSpPr>
        <p:spPr>
          <a:xfrm>
            <a:off x="4160646" y="2895415"/>
            <a:ext cx="20435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8" name="Textfeld 77"/>
          <p:cNvSpPr txBox="1"/>
          <p:nvPr/>
        </p:nvSpPr>
        <p:spPr>
          <a:xfrm>
            <a:off x="4677069" y="2895415"/>
            <a:ext cx="21106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79" name="Textfeld 78"/>
          <p:cNvSpPr txBox="1"/>
          <p:nvPr/>
        </p:nvSpPr>
        <p:spPr>
          <a:xfrm>
            <a:off x="4378453" y="2895415"/>
            <a:ext cx="3189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feld 79"/>
          <p:cNvSpPr txBox="1"/>
          <p:nvPr/>
        </p:nvSpPr>
        <p:spPr>
          <a:xfrm>
            <a:off x="3501561" y="2895415"/>
            <a:ext cx="7071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[h]</a:t>
            </a:r>
          </a:p>
        </p:txBody>
      </p:sp>
      <p:sp>
        <p:nvSpPr>
          <p:cNvPr id="81" name="Textfeld 80"/>
          <p:cNvSpPr txBox="1"/>
          <p:nvPr/>
        </p:nvSpPr>
        <p:spPr>
          <a:xfrm>
            <a:off x="3492469" y="3202068"/>
            <a:ext cx="71620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WD45</a:t>
            </a:r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feld 81"/>
          <p:cNvSpPr txBox="1"/>
          <p:nvPr/>
        </p:nvSpPr>
        <p:spPr>
          <a:xfrm>
            <a:off x="4840192" y="3103974"/>
            <a:ext cx="3399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83" name="Textfeld 82"/>
          <p:cNvSpPr txBox="1"/>
          <p:nvPr/>
        </p:nvSpPr>
        <p:spPr>
          <a:xfrm>
            <a:off x="4840192" y="3332306"/>
            <a:ext cx="3399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-37</a:t>
            </a:r>
          </a:p>
        </p:txBody>
      </p:sp>
      <p:sp>
        <p:nvSpPr>
          <p:cNvPr id="84" name="Textfeld 83"/>
          <p:cNvSpPr txBox="1"/>
          <p:nvPr/>
        </p:nvSpPr>
        <p:spPr>
          <a:xfrm>
            <a:off x="4840192" y="2944101"/>
            <a:ext cx="39430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feld 84"/>
          <p:cNvSpPr txBox="1"/>
          <p:nvPr/>
        </p:nvSpPr>
        <p:spPr>
          <a:xfrm>
            <a:off x="4136237" y="2706561"/>
            <a:ext cx="7020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cxnSp>
        <p:nvCxnSpPr>
          <p:cNvPr id="86" name="Gerade Verbindung 14"/>
          <p:cNvCxnSpPr/>
          <p:nvPr/>
        </p:nvCxnSpPr>
        <p:spPr>
          <a:xfrm flipH="1">
            <a:off x="4159011" y="2861984"/>
            <a:ext cx="7020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7" name="Textfeld 86"/>
          <p:cNvSpPr txBox="1"/>
          <p:nvPr/>
        </p:nvSpPr>
        <p:spPr>
          <a:xfrm>
            <a:off x="3492469" y="3487142"/>
            <a:ext cx="71620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RIOK1</a:t>
            </a:r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feld 87"/>
          <p:cNvSpPr txBox="1"/>
          <p:nvPr/>
        </p:nvSpPr>
        <p:spPr>
          <a:xfrm>
            <a:off x="4840192" y="3528413"/>
            <a:ext cx="3399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-75</a:t>
            </a:r>
          </a:p>
        </p:txBody>
      </p:sp>
      <p:sp>
        <p:nvSpPr>
          <p:cNvPr id="89" name="Textfeld 88"/>
          <p:cNvSpPr txBox="1"/>
          <p:nvPr/>
        </p:nvSpPr>
        <p:spPr>
          <a:xfrm>
            <a:off x="3059233" y="4059385"/>
            <a:ext cx="114944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caspase-8 (p43/ p41)</a:t>
            </a:r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feld 89"/>
          <p:cNvSpPr txBox="1"/>
          <p:nvPr/>
        </p:nvSpPr>
        <p:spPr>
          <a:xfrm>
            <a:off x="3188853" y="5050514"/>
            <a:ext cx="101982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caspase-8 (p18)</a:t>
            </a:r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feld 90"/>
          <p:cNvSpPr txBox="1"/>
          <p:nvPr/>
        </p:nvSpPr>
        <p:spPr>
          <a:xfrm>
            <a:off x="3193461" y="3675274"/>
            <a:ext cx="10152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procaspase-8 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feld 91"/>
          <p:cNvSpPr txBox="1"/>
          <p:nvPr/>
        </p:nvSpPr>
        <p:spPr>
          <a:xfrm>
            <a:off x="4840192" y="3797507"/>
            <a:ext cx="3399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93" name="Textfeld 92"/>
          <p:cNvSpPr txBox="1"/>
          <p:nvPr/>
        </p:nvSpPr>
        <p:spPr>
          <a:xfrm>
            <a:off x="4840192" y="4130485"/>
            <a:ext cx="3399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-37</a:t>
            </a:r>
          </a:p>
        </p:txBody>
      </p:sp>
      <p:sp>
        <p:nvSpPr>
          <p:cNvPr id="94" name="Textfeld 93"/>
          <p:cNvSpPr txBox="1"/>
          <p:nvPr/>
        </p:nvSpPr>
        <p:spPr>
          <a:xfrm>
            <a:off x="4840192" y="4514740"/>
            <a:ext cx="3399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-25</a:t>
            </a:r>
          </a:p>
        </p:txBody>
      </p:sp>
      <p:sp>
        <p:nvSpPr>
          <p:cNvPr id="95" name="Textfeld 94"/>
          <p:cNvSpPr txBox="1"/>
          <p:nvPr/>
        </p:nvSpPr>
        <p:spPr>
          <a:xfrm>
            <a:off x="4840192" y="5308367"/>
            <a:ext cx="3399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-25</a:t>
            </a:r>
          </a:p>
        </p:txBody>
      </p:sp>
      <p:sp>
        <p:nvSpPr>
          <p:cNvPr id="96" name="Textfeld 95"/>
          <p:cNvSpPr txBox="1"/>
          <p:nvPr/>
        </p:nvSpPr>
        <p:spPr>
          <a:xfrm>
            <a:off x="3188853" y="5227095"/>
            <a:ext cx="101982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FADD</a:t>
            </a:r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feld 96"/>
          <p:cNvSpPr txBox="1"/>
          <p:nvPr/>
        </p:nvSpPr>
        <p:spPr>
          <a:xfrm>
            <a:off x="3188853" y="5465354"/>
            <a:ext cx="101982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feld 97"/>
          <p:cNvSpPr txBox="1"/>
          <p:nvPr/>
        </p:nvSpPr>
        <p:spPr>
          <a:xfrm>
            <a:off x="4840192" y="5601144"/>
            <a:ext cx="3399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-37</a:t>
            </a:r>
          </a:p>
        </p:txBody>
      </p:sp>
      <p:sp>
        <p:nvSpPr>
          <p:cNvPr id="157" name="Textfeld 156"/>
          <p:cNvSpPr txBox="1"/>
          <p:nvPr/>
        </p:nvSpPr>
        <p:spPr>
          <a:xfrm>
            <a:off x="535385" y="641242"/>
            <a:ext cx="1415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8" name="Textfeld 157"/>
          <p:cNvSpPr txBox="1"/>
          <p:nvPr/>
        </p:nvSpPr>
        <p:spPr>
          <a:xfrm>
            <a:off x="535385" y="2151608"/>
            <a:ext cx="1415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0" name="Textfeld 159"/>
          <p:cNvSpPr txBox="1"/>
          <p:nvPr/>
        </p:nvSpPr>
        <p:spPr>
          <a:xfrm>
            <a:off x="828675" y="238896"/>
            <a:ext cx="1387569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63" dirty="0" smtClean="0">
                <a:latin typeface="Arial" panose="020B0604020202020204" pitchFamily="34" charset="0"/>
                <a:cs typeface="Arial" panose="020B0604020202020204" pitchFamily="34" charset="0"/>
              </a:rPr>
              <a:t>Fig.2 </a:t>
            </a:r>
            <a:endParaRPr lang="en-GB" sz="146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feld 133"/>
          <p:cNvSpPr txBox="1"/>
          <p:nvPr/>
        </p:nvSpPr>
        <p:spPr>
          <a:xfrm>
            <a:off x="1428757" y="5753178"/>
            <a:ext cx="643500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Input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feld 134"/>
          <p:cNvSpPr txBox="1"/>
          <p:nvPr/>
        </p:nvSpPr>
        <p:spPr>
          <a:xfrm>
            <a:off x="2119191" y="5758612"/>
            <a:ext cx="789844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PRMT5-co-IP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7" name="Gerade Verbindung 14"/>
          <p:cNvCxnSpPr/>
          <p:nvPr/>
        </p:nvCxnSpPr>
        <p:spPr>
          <a:xfrm flipH="1" flipV="1">
            <a:off x="1428757" y="5938470"/>
            <a:ext cx="643500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8" name="Textfeld 137"/>
          <p:cNvSpPr txBox="1"/>
          <p:nvPr/>
        </p:nvSpPr>
        <p:spPr>
          <a:xfrm>
            <a:off x="404749" y="6161633"/>
            <a:ext cx="109418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procaspase-8 (</a:t>
            </a:r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s.e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.)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feld 138"/>
          <p:cNvSpPr txBox="1"/>
          <p:nvPr/>
        </p:nvSpPr>
        <p:spPr>
          <a:xfrm>
            <a:off x="2850892" y="6217553"/>
            <a:ext cx="3404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</a:p>
        </p:txBody>
      </p:sp>
      <p:pic>
        <p:nvPicPr>
          <p:cNvPr id="140" name="Picture 2" descr="G:\AG_Lavrik\Fabian\Experimente\V20190820 PRMT5-Co-IP with skw cells and CD95 treatment\1.casp.8\s.e..tif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5" t="15013" r="10826" b="72823"/>
          <a:stretch/>
        </p:blipFill>
        <p:spPr bwMode="auto">
          <a:xfrm>
            <a:off x="1445133" y="6171609"/>
            <a:ext cx="1462500" cy="18775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1" name="Picture 2" descr="G:\AG_Lavrik\Fabian\Experimente\V20190820 PRMT5-Co-IP with skw cells and CD95 treatment\5.prmt5\marker+Wohlfromm, Fabian 2019-09-03 10hr 28min_Exposure_120.0sec.tif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0" t="11612" r="8792" b="70449"/>
          <a:stretch/>
        </p:blipFill>
        <p:spPr bwMode="auto">
          <a:xfrm>
            <a:off x="1445133" y="6944942"/>
            <a:ext cx="1462500" cy="29033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2" name="Picture 3" descr="G:\AG_Lavrik\Fabian\Experimente\V20190820 PRMT5-Co-IP with skw cells and CD95 treatment\6.actin\marker+Wohlfromm, Fabian 2019-09-04 09hr 50min_Exposure_3.0sec.tif"/>
          <p:cNvPicPr>
            <a:picLocks noChangeAspect="1" noChangeArrowheads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0" t="24952" r="57493" b="60519"/>
          <a:stretch/>
        </p:blipFill>
        <p:spPr bwMode="auto">
          <a:xfrm>
            <a:off x="1445133" y="7235144"/>
            <a:ext cx="662218" cy="24003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3" name="Picture 2" descr="G:\AG_Lavrik\Fabian\Experimente\V20190820 PRMT5-Co-IP with skw cells and CD95 treatment\1.casp.8\marker+Wohlfromm, Fabian 2019-08-27 10hr 19min_Exposure_13.5sec.tif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9" t="12778" r="10125" b="65089"/>
          <a:stretch/>
        </p:blipFill>
        <p:spPr bwMode="auto">
          <a:xfrm>
            <a:off x="1445133" y="6365688"/>
            <a:ext cx="1462500" cy="32071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4" name="Textfeld 143"/>
          <p:cNvSpPr txBox="1"/>
          <p:nvPr/>
        </p:nvSpPr>
        <p:spPr>
          <a:xfrm>
            <a:off x="2850892" y="6058374"/>
            <a:ext cx="34040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feld 144"/>
          <p:cNvSpPr txBox="1"/>
          <p:nvPr/>
        </p:nvSpPr>
        <p:spPr>
          <a:xfrm>
            <a:off x="483712" y="6351384"/>
            <a:ext cx="10152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procaspase-8 (</a:t>
            </a:r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l.e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.)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feld 145"/>
          <p:cNvSpPr txBox="1"/>
          <p:nvPr/>
        </p:nvSpPr>
        <p:spPr>
          <a:xfrm>
            <a:off x="1451566" y="5993772"/>
            <a:ext cx="13319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47" name="Textfeld 146"/>
          <p:cNvSpPr txBox="1"/>
          <p:nvPr/>
        </p:nvSpPr>
        <p:spPr>
          <a:xfrm>
            <a:off x="1538513" y="5993772"/>
            <a:ext cx="30150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48" name="Textfeld 147"/>
          <p:cNvSpPr txBox="1"/>
          <p:nvPr/>
        </p:nvSpPr>
        <p:spPr>
          <a:xfrm>
            <a:off x="1700840" y="5993772"/>
            <a:ext cx="29610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149" name="Textfeld 148"/>
          <p:cNvSpPr txBox="1"/>
          <p:nvPr/>
        </p:nvSpPr>
        <p:spPr>
          <a:xfrm>
            <a:off x="2122221" y="5993772"/>
            <a:ext cx="13319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50" name="Textfeld 149"/>
          <p:cNvSpPr txBox="1"/>
          <p:nvPr/>
        </p:nvSpPr>
        <p:spPr>
          <a:xfrm>
            <a:off x="2180419" y="5993772"/>
            <a:ext cx="29518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51" name="Textfeld 150"/>
          <p:cNvSpPr txBox="1"/>
          <p:nvPr/>
        </p:nvSpPr>
        <p:spPr>
          <a:xfrm>
            <a:off x="2388221" y="5993772"/>
            <a:ext cx="28393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152" name="Textfeld 151"/>
          <p:cNvSpPr txBox="1"/>
          <p:nvPr/>
        </p:nvSpPr>
        <p:spPr>
          <a:xfrm>
            <a:off x="2546997" y="5993772"/>
            <a:ext cx="29023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53" name="Textfeld 152"/>
          <p:cNvSpPr txBox="1"/>
          <p:nvPr/>
        </p:nvSpPr>
        <p:spPr>
          <a:xfrm>
            <a:off x="2795880" y="5993772"/>
            <a:ext cx="1000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4" name="Textfeld 153"/>
          <p:cNvSpPr txBox="1"/>
          <p:nvPr/>
        </p:nvSpPr>
        <p:spPr>
          <a:xfrm>
            <a:off x="2850892" y="6419443"/>
            <a:ext cx="3404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55" name="Textfeld 154"/>
          <p:cNvSpPr txBox="1"/>
          <p:nvPr/>
        </p:nvSpPr>
        <p:spPr>
          <a:xfrm>
            <a:off x="828187" y="5988963"/>
            <a:ext cx="670742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[min]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6" name="Gerade Verbindung 14"/>
          <p:cNvCxnSpPr/>
          <p:nvPr/>
        </p:nvCxnSpPr>
        <p:spPr>
          <a:xfrm flipH="1">
            <a:off x="2119192" y="5938470"/>
            <a:ext cx="789843" cy="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61" name="Textfeld 160"/>
          <p:cNvSpPr txBox="1"/>
          <p:nvPr/>
        </p:nvSpPr>
        <p:spPr>
          <a:xfrm>
            <a:off x="1910610" y="5993772"/>
            <a:ext cx="29272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62" name="Textfeld 161"/>
          <p:cNvSpPr txBox="1"/>
          <p:nvPr/>
        </p:nvSpPr>
        <p:spPr>
          <a:xfrm>
            <a:off x="2850892" y="6913060"/>
            <a:ext cx="3404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75</a:t>
            </a:r>
          </a:p>
        </p:txBody>
      </p:sp>
      <p:sp>
        <p:nvSpPr>
          <p:cNvPr id="163" name="Textfeld 162"/>
          <p:cNvSpPr txBox="1"/>
          <p:nvPr/>
        </p:nvSpPr>
        <p:spPr>
          <a:xfrm>
            <a:off x="875153" y="6940293"/>
            <a:ext cx="6237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PRMT5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4" name="Picture 2" descr="G:\AG_Lavrik\Fabian\Experimente\V20190820 PRMT5-Co-IP with skw cells and CD95 treatment\4.wd45\s.e..tif"/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631" r="11442" b="64324"/>
          <a:stretch/>
        </p:blipFill>
        <p:spPr bwMode="auto">
          <a:xfrm>
            <a:off x="1445133" y="6692209"/>
            <a:ext cx="1462500" cy="250496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5" name="Textfeld 164"/>
          <p:cNvSpPr txBox="1"/>
          <p:nvPr/>
        </p:nvSpPr>
        <p:spPr>
          <a:xfrm>
            <a:off x="2850892" y="6636686"/>
            <a:ext cx="3404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66" name="Textfeld 165"/>
          <p:cNvSpPr txBox="1"/>
          <p:nvPr/>
        </p:nvSpPr>
        <p:spPr>
          <a:xfrm>
            <a:off x="498304" y="6721441"/>
            <a:ext cx="100062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WD45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Textfeld 166"/>
          <p:cNvSpPr txBox="1"/>
          <p:nvPr/>
        </p:nvSpPr>
        <p:spPr>
          <a:xfrm>
            <a:off x="2850892" y="6795036"/>
            <a:ext cx="3404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37</a:t>
            </a:r>
          </a:p>
        </p:txBody>
      </p:sp>
      <p:sp>
        <p:nvSpPr>
          <p:cNvPr id="168" name="Textfeld 167"/>
          <p:cNvSpPr txBox="1"/>
          <p:nvPr/>
        </p:nvSpPr>
        <p:spPr>
          <a:xfrm>
            <a:off x="2850892" y="7106417"/>
            <a:ext cx="39735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69" name="Textfeld 168"/>
          <p:cNvSpPr txBox="1"/>
          <p:nvPr/>
        </p:nvSpPr>
        <p:spPr>
          <a:xfrm>
            <a:off x="875153" y="7262966"/>
            <a:ext cx="6237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actin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feld 132"/>
          <p:cNvSpPr txBox="1"/>
          <p:nvPr/>
        </p:nvSpPr>
        <p:spPr>
          <a:xfrm>
            <a:off x="1443086" y="5580735"/>
            <a:ext cx="1462500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200 </a:t>
            </a:r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ng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/ml CD95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0" name="Gruppieren 169"/>
          <p:cNvGrpSpPr/>
          <p:nvPr/>
        </p:nvGrpSpPr>
        <p:grpSpPr>
          <a:xfrm>
            <a:off x="478517" y="7978366"/>
            <a:ext cx="2135807" cy="1613191"/>
            <a:chOff x="-53739" y="3113267"/>
            <a:chExt cx="2628683" cy="1985466"/>
          </a:xfrm>
        </p:grpSpPr>
        <p:grpSp>
          <p:nvGrpSpPr>
            <p:cNvPr id="171" name="Gruppieren 170"/>
            <p:cNvGrpSpPr/>
            <p:nvPr/>
          </p:nvGrpSpPr>
          <p:grpSpPr>
            <a:xfrm>
              <a:off x="-53739" y="3307018"/>
              <a:ext cx="2628683" cy="1791715"/>
              <a:chOff x="-25563" y="3633261"/>
              <a:chExt cx="2628683" cy="1791715"/>
            </a:xfrm>
          </p:grpSpPr>
          <p:pic>
            <p:nvPicPr>
              <p:cNvPr id="173" name="Grafik 172"/>
              <p:cNvPicPr>
                <a:picLocks noChangeAspect="1"/>
              </p:cNvPicPr>
              <p:nvPr/>
            </p:nvPicPr>
            <p:blipFill rotWithShape="1"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60" b="73527"/>
              <a:stretch/>
            </p:blipFill>
            <p:spPr>
              <a:xfrm>
                <a:off x="1143851" y="4358416"/>
                <a:ext cx="1080000" cy="31601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74" name="Textfeld 173"/>
              <p:cNvSpPr txBox="1"/>
              <p:nvPr/>
            </p:nvSpPr>
            <p:spPr>
              <a:xfrm>
                <a:off x="-25563" y="4427077"/>
                <a:ext cx="1249496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procaspase-8 (</a:t>
                </a:r>
                <a:r>
                  <a:rPr lang="de-DE" sz="6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l.e</a:t>
                </a:r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.)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5" name="Textfeld 174"/>
              <p:cNvSpPr txBox="1"/>
              <p:nvPr/>
            </p:nvSpPr>
            <p:spPr>
              <a:xfrm>
                <a:off x="2147346" y="4539683"/>
                <a:ext cx="418361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50</a:t>
                </a:r>
              </a:p>
            </p:txBody>
          </p:sp>
          <p:sp>
            <p:nvSpPr>
              <p:cNvPr id="176" name="Textfeld 175"/>
              <p:cNvSpPr txBox="1"/>
              <p:nvPr/>
            </p:nvSpPr>
            <p:spPr>
              <a:xfrm>
                <a:off x="398403" y="3886898"/>
                <a:ext cx="825528" cy="227281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[min]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77" name="Gerade Verbindung 14"/>
              <p:cNvCxnSpPr/>
              <p:nvPr/>
            </p:nvCxnSpPr>
            <p:spPr>
              <a:xfrm flipH="1">
                <a:off x="1131101" y="3851936"/>
                <a:ext cx="108000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78" name="Textfeld 177"/>
              <p:cNvSpPr txBox="1"/>
              <p:nvPr/>
            </p:nvSpPr>
            <p:spPr>
              <a:xfrm>
                <a:off x="1159547" y="3884247"/>
                <a:ext cx="163927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79" name="Textfeld 178"/>
              <p:cNvSpPr txBox="1"/>
              <p:nvPr/>
            </p:nvSpPr>
            <p:spPr>
              <a:xfrm>
                <a:off x="1243581" y="3884247"/>
                <a:ext cx="339908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180" name="Textfeld 179"/>
              <p:cNvSpPr txBox="1"/>
              <p:nvPr/>
            </p:nvSpPr>
            <p:spPr>
              <a:xfrm>
                <a:off x="1434765" y="3884247"/>
                <a:ext cx="337431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181" name="Textfeld 180"/>
              <p:cNvSpPr txBox="1"/>
              <p:nvPr/>
            </p:nvSpPr>
            <p:spPr>
              <a:xfrm>
                <a:off x="1613340" y="3884247"/>
                <a:ext cx="337920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182" name="Textfeld 181"/>
              <p:cNvSpPr txBox="1"/>
              <p:nvPr/>
            </p:nvSpPr>
            <p:spPr>
              <a:xfrm>
                <a:off x="1909735" y="3884247"/>
                <a:ext cx="123158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183" name="Textfeld 182"/>
              <p:cNvSpPr txBox="1"/>
              <p:nvPr/>
            </p:nvSpPr>
            <p:spPr>
              <a:xfrm>
                <a:off x="1947890" y="3884247"/>
                <a:ext cx="368042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BC</a:t>
                </a:r>
              </a:p>
            </p:txBody>
          </p:sp>
          <p:sp>
            <p:nvSpPr>
              <p:cNvPr id="184" name="Textfeld 183"/>
              <p:cNvSpPr txBox="1"/>
              <p:nvPr/>
            </p:nvSpPr>
            <p:spPr>
              <a:xfrm>
                <a:off x="1124909" y="3633261"/>
                <a:ext cx="1086192" cy="227281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WD45-IP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5" name="Textfeld 184"/>
              <p:cNvSpPr txBox="1"/>
              <p:nvPr/>
            </p:nvSpPr>
            <p:spPr>
              <a:xfrm>
                <a:off x="2147346" y="3964936"/>
                <a:ext cx="418361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6" name="Textfeld 185"/>
              <p:cNvSpPr txBox="1"/>
              <p:nvPr/>
            </p:nvSpPr>
            <p:spPr>
              <a:xfrm>
                <a:off x="-25563" y="4139413"/>
                <a:ext cx="1249496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procaspase-8 (</a:t>
                </a:r>
                <a:r>
                  <a:rPr lang="de-DE" sz="6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s.e</a:t>
                </a:r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.)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87" name="Grafik 186"/>
              <p:cNvPicPr>
                <a:picLocks noChangeAspect="1"/>
              </p:cNvPicPr>
              <p:nvPr/>
            </p:nvPicPr>
            <p:blipFill rotWithShape="1"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99" t="24106" b="58962"/>
              <a:stretch/>
            </p:blipFill>
            <p:spPr>
              <a:xfrm>
                <a:off x="1143851" y="4098021"/>
                <a:ext cx="1080000" cy="25612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88" name="Textfeld 187"/>
              <p:cNvSpPr txBox="1"/>
              <p:nvPr/>
            </p:nvSpPr>
            <p:spPr>
              <a:xfrm>
                <a:off x="2147345" y="4203613"/>
                <a:ext cx="455775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50</a:t>
                </a:r>
              </a:p>
            </p:txBody>
          </p:sp>
          <p:pic>
            <p:nvPicPr>
              <p:cNvPr id="189" name="Grafik 188"/>
              <p:cNvPicPr>
                <a:picLocks noChangeAspect="1"/>
              </p:cNvPicPr>
              <p:nvPr/>
            </p:nvPicPr>
            <p:blipFill rotWithShape="1"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758" t="32562" b="57408"/>
              <a:stretch/>
            </p:blipFill>
            <p:spPr>
              <a:xfrm>
                <a:off x="1143851" y="4685170"/>
                <a:ext cx="1080000" cy="20500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90" name="Textfeld 189"/>
              <p:cNvSpPr txBox="1"/>
              <p:nvPr/>
            </p:nvSpPr>
            <p:spPr>
              <a:xfrm>
                <a:off x="2147346" y="4647842"/>
                <a:ext cx="418361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75</a:t>
                </a:r>
              </a:p>
            </p:txBody>
          </p:sp>
          <p:sp>
            <p:nvSpPr>
              <p:cNvPr id="191" name="Textfeld 190"/>
              <p:cNvSpPr txBox="1"/>
              <p:nvPr/>
            </p:nvSpPr>
            <p:spPr>
              <a:xfrm>
                <a:off x="-25563" y="4690929"/>
                <a:ext cx="1249496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PRMT5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92" name="Grafik 191"/>
              <p:cNvPicPr>
                <a:picLocks noChangeAspect="1"/>
              </p:cNvPicPr>
              <p:nvPr/>
            </p:nvPicPr>
            <p:blipFill rotWithShape="1">
              <a:blip r:embed="rId2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128" t="45826" r="6279" b="43745"/>
              <a:stretch/>
            </p:blipFill>
            <p:spPr>
              <a:xfrm>
                <a:off x="1143851" y="4889012"/>
                <a:ext cx="1080000" cy="21586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93" name="Textfeld 192"/>
              <p:cNvSpPr txBox="1"/>
              <p:nvPr/>
            </p:nvSpPr>
            <p:spPr>
              <a:xfrm>
                <a:off x="2153808" y="4953576"/>
                <a:ext cx="411898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37</a:t>
                </a:r>
              </a:p>
            </p:txBody>
          </p:sp>
          <p:sp>
            <p:nvSpPr>
              <p:cNvPr id="194" name="Textfeld 193"/>
              <p:cNvSpPr txBox="1"/>
              <p:nvPr/>
            </p:nvSpPr>
            <p:spPr>
              <a:xfrm>
                <a:off x="-25563" y="4902593"/>
                <a:ext cx="1249496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WD45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95" name="Grafik 194"/>
              <p:cNvPicPr>
                <a:picLocks noChangeAspect="1"/>
              </p:cNvPicPr>
              <p:nvPr/>
            </p:nvPicPr>
            <p:blipFill rotWithShape="1">
              <a:blip r:embed="rId2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854" t="19724" b="68968"/>
              <a:stretch/>
            </p:blipFill>
            <p:spPr>
              <a:xfrm>
                <a:off x="1143851" y="5104799"/>
                <a:ext cx="1080000" cy="24047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96" name="Textfeld 195"/>
              <p:cNvSpPr txBox="1"/>
              <p:nvPr/>
            </p:nvSpPr>
            <p:spPr>
              <a:xfrm>
                <a:off x="2147345" y="5197695"/>
                <a:ext cx="418359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75</a:t>
                </a:r>
              </a:p>
            </p:txBody>
          </p:sp>
          <p:sp>
            <p:nvSpPr>
              <p:cNvPr id="197" name="Textfeld 196"/>
              <p:cNvSpPr txBox="1"/>
              <p:nvPr/>
            </p:nvSpPr>
            <p:spPr>
              <a:xfrm>
                <a:off x="-25563" y="5129339"/>
                <a:ext cx="1249496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RIOK1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72" name="Textfeld 171"/>
            <p:cNvSpPr txBox="1"/>
            <p:nvPr/>
          </p:nvSpPr>
          <p:spPr>
            <a:xfrm>
              <a:off x="1098934" y="3113267"/>
              <a:ext cx="1083993" cy="22728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200 </a:t>
              </a:r>
              <a:r>
                <a:rPr lang="de-DE" sz="6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ng</a:t>
              </a:r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/ml CD95L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8" name="Gruppieren 197"/>
          <p:cNvGrpSpPr/>
          <p:nvPr/>
        </p:nvGrpSpPr>
        <p:grpSpPr>
          <a:xfrm>
            <a:off x="3477507" y="7969181"/>
            <a:ext cx="1654771" cy="1711748"/>
            <a:chOff x="293811" y="5375377"/>
            <a:chExt cx="2036639" cy="2106767"/>
          </a:xfrm>
        </p:grpSpPr>
        <p:grpSp>
          <p:nvGrpSpPr>
            <p:cNvPr id="199" name="Gruppieren 198"/>
            <p:cNvGrpSpPr/>
            <p:nvPr/>
          </p:nvGrpSpPr>
          <p:grpSpPr>
            <a:xfrm>
              <a:off x="293811" y="5569737"/>
              <a:ext cx="2036639" cy="1912407"/>
              <a:chOff x="3501466" y="3632976"/>
              <a:chExt cx="2036639" cy="1912407"/>
            </a:xfrm>
          </p:grpSpPr>
          <p:sp>
            <p:nvSpPr>
              <p:cNvPr id="201" name="Textfeld 200"/>
              <p:cNvSpPr txBox="1"/>
              <p:nvPr/>
            </p:nvSpPr>
            <p:spPr>
              <a:xfrm>
                <a:off x="3501466" y="4242218"/>
                <a:ext cx="912968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procaspase-8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Textfeld 201"/>
              <p:cNvSpPr txBox="1"/>
              <p:nvPr/>
            </p:nvSpPr>
            <p:spPr>
              <a:xfrm>
                <a:off x="3703600" y="4478096"/>
                <a:ext cx="710834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PRMT5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Textfeld 202"/>
              <p:cNvSpPr txBox="1"/>
              <p:nvPr/>
            </p:nvSpPr>
            <p:spPr>
              <a:xfrm>
                <a:off x="3703600" y="4643791"/>
                <a:ext cx="710834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WD45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4" name="Textfeld 203"/>
              <p:cNvSpPr txBox="1"/>
              <p:nvPr/>
            </p:nvSpPr>
            <p:spPr>
              <a:xfrm>
                <a:off x="3703600" y="4964405"/>
                <a:ext cx="710834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RIOK1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Textfeld 204"/>
              <p:cNvSpPr txBox="1"/>
              <p:nvPr/>
            </p:nvSpPr>
            <p:spPr>
              <a:xfrm>
                <a:off x="3839317" y="5229632"/>
                <a:ext cx="575117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6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actin</a:t>
                </a:r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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06" name="Gruppieren 205"/>
              <p:cNvGrpSpPr/>
              <p:nvPr/>
            </p:nvGrpSpPr>
            <p:grpSpPr>
              <a:xfrm>
                <a:off x="3530019" y="3632976"/>
                <a:ext cx="2008086" cy="1912407"/>
                <a:chOff x="3530019" y="3632976"/>
                <a:chExt cx="2008086" cy="1912407"/>
              </a:xfrm>
            </p:grpSpPr>
            <p:pic>
              <p:nvPicPr>
                <p:cNvPr id="207" name="Grafik 206"/>
                <p:cNvPicPr>
                  <a:picLocks noChangeAspect="1"/>
                </p:cNvPicPr>
                <p:nvPr/>
              </p:nvPicPr>
              <p:blipFill rotWithShape="1">
                <a:blip r:embed="rId2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32163" r="20416" b="51034"/>
                <a:stretch/>
              </p:blipFill>
              <p:spPr>
                <a:xfrm>
                  <a:off x="4354311" y="4093967"/>
                  <a:ext cx="828000" cy="382499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208" name="Textfeld 207"/>
                <p:cNvSpPr txBox="1"/>
                <p:nvPr/>
              </p:nvSpPr>
              <p:spPr>
                <a:xfrm>
                  <a:off x="3530019" y="3872605"/>
                  <a:ext cx="825529" cy="227281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pPr algn="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[min]</a:t>
                  </a:r>
                  <a:endParaRPr lang="de-DE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9" name="Textfeld 208"/>
                <p:cNvSpPr txBox="1"/>
                <p:nvPr/>
              </p:nvSpPr>
              <p:spPr>
                <a:xfrm>
                  <a:off x="4376220" y="3872764"/>
                  <a:ext cx="163927" cy="2272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sp>
              <p:nvSpPr>
                <p:cNvPr id="210" name="Textfeld 209"/>
                <p:cNvSpPr txBox="1"/>
                <p:nvPr/>
              </p:nvSpPr>
              <p:spPr>
                <a:xfrm>
                  <a:off x="4475471" y="3872764"/>
                  <a:ext cx="344037" cy="2272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</a:p>
              </p:txBody>
            </p:sp>
            <p:sp>
              <p:nvSpPr>
                <p:cNvPr id="211" name="Textfeld 210"/>
                <p:cNvSpPr txBox="1"/>
                <p:nvPr/>
              </p:nvSpPr>
              <p:spPr>
                <a:xfrm>
                  <a:off x="4701909" y="3872764"/>
                  <a:ext cx="344575" cy="2272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0</a:t>
                  </a:r>
                </a:p>
              </p:txBody>
            </p:sp>
            <p:sp>
              <p:nvSpPr>
                <p:cNvPr id="212" name="Textfeld 211"/>
                <p:cNvSpPr txBox="1"/>
                <p:nvPr/>
              </p:nvSpPr>
              <p:spPr>
                <a:xfrm>
                  <a:off x="4894122" y="3872764"/>
                  <a:ext cx="363542" cy="2272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0</a:t>
                  </a:r>
                </a:p>
              </p:txBody>
            </p:sp>
            <p:sp>
              <p:nvSpPr>
                <p:cNvPr id="213" name="Textfeld 212"/>
                <p:cNvSpPr txBox="1"/>
                <p:nvPr/>
              </p:nvSpPr>
              <p:spPr>
                <a:xfrm>
                  <a:off x="5109374" y="3947957"/>
                  <a:ext cx="428731" cy="2272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6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de-DE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14" name="Gerade Verbindung 14"/>
                <p:cNvCxnSpPr/>
                <p:nvPr/>
              </p:nvCxnSpPr>
              <p:spPr>
                <a:xfrm flipH="1">
                  <a:off x="4333985" y="3866196"/>
                  <a:ext cx="828000" cy="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15" name="Textfeld 214"/>
                <p:cNvSpPr txBox="1"/>
                <p:nvPr/>
              </p:nvSpPr>
              <p:spPr>
                <a:xfrm>
                  <a:off x="4334560" y="3632976"/>
                  <a:ext cx="827425" cy="227281"/>
                </a:xfrm>
                <a:prstGeom prst="rect">
                  <a:avLst/>
                </a:prstGeom>
                <a:noFill/>
              </p:spPr>
              <p:txBody>
                <a:bodyPr wrap="square" rtlCol="0" anchor="ctr">
                  <a:spAutoFit/>
                </a:bodyPr>
                <a:lstStyle/>
                <a:p>
                  <a:pPr algn="ctr"/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  <a:sym typeface="Wingdings" panose="05000000000000000000" pitchFamily="2" charset="2"/>
                    </a:rPr>
                    <a:t>Input</a:t>
                  </a:r>
                  <a:endParaRPr lang="de-DE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216" name="Grafik 215"/>
                <p:cNvPicPr>
                  <a:picLocks noChangeAspect="1"/>
                </p:cNvPicPr>
                <p:nvPr/>
              </p:nvPicPr>
              <p:blipFill rotWithShape="1">
                <a:blip r:embed="rId2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603" t="22255" r="20865" b="70000"/>
                <a:stretch/>
              </p:blipFill>
              <p:spPr>
                <a:xfrm>
                  <a:off x="4354311" y="4481999"/>
                  <a:ext cx="828000" cy="174813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217" name="Textfeld 216"/>
                <p:cNvSpPr txBox="1"/>
                <p:nvPr/>
              </p:nvSpPr>
              <p:spPr>
                <a:xfrm>
                  <a:off x="5104613" y="4318347"/>
                  <a:ext cx="433492" cy="2272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50</a:t>
                  </a:r>
                </a:p>
              </p:txBody>
            </p:sp>
            <p:sp>
              <p:nvSpPr>
                <p:cNvPr id="218" name="Textfeld 217"/>
                <p:cNvSpPr txBox="1"/>
                <p:nvPr/>
              </p:nvSpPr>
              <p:spPr>
                <a:xfrm>
                  <a:off x="5109374" y="4433932"/>
                  <a:ext cx="428731" cy="2272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75</a:t>
                  </a:r>
                </a:p>
              </p:txBody>
            </p:sp>
            <p:pic>
              <p:nvPicPr>
                <p:cNvPr id="219" name="Grafik 218"/>
                <p:cNvPicPr>
                  <a:picLocks noChangeAspect="1"/>
                </p:cNvPicPr>
                <p:nvPr/>
              </p:nvPicPr>
              <p:blipFill rotWithShape="1">
                <a:blip r:embed="rId2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969" t="50286" r="18306" b="39608"/>
                <a:stretch/>
              </p:blipFill>
              <p:spPr>
                <a:xfrm>
                  <a:off x="4354311" y="4662345"/>
                  <a:ext cx="828000" cy="257289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220" name="Textfeld 219"/>
                <p:cNvSpPr txBox="1"/>
                <p:nvPr/>
              </p:nvSpPr>
              <p:spPr>
                <a:xfrm>
                  <a:off x="5109374" y="4721678"/>
                  <a:ext cx="428731" cy="2272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37</a:t>
                  </a:r>
                </a:p>
              </p:txBody>
            </p:sp>
            <p:pic>
              <p:nvPicPr>
                <p:cNvPr id="221" name="Grafik 220"/>
                <p:cNvPicPr>
                  <a:picLocks noChangeAspect="1"/>
                </p:cNvPicPr>
                <p:nvPr/>
              </p:nvPicPr>
              <p:blipFill rotWithShape="1">
                <a:blip r:embed="rId2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5916" r="21728" b="71065"/>
                <a:stretch/>
              </p:blipFill>
              <p:spPr>
                <a:xfrm>
                  <a:off x="4354311" y="4919635"/>
                  <a:ext cx="828000" cy="293031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222" name="Textfeld 221"/>
                <p:cNvSpPr txBox="1"/>
                <p:nvPr/>
              </p:nvSpPr>
              <p:spPr>
                <a:xfrm>
                  <a:off x="5109374" y="5029545"/>
                  <a:ext cx="428731" cy="2272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75</a:t>
                  </a:r>
                </a:p>
              </p:txBody>
            </p:sp>
            <p:pic>
              <p:nvPicPr>
                <p:cNvPr id="223" name="Grafik 222"/>
                <p:cNvPicPr>
                  <a:picLocks noChangeAspect="1"/>
                </p:cNvPicPr>
                <p:nvPr/>
              </p:nvPicPr>
              <p:blipFill rotWithShape="1">
                <a:blip r:embed="rId2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8372" t="47529" r="20034" b="38625"/>
                <a:stretch/>
              </p:blipFill>
              <p:spPr>
                <a:xfrm>
                  <a:off x="4354311" y="5200501"/>
                  <a:ext cx="828000" cy="287389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224" name="Textfeld 223"/>
                <p:cNvSpPr txBox="1"/>
                <p:nvPr/>
              </p:nvSpPr>
              <p:spPr>
                <a:xfrm>
                  <a:off x="5109374" y="5318102"/>
                  <a:ext cx="428731" cy="2272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37</a:t>
                  </a:r>
                </a:p>
              </p:txBody>
            </p:sp>
          </p:grpSp>
        </p:grpSp>
        <p:sp>
          <p:nvSpPr>
            <p:cNvPr id="200" name="Textfeld 199"/>
            <p:cNvSpPr txBox="1"/>
            <p:nvPr/>
          </p:nvSpPr>
          <p:spPr>
            <a:xfrm>
              <a:off x="1014880" y="5375377"/>
              <a:ext cx="1092461" cy="22728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200 </a:t>
              </a:r>
              <a:r>
                <a:rPr lang="de-DE" sz="6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ng</a:t>
              </a:r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/ml CD95L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5" name="Textfeld 224"/>
          <p:cNvSpPr txBox="1"/>
          <p:nvPr/>
        </p:nvSpPr>
        <p:spPr>
          <a:xfrm>
            <a:off x="535385" y="5234556"/>
            <a:ext cx="1742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Textfeld 225"/>
          <p:cNvSpPr txBox="1"/>
          <p:nvPr/>
        </p:nvSpPr>
        <p:spPr>
          <a:xfrm>
            <a:off x="535385" y="7642487"/>
            <a:ext cx="1742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Textfeld 226"/>
          <p:cNvSpPr txBox="1"/>
          <p:nvPr/>
        </p:nvSpPr>
        <p:spPr>
          <a:xfrm>
            <a:off x="875153" y="7056284"/>
            <a:ext cx="62377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IgG</a:t>
            </a:r>
            <a:r>
              <a:rPr lang="de-DE" sz="600" baseline="-25000" dirty="0" err="1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H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Textfeld 227"/>
          <p:cNvSpPr txBox="1"/>
          <p:nvPr/>
        </p:nvSpPr>
        <p:spPr>
          <a:xfrm>
            <a:off x="2850892" y="7202674"/>
            <a:ext cx="39735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229" name="Textfeld 228"/>
          <p:cNvSpPr txBox="1"/>
          <p:nvPr/>
        </p:nvSpPr>
        <p:spPr>
          <a:xfrm>
            <a:off x="2850892" y="7350921"/>
            <a:ext cx="34039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37</a:t>
            </a:r>
          </a:p>
        </p:txBody>
      </p:sp>
      <p:sp>
        <p:nvSpPr>
          <p:cNvPr id="230" name="Textfeld 229"/>
          <p:cNvSpPr txBox="1"/>
          <p:nvPr/>
        </p:nvSpPr>
        <p:spPr>
          <a:xfrm>
            <a:off x="1410965" y="702818"/>
            <a:ext cx="14500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KW 6.4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1" name="Textfeld 230"/>
          <p:cNvSpPr txBox="1"/>
          <p:nvPr/>
        </p:nvSpPr>
        <p:spPr>
          <a:xfrm>
            <a:off x="1469933" y="2462399"/>
            <a:ext cx="132293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KW 6.4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Textfeld 231"/>
          <p:cNvSpPr txBox="1"/>
          <p:nvPr/>
        </p:nvSpPr>
        <p:spPr>
          <a:xfrm>
            <a:off x="3791403" y="2380079"/>
            <a:ext cx="132293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KW 6.4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Textfeld 232"/>
          <p:cNvSpPr txBox="1"/>
          <p:nvPr/>
        </p:nvSpPr>
        <p:spPr>
          <a:xfrm>
            <a:off x="1457725" y="5391277"/>
            <a:ext cx="143822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KW 6.4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Textfeld 233"/>
          <p:cNvSpPr txBox="1"/>
          <p:nvPr/>
        </p:nvSpPr>
        <p:spPr>
          <a:xfrm>
            <a:off x="1426673" y="7815774"/>
            <a:ext cx="85438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KW 6.4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Textfeld 234"/>
          <p:cNvSpPr txBox="1"/>
          <p:nvPr/>
        </p:nvSpPr>
        <p:spPr>
          <a:xfrm>
            <a:off x="4155698" y="7814451"/>
            <a:ext cx="6677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KW 6.4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39470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387848" y="510675"/>
            <a:ext cx="5548836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63" dirty="0" smtClean="0">
                <a:latin typeface="Arial" panose="020B0604020202020204" pitchFamily="34" charset="0"/>
                <a:cs typeface="Arial" panose="020B0604020202020204" pitchFamily="34" charset="0"/>
              </a:rPr>
              <a:t>Fig. 3</a:t>
            </a:r>
            <a:endParaRPr lang="en-GB" sz="146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312" t="50230" r="35655" b="19551"/>
          <a:stretch/>
        </p:blipFill>
        <p:spPr>
          <a:xfrm>
            <a:off x="1969486" y="4197602"/>
            <a:ext cx="1632942" cy="10215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27" t="45650" r="39242" b="48168"/>
          <a:stretch/>
        </p:blipFill>
        <p:spPr>
          <a:xfrm>
            <a:off x="1969486" y="5226897"/>
            <a:ext cx="1632942" cy="20895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feld 6"/>
          <p:cNvSpPr txBox="1"/>
          <p:nvPr/>
        </p:nvSpPr>
        <p:spPr>
          <a:xfrm>
            <a:off x="1191648" y="4948636"/>
            <a:ext cx="81945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aspase-8 (p18)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1579575" y="5222604"/>
            <a:ext cx="43152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 rot="16200000">
            <a:off x="1826046" y="3908544"/>
            <a:ext cx="48282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HeLa-12</a:t>
            </a:r>
          </a:p>
        </p:txBody>
      </p:sp>
      <p:sp>
        <p:nvSpPr>
          <p:cNvPr id="13" name="Textfeld 12"/>
          <p:cNvSpPr txBox="1"/>
          <p:nvPr/>
        </p:nvSpPr>
        <p:spPr>
          <a:xfrm rot="16200000">
            <a:off x="2145388" y="3911149"/>
            <a:ext cx="47320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pcDNA3</a:t>
            </a:r>
          </a:p>
        </p:txBody>
      </p:sp>
      <p:sp>
        <p:nvSpPr>
          <p:cNvPr id="14" name="Textfeld 13"/>
          <p:cNvSpPr txBox="1"/>
          <p:nvPr/>
        </p:nvSpPr>
        <p:spPr>
          <a:xfrm rot="16200000">
            <a:off x="1585753" y="3196349"/>
            <a:ext cx="192348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procaspase-8a-WT 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8 µg / 10</a:t>
            </a:r>
            <a:r>
              <a:rPr lang="de-DE" sz="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 rot="16200000">
            <a:off x="1761633" y="3240397"/>
            <a:ext cx="183538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procaspase-8a-WT 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6 µg / 10</a:t>
            </a:r>
            <a:r>
              <a:rPr lang="de-DE" sz="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 rot="16200000">
            <a:off x="1854474" y="3169555"/>
            <a:ext cx="197707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procaspase-8a-WT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 4 µg / 10</a:t>
            </a:r>
            <a:r>
              <a:rPr lang="de-DE" sz="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 rot="16200000">
            <a:off x="2031312" y="3192158"/>
            <a:ext cx="193186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procaspase-8a-WT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 2,8 µg / 10</a:t>
            </a:r>
            <a:r>
              <a:rPr lang="de-DE" sz="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 rot="16200000">
            <a:off x="2115050" y="3119990"/>
            <a:ext cx="207620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procaspase-8a-WT 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2 µg / 10</a:t>
            </a:r>
            <a:r>
              <a:rPr lang="de-DE" sz="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 rot="16200000">
            <a:off x="2360136" y="3194818"/>
            <a:ext cx="192654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procaspase-8a-WT 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0,8 µg / 10</a:t>
            </a:r>
            <a:r>
              <a:rPr lang="de-DE" sz="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 rot="16200000">
            <a:off x="2521208" y="3195350"/>
            <a:ext cx="192548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procaspase-8a-WT 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0,4 µg / 10</a:t>
            </a:r>
            <a:r>
              <a:rPr lang="de-DE" sz="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 rot="16200000">
            <a:off x="1491167" y="3403408"/>
            <a:ext cx="150936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HeLa-CD95-C8-KO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1953650" y="4226681"/>
            <a:ext cx="1648778" cy="158516"/>
          </a:xfrm>
          <a:prstGeom prst="rect">
            <a:avLst/>
          </a:prstGeom>
          <a:noFill/>
          <a:ln w="19050"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1281416" y="4216031"/>
            <a:ext cx="729687" cy="184666"/>
          </a:xfrm>
          <a:prstGeom prst="rect">
            <a:avLst/>
          </a:prstGeom>
          <a:noFill/>
          <a:ln>
            <a:noFill/>
            <a:prstDash val="sysDot"/>
          </a:ln>
        </p:spPr>
        <p:txBody>
          <a:bodyPr wrap="non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procaspase-8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hteck 23"/>
          <p:cNvSpPr/>
          <p:nvPr/>
        </p:nvSpPr>
        <p:spPr>
          <a:xfrm>
            <a:off x="1961558" y="2867283"/>
            <a:ext cx="211800" cy="1517915"/>
          </a:xfrm>
          <a:prstGeom prst="rect">
            <a:avLst/>
          </a:prstGeom>
          <a:noFill/>
          <a:ln w="19050">
            <a:solidFill>
              <a:schemeClr val="accent6">
                <a:lumMod val="75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hteck 24"/>
          <p:cNvSpPr/>
          <p:nvPr/>
        </p:nvSpPr>
        <p:spPr>
          <a:xfrm>
            <a:off x="3073929" y="2432065"/>
            <a:ext cx="176674" cy="1953132"/>
          </a:xfrm>
          <a:prstGeom prst="rect">
            <a:avLst/>
          </a:prstGeom>
          <a:noFill/>
          <a:ln w="19050">
            <a:solidFill>
              <a:schemeClr val="accent6">
                <a:lumMod val="75000"/>
              </a:schemeClr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3576384" y="4301827"/>
            <a:ext cx="45245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32" name="Textfeld 31"/>
          <p:cNvSpPr txBox="1"/>
          <p:nvPr/>
        </p:nvSpPr>
        <p:spPr>
          <a:xfrm>
            <a:off x="3576384" y="5154799"/>
            <a:ext cx="3919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3576384" y="5313148"/>
            <a:ext cx="3919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37</a:t>
            </a:r>
          </a:p>
        </p:txBody>
      </p:sp>
    </p:spTree>
    <p:extLst>
      <p:ext uri="{BB962C8B-B14F-4D97-AF65-F5344CB8AC3E}">
        <p14:creationId xmlns:p14="http://schemas.microsoft.com/office/powerpoint/2010/main" val="5596559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7" name="Diagramm 2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89999247"/>
              </p:ext>
            </p:extLst>
          </p:nvPr>
        </p:nvGraphicFramePr>
        <p:xfrm>
          <a:off x="1002733" y="5415280"/>
          <a:ext cx="1721117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26" name="Diagramm 2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18935319"/>
              </p:ext>
            </p:extLst>
          </p:nvPr>
        </p:nvGraphicFramePr>
        <p:xfrm>
          <a:off x="1040845" y="3217567"/>
          <a:ext cx="1440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25" name="Diagramm 2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59615869"/>
              </p:ext>
            </p:extLst>
          </p:nvPr>
        </p:nvGraphicFramePr>
        <p:xfrm>
          <a:off x="1090250" y="1110905"/>
          <a:ext cx="1440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" name="Textfeld 3"/>
          <p:cNvSpPr txBox="1"/>
          <p:nvPr/>
        </p:nvSpPr>
        <p:spPr>
          <a:xfrm>
            <a:off x="666227" y="1"/>
            <a:ext cx="5548836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63" dirty="0" smtClean="0">
                <a:latin typeface="Arial" panose="020B0604020202020204" pitchFamily="34" charset="0"/>
                <a:cs typeface="Arial" panose="020B0604020202020204" pitchFamily="34" charset="0"/>
              </a:rPr>
              <a:t>Fig. 4</a:t>
            </a:r>
            <a:endParaRPr lang="en-GB" sz="146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5883156" y="1385184"/>
            <a:ext cx="33142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37</a:t>
            </a:r>
          </a:p>
        </p:txBody>
      </p:sp>
      <p:sp>
        <p:nvSpPr>
          <p:cNvPr id="41" name="Textfeld 40"/>
          <p:cNvSpPr txBox="1"/>
          <p:nvPr/>
        </p:nvSpPr>
        <p:spPr>
          <a:xfrm>
            <a:off x="3364207" y="2948775"/>
            <a:ext cx="10152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procaspase-8a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3364207" y="3136652"/>
            <a:ext cx="10152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caspase-8 (p43)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feld 42"/>
          <p:cNvSpPr txBox="1"/>
          <p:nvPr/>
        </p:nvSpPr>
        <p:spPr>
          <a:xfrm>
            <a:off x="3364207" y="3409635"/>
            <a:ext cx="10152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actin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5886566" y="1635822"/>
            <a:ext cx="3314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25</a:t>
            </a:r>
          </a:p>
        </p:txBody>
      </p:sp>
      <p:sp>
        <p:nvSpPr>
          <p:cNvPr id="46" name="Textfeld 45"/>
          <p:cNvSpPr txBox="1"/>
          <p:nvPr/>
        </p:nvSpPr>
        <p:spPr>
          <a:xfrm>
            <a:off x="5883156" y="1902870"/>
            <a:ext cx="32013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20</a:t>
            </a:r>
          </a:p>
        </p:txBody>
      </p:sp>
      <p:sp>
        <p:nvSpPr>
          <p:cNvPr id="74" name="Textfeld 73"/>
          <p:cNvSpPr txBox="1"/>
          <p:nvPr/>
        </p:nvSpPr>
        <p:spPr>
          <a:xfrm>
            <a:off x="5883157" y="3288030"/>
            <a:ext cx="32013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83" name="Textfeld 82"/>
          <p:cNvSpPr txBox="1"/>
          <p:nvPr/>
        </p:nvSpPr>
        <p:spPr>
          <a:xfrm>
            <a:off x="5883157" y="3444326"/>
            <a:ext cx="29575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37</a:t>
            </a:r>
          </a:p>
        </p:txBody>
      </p:sp>
      <p:cxnSp>
        <p:nvCxnSpPr>
          <p:cNvPr id="86" name="Gerade Verbindung 14"/>
          <p:cNvCxnSpPr/>
          <p:nvPr/>
        </p:nvCxnSpPr>
        <p:spPr>
          <a:xfrm flipH="1">
            <a:off x="4328940" y="1210560"/>
            <a:ext cx="263250" cy="118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7" name="Textfeld 86"/>
          <p:cNvSpPr txBox="1"/>
          <p:nvPr/>
        </p:nvSpPr>
        <p:spPr>
          <a:xfrm>
            <a:off x="4342211" y="1206562"/>
            <a:ext cx="13319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8" name="Textfeld 87"/>
          <p:cNvSpPr txBox="1"/>
          <p:nvPr/>
        </p:nvSpPr>
        <p:spPr>
          <a:xfrm>
            <a:off x="4437155" y="1207786"/>
            <a:ext cx="2423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9" name="Textfeld 88"/>
          <p:cNvSpPr txBox="1"/>
          <p:nvPr/>
        </p:nvSpPr>
        <p:spPr>
          <a:xfrm>
            <a:off x="3127620" y="1204593"/>
            <a:ext cx="1214591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3h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feld 89"/>
          <p:cNvSpPr txBox="1"/>
          <p:nvPr/>
        </p:nvSpPr>
        <p:spPr>
          <a:xfrm>
            <a:off x="4596570" y="1200657"/>
            <a:ext cx="2662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1" name="Textfeld 90"/>
          <p:cNvSpPr txBox="1"/>
          <p:nvPr/>
        </p:nvSpPr>
        <p:spPr>
          <a:xfrm>
            <a:off x="3364207" y="1498728"/>
            <a:ext cx="10152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procaspase-3 (</a:t>
            </a:r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s.e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.)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feld 91"/>
          <p:cNvSpPr txBox="1"/>
          <p:nvPr/>
        </p:nvSpPr>
        <p:spPr>
          <a:xfrm>
            <a:off x="4772480" y="1196750"/>
            <a:ext cx="2423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3" name="Textfeld 92"/>
          <p:cNvSpPr txBox="1"/>
          <p:nvPr/>
        </p:nvSpPr>
        <p:spPr>
          <a:xfrm>
            <a:off x="4918447" y="1201348"/>
            <a:ext cx="2662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4" name="Textfeld 93"/>
          <p:cNvSpPr txBox="1"/>
          <p:nvPr/>
        </p:nvSpPr>
        <p:spPr>
          <a:xfrm>
            <a:off x="5065383" y="1196750"/>
            <a:ext cx="2423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5" name="Textfeld 94"/>
          <p:cNvSpPr txBox="1"/>
          <p:nvPr/>
        </p:nvSpPr>
        <p:spPr>
          <a:xfrm>
            <a:off x="5281382" y="1201442"/>
            <a:ext cx="2662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6" name="Textfeld 95"/>
          <p:cNvSpPr txBox="1"/>
          <p:nvPr/>
        </p:nvSpPr>
        <p:spPr>
          <a:xfrm>
            <a:off x="5423559" y="1203451"/>
            <a:ext cx="2423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7" name="Textfeld 96"/>
          <p:cNvSpPr txBox="1"/>
          <p:nvPr/>
        </p:nvSpPr>
        <p:spPr>
          <a:xfrm>
            <a:off x="5883157" y="1261351"/>
            <a:ext cx="34224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feld 97"/>
          <p:cNvSpPr txBox="1"/>
          <p:nvPr/>
        </p:nvSpPr>
        <p:spPr>
          <a:xfrm>
            <a:off x="4231905" y="1055318"/>
            <a:ext cx="4041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feld 98"/>
          <p:cNvSpPr txBox="1"/>
          <p:nvPr/>
        </p:nvSpPr>
        <p:spPr>
          <a:xfrm>
            <a:off x="4602374" y="1055318"/>
            <a:ext cx="43296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R233H</a:t>
            </a:r>
          </a:p>
        </p:txBody>
      </p:sp>
      <p:sp>
        <p:nvSpPr>
          <p:cNvPr id="100" name="Textfeld 99"/>
          <p:cNvSpPr txBox="1"/>
          <p:nvPr/>
        </p:nvSpPr>
        <p:spPr>
          <a:xfrm>
            <a:off x="4946147" y="1055318"/>
            <a:ext cx="43226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R435Q</a:t>
            </a:r>
          </a:p>
        </p:txBody>
      </p:sp>
      <p:sp>
        <p:nvSpPr>
          <p:cNvPr id="101" name="Textfeld 100"/>
          <p:cNvSpPr txBox="1"/>
          <p:nvPr/>
        </p:nvSpPr>
        <p:spPr>
          <a:xfrm>
            <a:off x="5598373" y="1055318"/>
            <a:ext cx="3510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KO</a:t>
            </a:r>
          </a:p>
        </p:txBody>
      </p:sp>
      <p:sp>
        <p:nvSpPr>
          <p:cNvPr id="102" name="Textfeld 101"/>
          <p:cNvSpPr txBox="1"/>
          <p:nvPr/>
        </p:nvSpPr>
        <p:spPr>
          <a:xfrm>
            <a:off x="4167942" y="1053019"/>
            <a:ext cx="17426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endParaRPr lang="en-GB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feld 102"/>
          <p:cNvSpPr txBox="1"/>
          <p:nvPr/>
        </p:nvSpPr>
        <p:spPr>
          <a:xfrm>
            <a:off x="5883157" y="2475526"/>
            <a:ext cx="32013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25</a:t>
            </a:r>
          </a:p>
        </p:txBody>
      </p:sp>
      <p:sp>
        <p:nvSpPr>
          <p:cNvPr id="105" name="Textfeld 104"/>
          <p:cNvSpPr txBox="1"/>
          <p:nvPr/>
        </p:nvSpPr>
        <p:spPr>
          <a:xfrm>
            <a:off x="5883157" y="2649382"/>
            <a:ext cx="3314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20</a:t>
            </a:r>
          </a:p>
        </p:txBody>
      </p:sp>
      <p:sp>
        <p:nvSpPr>
          <p:cNvPr id="108" name="Textfeld 107"/>
          <p:cNvSpPr txBox="1"/>
          <p:nvPr/>
        </p:nvSpPr>
        <p:spPr>
          <a:xfrm>
            <a:off x="5569289" y="1195000"/>
            <a:ext cx="26621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9" name="Textfeld 108"/>
          <p:cNvSpPr txBox="1"/>
          <p:nvPr/>
        </p:nvSpPr>
        <p:spPr>
          <a:xfrm>
            <a:off x="5711467" y="1197009"/>
            <a:ext cx="24239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0" name="Textfeld 109"/>
          <p:cNvSpPr txBox="1"/>
          <p:nvPr/>
        </p:nvSpPr>
        <p:spPr>
          <a:xfrm>
            <a:off x="4327433" y="898121"/>
            <a:ext cx="1621940" cy="18466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500 </a:t>
            </a:r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ng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/ml CD95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1" name="Gerade Verbindung 14"/>
          <p:cNvCxnSpPr/>
          <p:nvPr/>
        </p:nvCxnSpPr>
        <p:spPr>
          <a:xfrm flipH="1">
            <a:off x="4692328" y="1210560"/>
            <a:ext cx="263250" cy="118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2" name="Gerade Verbindung 14"/>
          <p:cNvCxnSpPr/>
          <p:nvPr/>
        </p:nvCxnSpPr>
        <p:spPr>
          <a:xfrm flipH="1">
            <a:off x="5020595" y="1210560"/>
            <a:ext cx="263250" cy="118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3" name="Gerade Verbindung 14"/>
          <p:cNvCxnSpPr/>
          <p:nvPr/>
        </p:nvCxnSpPr>
        <p:spPr>
          <a:xfrm flipH="1">
            <a:off x="5338824" y="1210560"/>
            <a:ext cx="263250" cy="118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4" name="Gerade Verbindung 14"/>
          <p:cNvCxnSpPr/>
          <p:nvPr/>
        </p:nvCxnSpPr>
        <p:spPr>
          <a:xfrm flipH="1">
            <a:off x="5642248" y="1210560"/>
            <a:ext cx="263250" cy="1182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15" name="Textfeld 114"/>
          <p:cNvSpPr txBox="1"/>
          <p:nvPr/>
        </p:nvSpPr>
        <p:spPr>
          <a:xfrm>
            <a:off x="5280324" y="1055318"/>
            <a:ext cx="38025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16" name="Textfeld 115"/>
          <p:cNvSpPr txBox="1"/>
          <p:nvPr/>
        </p:nvSpPr>
        <p:spPr>
          <a:xfrm>
            <a:off x="3364207" y="2306456"/>
            <a:ext cx="10152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procaspase-3 (</a:t>
            </a:r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l.e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.)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feld 116"/>
          <p:cNvSpPr txBox="1"/>
          <p:nvPr/>
        </p:nvSpPr>
        <p:spPr>
          <a:xfrm>
            <a:off x="3238293" y="2726456"/>
            <a:ext cx="114113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caspase-3 (p19/17) (</a:t>
            </a:r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l.e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.)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feld 117"/>
          <p:cNvSpPr txBox="1"/>
          <p:nvPr/>
        </p:nvSpPr>
        <p:spPr>
          <a:xfrm>
            <a:off x="5883157" y="2992404"/>
            <a:ext cx="3314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19" name="Textfeld 118"/>
          <p:cNvSpPr txBox="1"/>
          <p:nvPr/>
        </p:nvSpPr>
        <p:spPr>
          <a:xfrm>
            <a:off x="5883157" y="3175910"/>
            <a:ext cx="33142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37</a:t>
            </a:r>
          </a:p>
        </p:txBody>
      </p:sp>
      <p:sp>
        <p:nvSpPr>
          <p:cNvPr id="124" name="Textfeld 123"/>
          <p:cNvSpPr txBox="1"/>
          <p:nvPr/>
        </p:nvSpPr>
        <p:spPr>
          <a:xfrm>
            <a:off x="143150" y="7317537"/>
            <a:ext cx="1742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feld 124"/>
          <p:cNvSpPr txBox="1"/>
          <p:nvPr/>
        </p:nvSpPr>
        <p:spPr>
          <a:xfrm>
            <a:off x="3091456" y="894839"/>
            <a:ext cx="1742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3" name="Gruppieren 12"/>
          <p:cNvGrpSpPr/>
          <p:nvPr/>
        </p:nvGrpSpPr>
        <p:grpSpPr>
          <a:xfrm>
            <a:off x="1063245" y="7717804"/>
            <a:ext cx="1548000" cy="1618442"/>
            <a:chOff x="1364908" y="7176581"/>
            <a:chExt cx="1548000" cy="1618442"/>
          </a:xfrm>
        </p:grpSpPr>
        <p:sp>
          <p:nvSpPr>
            <p:cNvPr id="127" name="Textfeld 126"/>
            <p:cNvSpPr txBox="1"/>
            <p:nvPr/>
          </p:nvSpPr>
          <p:spPr>
            <a:xfrm>
              <a:off x="1544907" y="7176581"/>
              <a:ext cx="128346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6h CD95L [1000 </a:t>
              </a:r>
              <a:r>
                <a:rPr lang="de-DE" sz="6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ng</a:t>
              </a:r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/ml]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29" name="Diagramm 12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0770984"/>
                </p:ext>
              </p:extLst>
            </p:nvPr>
          </p:nvGraphicFramePr>
          <p:xfrm>
            <a:off x="1364908" y="7332523"/>
            <a:ext cx="1548000" cy="14625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pSp>
          <p:nvGrpSpPr>
            <p:cNvPr id="130" name="Gruppieren 129"/>
            <p:cNvGrpSpPr/>
            <p:nvPr/>
          </p:nvGrpSpPr>
          <p:grpSpPr>
            <a:xfrm>
              <a:off x="2287523" y="7368320"/>
              <a:ext cx="537620" cy="379138"/>
              <a:chOff x="4924692" y="6559712"/>
              <a:chExt cx="584335" cy="466632"/>
            </a:xfrm>
          </p:grpSpPr>
          <p:cxnSp>
            <p:nvCxnSpPr>
              <p:cNvPr id="141" name="Gerader Verbinder 140"/>
              <p:cNvCxnSpPr/>
              <p:nvPr/>
            </p:nvCxnSpPr>
            <p:spPr>
              <a:xfrm>
                <a:off x="4926278" y="6936344"/>
                <a:ext cx="531313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2" name="Gerader Verbinder 141"/>
              <p:cNvCxnSpPr/>
              <p:nvPr/>
            </p:nvCxnSpPr>
            <p:spPr>
              <a:xfrm>
                <a:off x="5457591" y="6936344"/>
                <a:ext cx="0" cy="9000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3" name="Gerader Verbinder 142"/>
              <p:cNvCxnSpPr/>
              <p:nvPr/>
            </p:nvCxnSpPr>
            <p:spPr>
              <a:xfrm>
                <a:off x="4924692" y="6936344"/>
                <a:ext cx="0" cy="9000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4" name="Textfeld 143"/>
              <p:cNvSpPr txBox="1"/>
              <p:nvPr/>
            </p:nvSpPr>
            <p:spPr>
              <a:xfrm>
                <a:off x="5004066" y="6770116"/>
                <a:ext cx="371193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</a:p>
            </p:txBody>
          </p:sp>
          <p:cxnSp>
            <p:nvCxnSpPr>
              <p:cNvPr id="145" name="Gerader Verbinder 144"/>
              <p:cNvCxnSpPr/>
              <p:nvPr/>
            </p:nvCxnSpPr>
            <p:spPr>
              <a:xfrm>
                <a:off x="5189271" y="6722021"/>
                <a:ext cx="26832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146" name="Gruppieren 145"/>
              <p:cNvGrpSpPr/>
              <p:nvPr/>
            </p:nvGrpSpPr>
            <p:grpSpPr>
              <a:xfrm>
                <a:off x="5137834" y="6559712"/>
                <a:ext cx="371193" cy="245684"/>
                <a:chOff x="1594589" y="1193232"/>
                <a:chExt cx="371193" cy="245684"/>
              </a:xfrm>
            </p:grpSpPr>
            <p:cxnSp>
              <p:nvCxnSpPr>
                <p:cNvPr id="147" name="Gerader Verbinder 146"/>
                <p:cNvCxnSpPr/>
                <p:nvPr/>
              </p:nvCxnSpPr>
              <p:spPr>
                <a:xfrm>
                  <a:off x="1914346" y="1348916"/>
                  <a:ext cx="0" cy="9000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48" name="Gerader Verbinder 147"/>
                <p:cNvCxnSpPr/>
                <p:nvPr/>
              </p:nvCxnSpPr>
              <p:spPr>
                <a:xfrm>
                  <a:off x="1646026" y="1348916"/>
                  <a:ext cx="0" cy="9000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49" name="Textfeld 148"/>
                <p:cNvSpPr txBox="1"/>
                <p:nvPr/>
              </p:nvSpPr>
              <p:spPr>
                <a:xfrm>
                  <a:off x="1594589" y="1193232"/>
                  <a:ext cx="371193" cy="2272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</a:p>
              </p:txBody>
            </p:sp>
          </p:grpSp>
        </p:grpSp>
        <p:grpSp>
          <p:nvGrpSpPr>
            <p:cNvPr id="131" name="Gruppieren 130"/>
            <p:cNvGrpSpPr/>
            <p:nvPr/>
          </p:nvGrpSpPr>
          <p:grpSpPr>
            <a:xfrm>
              <a:off x="2232254" y="7631466"/>
              <a:ext cx="529861" cy="388514"/>
              <a:chOff x="4924692" y="6554507"/>
              <a:chExt cx="592469" cy="478171"/>
            </a:xfrm>
          </p:grpSpPr>
          <p:cxnSp>
            <p:nvCxnSpPr>
              <p:cNvPr id="132" name="Gerader Verbinder 131"/>
              <p:cNvCxnSpPr/>
              <p:nvPr/>
            </p:nvCxnSpPr>
            <p:spPr>
              <a:xfrm>
                <a:off x="4926278" y="6936344"/>
                <a:ext cx="531313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3" name="Gerader Verbinder 132"/>
              <p:cNvCxnSpPr/>
              <p:nvPr/>
            </p:nvCxnSpPr>
            <p:spPr>
              <a:xfrm>
                <a:off x="5457591" y="6936344"/>
                <a:ext cx="0" cy="9000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4" name="Gerader Verbinder 133"/>
              <p:cNvCxnSpPr/>
              <p:nvPr/>
            </p:nvCxnSpPr>
            <p:spPr>
              <a:xfrm>
                <a:off x="4924692" y="6936344"/>
                <a:ext cx="0" cy="9000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5" name="Textfeld 134"/>
              <p:cNvSpPr txBox="1"/>
              <p:nvPr/>
            </p:nvSpPr>
            <p:spPr>
              <a:xfrm>
                <a:off x="5005545" y="6805397"/>
                <a:ext cx="371193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cxnSp>
            <p:nvCxnSpPr>
              <p:cNvPr id="136" name="Gerader Verbinder 135"/>
              <p:cNvCxnSpPr/>
              <p:nvPr/>
            </p:nvCxnSpPr>
            <p:spPr>
              <a:xfrm>
                <a:off x="5189271" y="6722021"/>
                <a:ext cx="26832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137" name="Gruppieren 136"/>
              <p:cNvGrpSpPr/>
              <p:nvPr/>
            </p:nvGrpSpPr>
            <p:grpSpPr>
              <a:xfrm>
                <a:off x="5145968" y="6554507"/>
                <a:ext cx="371193" cy="250889"/>
                <a:chOff x="1602723" y="1188027"/>
                <a:chExt cx="371193" cy="250889"/>
              </a:xfrm>
            </p:grpSpPr>
            <p:cxnSp>
              <p:nvCxnSpPr>
                <p:cNvPr id="138" name="Gerader Verbinder 137"/>
                <p:cNvCxnSpPr/>
                <p:nvPr/>
              </p:nvCxnSpPr>
              <p:spPr>
                <a:xfrm>
                  <a:off x="1914346" y="1348916"/>
                  <a:ext cx="0" cy="9000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39" name="Gerader Verbinder 138"/>
                <p:cNvCxnSpPr/>
                <p:nvPr/>
              </p:nvCxnSpPr>
              <p:spPr>
                <a:xfrm>
                  <a:off x="1646026" y="1348916"/>
                  <a:ext cx="0" cy="90000"/>
                </a:xfrm>
                <a:prstGeom prst="line">
                  <a:avLst/>
                </a:prstGeom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140" name="Textfeld 139"/>
                <p:cNvSpPr txBox="1"/>
                <p:nvPr/>
              </p:nvSpPr>
              <p:spPr>
                <a:xfrm>
                  <a:off x="1602723" y="1188027"/>
                  <a:ext cx="371193" cy="2272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</a:p>
              </p:txBody>
            </p:sp>
          </p:grpSp>
        </p:grpSp>
      </p:grpSp>
      <p:sp>
        <p:nvSpPr>
          <p:cNvPr id="182" name="Textfeld 181"/>
          <p:cNvSpPr txBox="1"/>
          <p:nvPr/>
        </p:nvSpPr>
        <p:spPr>
          <a:xfrm>
            <a:off x="67441" y="887840"/>
            <a:ext cx="1415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68" name="Grafik 167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72" t="19046" r="16095" b="72922"/>
          <a:stretch/>
        </p:blipFill>
        <p:spPr>
          <a:xfrm>
            <a:off x="1355060" y="2525263"/>
            <a:ext cx="1080000" cy="21581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9" name="Textfeld 168"/>
          <p:cNvSpPr txBox="1"/>
          <p:nvPr/>
        </p:nvSpPr>
        <p:spPr>
          <a:xfrm>
            <a:off x="2426361" y="2592771"/>
            <a:ext cx="2963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</a:p>
        </p:txBody>
      </p:sp>
      <p:pic>
        <p:nvPicPr>
          <p:cNvPr id="170" name="Grafik 16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9450" r="16200" b="62435"/>
          <a:stretch/>
        </p:blipFill>
        <p:spPr>
          <a:xfrm>
            <a:off x="1355060" y="2726202"/>
            <a:ext cx="1080000" cy="19631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1" name="Textfeld 170"/>
          <p:cNvSpPr txBox="1"/>
          <p:nvPr/>
        </p:nvSpPr>
        <p:spPr>
          <a:xfrm>
            <a:off x="2426360" y="2772356"/>
            <a:ext cx="29631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37</a:t>
            </a:r>
          </a:p>
        </p:txBody>
      </p:sp>
      <p:sp>
        <p:nvSpPr>
          <p:cNvPr id="176" name="Textfeld 175"/>
          <p:cNvSpPr txBox="1"/>
          <p:nvPr/>
        </p:nvSpPr>
        <p:spPr>
          <a:xfrm>
            <a:off x="2050606" y="1186296"/>
            <a:ext cx="31190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b="1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grpSp>
        <p:nvGrpSpPr>
          <p:cNvPr id="10" name="Gruppieren 9"/>
          <p:cNvGrpSpPr/>
          <p:nvPr/>
        </p:nvGrpSpPr>
        <p:grpSpPr>
          <a:xfrm>
            <a:off x="2078144" y="1310366"/>
            <a:ext cx="264476" cy="59414"/>
            <a:chOff x="5281277" y="1023710"/>
            <a:chExt cx="271848" cy="59414"/>
          </a:xfrm>
        </p:grpSpPr>
        <p:cxnSp>
          <p:nvCxnSpPr>
            <p:cNvPr id="177" name="Gerader Verbinder 176"/>
            <p:cNvCxnSpPr/>
            <p:nvPr/>
          </p:nvCxnSpPr>
          <p:spPr>
            <a:xfrm>
              <a:off x="5281277" y="1023710"/>
              <a:ext cx="271848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78" name="Gerader Verbinder 177"/>
            <p:cNvCxnSpPr/>
            <p:nvPr/>
          </p:nvCxnSpPr>
          <p:spPr>
            <a:xfrm>
              <a:off x="5551892" y="1023710"/>
              <a:ext cx="0" cy="59414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79" name="Gerader Verbinder 178"/>
            <p:cNvCxnSpPr/>
            <p:nvPr/>
          </p:nvCxnSpPr>
          <p:spPr>
            <a:xfrm>
              <a:off x="5281277" y="1023710"/>
              <a:ext cx="0" cy="59414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1" name="Gruppieren 10"/>
          <p:cNvGrpSpPr/>
          <p:nvPr/>
        </p:nvGrpSpPr>
        <p:grpSpPr>
          <a:xfrm>
            <a:off x="1813489" y="1430500"/>
            <a:ext cx="534520" cy="59415"/>
            <a:chOff x="5186752" y="1814149"/>
            <a:chExt cx="489523" cy="59415"/>
          </a:xfrm>
        </p:grpSpPr>
        <p:cxnSp>
          <p:nvCxnSpPr>
            <p:cNvPr id="172" name="Gerader Verbinder 171"/>
            <p:cNvCxnSpPr/>
            <p:nvPr/>
          </p:nvCxnSpPr>
          <p:spPr>
            <a:xfrm>
              <a:off x="5186752" y="1814149"/>
              <a:ext cx="489523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73" name="Gerader Verbinder 172"/>
            <p:cNvCxnSpPr/>
            <p:nvPr/>
          </p:nvCxnSpPr>
          <p:spPr>
            <a:xfrm>
              <a:off x="5671340" y="1814150"/>
              <a:ext cx="0" cy="59414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74" name="Gerader Verbinder 173"/>
            <p:cNvCxnSpPr/>
            <p:nvPr/>
          </p:nvCxnSpPr>
          <p:spPr>
            <a:xfrm>
              <a:off x="5186752" y="1814150"/>
              <a:ext cx="0" cy="59414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80" name="Textfeld 179"/>
          <p:cNvSpPr txBox="1"/>
          <p:nvPr/>
        </p:nvSpPr>
        <p:spPr>
          <a:xfrm>
            <a:off x="1786731" y="1317945"/>
            <a:ext cx="57594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b="1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181" name="Textfeld 180"/>
          <p:cNvSpPr txBox="1"/>
          <p:nvPr/>
        </p:nvSpPr>
        <p:spPr>
          <a:xfrm>
            <a:off x="1280107" y="1011253"/>
            <a:ext cx="106945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2h CD95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feld 182"/>
          <p:cNvSpPr txBox="1"/>
          <p:nvPr/>
        </p:nvSpPr>
        <p:spPr>
          <a:xfrm>
            <a:off x="2399233" y="2378712"/>
            <a:ext cx="356985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feld 185"/>
          <p:cNvSpPr txBox="1"/>
          <p:nvPr/>
        </p:nvSpPr>
        <p:spPr>
          <a:xfrm>
            <a:off x="541662" y="2511752"/>
            <a:ext cx="8248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procaspase-8a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feld 186"/>
          <p:cNvSpPr txBox="1"/>
          <p:nvPr/>
        </p:nvSpPr>
        <p:spPr>
          <a:xfrm>
            <a:off x="541662" y="2692518"/>
            <a:ext cx="8248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actin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Textfeld 201"/>
          <p:cNvSpPr txBox="1"/>
          <p:nvPr/>
        </p:nvSpPr>
        <p:spPr>
          <a:xfrm>
            <a:off x="67441" y="2998431"/>
            <a:ext cx="1415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4" name="Textfeld 203"/>
          <p:cNvSpPr txBox="1"/>
          <p:nvPr/>
        </p:nvSpPr>
        <p:spPr>
          <a:xfrm>
            <a:off x="320200" y="6857104"/>
            <a:ext cx="10152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procaspase-8a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Textfeld 204"/>
          <p:cNvSpPr txBox="1"/>
          <p:nvPr/>
        </p:nvSpPr>
        <p:spPr>
          <a:xfrm>
            <a:off x="320200" y="7096622"/>
            <a:ext cx="10152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actin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Textfeld 205"/>
          <p:cNvSpPr txBox="1"/>
          <p:nvPr/>
        </p:nvSpPr>
        <p:spPr>
          <a:xfrm>
            <a:off x="2662419" y="6915053"/>
            <a:ext cx="36420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207" name="Textfeld 206"/>
          <p:cNvSpPr txBox="1"/>
          <p:nvPr/>
        </p:nvSpPr>
        <p:spPr>
          <a:xfrm>
            <a:off x="2662419" y="7176438"/>
            <a:ext cx="364208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37</a:t>
            </a:r>
          </a:p>
        </p:txBody>
      </p:sp>
      <p:grpSp>
        <p:nvGrpSpPr>
          <p:cNvPr id="208" name="Gruppieren 207"/>
          <p:cNvGrpSpPr/>
          <p:nvPr/>
        </p:nvGrpSpPr>
        <p:grpSpPr>
          <a:xfrm>
            <a:off x="1781970" y="5775296"/>
            <a:ext cx="583223" cy="192218"/>
            <a:chOff x="1381447" y="1423286"/>
            <a:chExt cx="532899" cy="236578"/>
          </a:xfrm>
        </p:grpSpPr>
        <p:cxnSp>
          <p:nvCxnSpPr>
            <p:cNvPr id="209" name="Gerader Verbinder 208"/>
            <p:cNvCxnSpPr/>
            <p:nvPr/>
          </p:nvCxnSpPr>
          <p:spPr>
            <a:xfrm>
              <a:off x="1383033" y="1569864"/>
              <a:ext cx="531313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10" name="Gerader Verbinder 209"/>
            <p:cNvCxnSpPr/>
            <p:nvPr/>
          </p:nvCxnSpPr>
          <p:spPr>
            <a:xfrm>
              <a:off x="1914346" y="1569864"/>
              <a:ext cx="0" cy="9000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11" name="Gerader Verbinder 210"/>
            <p:cNvCxnSpPr/>
            <p:nvPr/>
          </p:nvCxnSpPr>
          <p:spPr>
            <a:xfrm>
              <a:off x="1381447" y="1569864"/>
              <a:ext cx="0" cy="9000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12" name="Textfeld 211"/>
            <p:cNvSpPr txBox="1"/>
            <p:nvPr/>
          </p:nvSpPr>
          <p:spPr>
            <a:xfrm>
              <a:off x="1462300" y="1423286"/>
              <a:ext cx="371193" cy="2272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</p:grpSp>
      <p:grpSp>
        <p:nvGrpSpPr>
          <p:cNvPr id="12" name="Gruppieren 11"/>
          <p:cNvGrpSpPr/>
          <p:nvPr/>
        </p:nvGrpSpPr>
        <p:grpSpPr>
          <a:xfrm>
            <a:off x="2010460" y="5621592"/>
            <a:ext cx="395483" cy="203847"/>
            <a:chOff x="5351836" y="5048657"/>
            <a:chExt cx="374355" cy="203847"/>
          </a:xfrm>
        </p:grpSpPr>
        <p:cxnSp>
          <p:nvCxnSpPr>
            <p:cNvPr id="213" name="Gerader Verbinder 212"/>
            <p:cNvCxnSpPr/>
            <p:nvPr/>
          </p:nvCxnSpPr>
          <p:spPr>
            <a:xfrm>
              <a:off x="5410365" y="5175583"/>
              <a:ext cx="2808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pSp>
          <p:nvGrpSpPr>
            <p:cNvPr id="214" name="Gruppieren 213"/>
            <p:cNvGrpSpPr/>
            <p:nvPr/>
          </p:nvGrpSpPr>
          <p:grpSpPr>
            <a:xfrm>
              <a:off x="5351836" y="5048657"/>
              <a:ext cx="374355" cy="203847"/>
              <a:chOff x="1584679" y="1188027"/>
              <a:chExt cx="371193" cy="250889"/>
            </a:xfrm>
          </p:grpSpPr>
          <p:cxnSp>
            <p:nvCxnSpPr>
              <p:cNvPr id="215" name="Gerader Verbinder 214"/>
              <p:cNvCxnSpPr/>
              <p:nvPr/>
            </p:nvCxnSpPr>
            <p:spPr>
              <a:xfrm>
                <a:off x="1914346" y="1348916"/>
                <a:ext cx="0" cy="9000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6" name="Gerader Verbinder 215"/>
              <p:cNvCxnSpPr/>
              <p:nvPr/>
            </p:nvCxnSpPr>
            <p:spPr>
              <a:xfrm>
                <a:off x="1646026" y="1348916"/>
                <a:ext cx="0" cy="9000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17" name="Textfeld 216"/>
              <p:cNvSpPr txBox="1"/>
              <p:nvPr/>
            </p:nvSpPr>
            <p:spPr>
              <a:xfrm>
                <a:off x="1584679" y="1188027"/>
                <a:ext cx="371193" cy="2272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</p:grpSp>
      <p:sp>
        <p:nvSpPr>
          <p:cNvPr id="218" name="Textfeld 217"/>
          <p:cNvSpPr txBox="1"/>
          <p:nvPr/>
        </p:nvSpPr>
        <p:spPr>
          <a:xfrm>
            <a:off x="1207245" y="5269521"/>
            <a:ext cx="140400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6h CD95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Textfeld 218"/>
          <p:cNvSpPr txBox="1"/>
          <p:nvPr/>
        </p:nvSpPr>
        <p:spPr>
          <a:xfrm>
            <a:off x="2674104" y="6746592"/>
            <a:ext cx="461812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0" name="Grafik 219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73" t="23113" r="7222" b="68723"/>
          <a:stretch/>
        </p:blipFill>
        <p:spPr>
          <a:xfrm>
            <a:off x="1283850" y="6846904"/>
            <a:ext cx="1440000" cy="28496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1" name="Grafik 220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71" t="26575" r="2726" b="64138"/>
          <a:stretch/>
        </p:blipFill>
        <p:spPr>
          <a:xfrm>
            <a:off x="1283850" y="7080227"/>
            <a:ext cx="1440000" cy="27042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2" name="Textfeld 221"/>
          <p:cNvSpPr txBox="1"/>
          <p:nvPr/>
        </p:nvSpPr>
        <p:spPr>
          <a:xfrm>
            <a:off x="143150" y="5206946"/>
            <a:ext cx="1742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65" name="Textfeld 164"/>
          <p:cNvSpPr txBox="1"/>
          <p:nvPr/>
        </p:nvSpPr>
        <p:spPr>
          <a:xfrm>
            <a:off x="574937" y="4616208"/>
            <a:ext cx="8248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procaspase-8a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feld 165"/>
          <p:cNvSpPr txBox="1"/>
          <p:nvPr/>
        </p:nvSpPr>
        <p:spPr>
          <a:xfrm>
            <a:off x="574937" y="4867673"/>
            <a:ext cx="82486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actin</a:t>
            </a:r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feld 183"/>
          <p:cNvSpPr txBox="1"/>
          <p:nvPr/>
        </p:nvSpPr>
        <p:spPr>
          <a:xfrm>
            <a:off x="1396090" y="3078142"/>
            <a:ext cx="89413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3h CD95L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5" name="Grafik 184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4413" r="31403" b="66248"/>
          <a:stretch/>
        </p:blipFill>
        <p:spPr>
          <a:xfrm>
            <a:off x="1345846" y="4634121"/>
            <a:ext cx="1080000" cy="2441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8" name="Textfeld 187"/>
          <p:cNvSpPr txBox="1"/>
          <p:nvPr/>
        </p:nvSpPr>
        <p:spPr>
          <a:xfrm>
            <a:off x="2394980" y="4717512"/>
            <a:ext cx="31712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</a:p>
        </p:txBody>
      </p:sp>
      <p:sp>
        <p:nvSpPr>
          <p:cNvPr id="190" name="Textfeld 189"/>
          <p:cNvSpPr txBox="1"/>
          <p:nvPr/>
        </p:nvSpPr>
        <p:spPr>
          <a:xfrm>
            <a:off x="2394980" y="4505690"/>
            <a:ext cx="404154" cy="1799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569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56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2" name="Gruppieren 191"/>
          <p:cNvGrpSpPr/>
          <p:nvPr/>
        </p:nvGrpSpPr>
        <p:grpSpPr>
          <a:xfrm>
            <a:off x="2054856" y="3306269"/>
            <a:ext cx="321247" cy="276999"/>
            <a:chOff x="2475071" y="4329049"/>
            <a:chExt cx="371193" cy="419598"/>
          </a:xfrm>
        </p:grpSpPr>
        <p:sp>
          <p:nvSpPr>
            <p:cNvPr id="193" name="Textfeld 192"/>
            <p:cNvSpPr txBox="1"/>
            <p:nvPr/>
          </p:nvSpPr>
          <p:spPr>
            <a:xfrm>
              <a:off x="2475071" y="4329049"/>
              <a:ext cx="371193" cy="4195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cxnSp>
          <p:nvCxnSpPr>
            <p:cNvPr id="194" name="Gerader Verbinder 193"/>
            <p:cNvCxnSpPr/>
            <p:nvPr/>
          </p:nvCxnSpPr>
          <p:spPr>
            <a:xfrm>
              <a:off x="2498371" y="4506081"/>
              <a:ext cx="323519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95" name="Gerader Verbinder 194"/>
            <p:cNvCxnSpPr/>
            <p:nvPr/>
          </p:nvCxnSpPr>
          <p:spPr>
            <a:xfrm>
              <a:off x="2820423" y="4506081"/>
              <a:ext cx="0" cy="9000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96" name="Gerader Verbinder 195"/>
            <p:cNvCxnSpPr/>
            <p:nvPr/>
          </p:nvCxnSpPr>
          <p:spPr>
            <a:xfrm>
              <a:off x="2498371" y="4506081"/>
              <a:ext cx="0" cy="9000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97" name="Gruppieren 196"/>
          <p:cNvGrpSpPr/>
          <p:nvPr/>
        </p:nvGrpSpPr>
        <p:grpSpPr>
          <a:xfrm>
            <a:off x="1808881" y="3447579"/>
            <a:ext cx="545072" cy="184666"/>
            <a:chOff x="5127331" y="4101141"/>
            <a:chExt cx="636815" cy="279732"/>
          </a:xfrm>
        </p:grpSpPr>
        <p:cxnSp>
          <p:nvCxnSpPr>
            <p:cNvPr id="198" name="Gerader Verbinder 197"/>
            <p:cNvCxnSpPr/>
            <p:nvPr/>
          </p:nvCxnSpPr>
          <p:spPr>
            <a:xfrm>
              <a:off x="5132706" y="4250769"/>
              <a:ext cx="63144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99" name="Gerader Verbinder 198"/>
            <p:cNvCxnSpPr/>
            <p:nvPr/>
          </p:nvCxnSpPr>
          <p:spPr>
            <a:xfrm>
              <a:off x="5764146" y="4250769"/>
              <a:ext cx="0" cy="9000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200" name="Gerader Verbinder 199"/>
            <p:cNvCxnSpPr/>
            <p:nvPr/>
          </p:nvCxnSpPr>
          <p:spPr>
            <a:xfrm>
              <a:off x="5132706" y="4250769"/>
              <a:ext cx="0" cy="9000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201" name="Textfeld 200"/>
            <p:cNvSpPr txBox="1"/>
            <p:nvPr/>
          </p:nvSpPr>
          <p:spPr>
            <a:xfrm>
              <a:off x="5127331" y="4101141"/>
              <a:ext cx="636815" cy="2797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  <a:endParaRPr lang="en-GB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223" name="Grafik 222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431" r="32247" b="55325"/>
          <a:stretch/>
        </p:blipFill>
        <p:spPr>
          <a:xfrm>
            <a:off x="1346361" y="4889499"/>
            <a:ext cx="1080000" cy="21556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4" name="Textfeld 223"/>
          <p:cNvSpPr txBox="1"/>
          <p:nvPr/>
        </p:nvSpPr>
        <p:spPr>
          <a:xfrm>
            <a:off x="2394980" y="4963971"/>
            <a:ext cx="31712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-37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0" name="Gruppieren 149"/>
          <p:cNvGrpSpPr/>
          <p:nvPr/>
        </p:nvGrpSpPr>
        <p:grpSpPr>
          <a:xfrm>
            <a:off x="3315113" y="3831152"/>
            <a:ext cx="3178892" cy="2005930"/>
            <a:chOff x="-254560" y="3688598"/>
            <a:chExt cx="3178892" cy="2005930"/>
          </a:xfrm>
        </p:grpSpPr>
        <p:graphicFrame>
          <p:nvGraphicFramePr>
            <p:cNvPr id="151" name="Diagramm 15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66737494"/>
                </p:ext>
              </p:extLst>
            </p:nvPr>
          </p:nvGraphicFramePr>
          <p:xfrm>
            <a:off x="404332" y="3688598"/>
            <a:ext cx="252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grpSp>
          <p:nvGrpSpPr>
            <p:cNvPr id="152" name="Gruppieren 151"/>
            <p:cNvGrpSpPr/>
            <p:nvPr/>
          </p:nvGrpSpPr>
          <p:grpSpPr>
            <a:xfrm>
              <a:off x="-254560" y="5353705"/>
              <a:ext cx="3161809" cy="340823"/>
              <a:chOff x="-254560" y="5380285"/>
              <a:chExt cx="3161809" cy="340823"/>
            </a:xfrm>
          </p:grpSpPr>
          <p:sp>
            <p:nvSpPr>
              <p:cNvPr id="153" name="Textfeld 152"/>
              <p:cNvSpPr txBox="1"/>
              <p:nvPr/>
            </p:nvSpPr>
            <p:spPr>
              <a:xfrm>
                <a:off x="-254560" y="5536442"/>
                <a:ext cx="1008944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h CD95L [500 ng/ml]</a:t>
                </a:r>
                <a:endParaRPr lang="en-GB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4" name="Gerade Verbindung 14"/>
              <p:cNvCxnSpPr/>
              <p:nvPr/>
            </p:nvCxnSpPr>
            <p:spPr>
              <a:xfrm flipH="1">
                <a:off x="759817" y="5535481"/>
                <a:ext cx="396000" cy="1182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55" name="Textfeld 154"/>
              <p:cNvSpPr txBox="1"/>
              <p:nvPr/>
            </p:nvSpPr>
            <p:spPr>
              <a:xfrm>
                <a:off x="780150" y="5536442"/>
                <a:ext cx="13319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56" name="Textfeld 155"/>
              <p:cNvSpPr txBox="1"/>
              <p:nvPr/>
            </p:nvSpPr>
            <p:spPr>
              <a:xfrm>
                <a:off x="950877" y="5536442"/>
                <a:ext cx="24239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57" name="Textfeld 156"/>
              <p:cNvSpPr txBox="1"/>
              <p:nvPr/>
            </p:nvSpPr>
            <p:spPr>
              <a:xfrm>
                <a:off x="1151025" y="5536442"/>
                <a:ext cx="26621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58" name="Textfeld 157"/>
              <p:cNvSpPr txBox="1"/>
              <p:nvPr/>
            </p:nvSpPr>
            <p:spPr>
              <a:xfrm>
                <a:off x="1376365" y="5536442"/>
                <a:ext cx="24239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59" name="Textfeld 158"/>
              <p:cNvSpPr txBox="1"/>
              <p:nvPr/>
            </p:nvSpPr>
            <p:spPr>
              <a:xfrm>
                <a:off x="1571353" y="5536442"/>
                <a:ext cx="26621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60" name="Textfeld 159"/>
              <p:cNvSpPr txBox="1"/>
              <p:nvPr/>
            </p:nvSpPr>
            <p:spPr>
              <a:xfrm>
                <a:off x="1795962" y="5536442"/>
                <a:ext cx="24239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61" name="Textfeld 160"/>
              <p:cNvSpPr txBox="1"/>
              <p:nvPr/>
            </p:nvSpPr>
            <p:spPr>
              <a:xfrm>
                <a:off x="2011840" y="5536442"/>
                <a:ext cx="26621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162" name="Textfeld 161"/>
              <p:cNvSpPr txBox="1"/>
              <p:nvPr/>
            </p:nvSpPr>
            <p:spPr>
              <a:xfrm>
                <a:off x="2228165" y="5536442"/>
                <a:ext cx="24239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163" name="Textfeld 162"/>
              <p:cNvSpPr txBox="1"/>
              <p:nvPr/>
            </p:nvSpPr>
            <p:spPr>
              <a:xfrm>
                <a:off x="698089" y="5380285"/>
                <a:ext cx="45979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vector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Textfeld 163"/>
              <p:cNvSpPr txBox="1"/>
              <p:nvPr/>
            </p:nvSpPr>
            <p:spPr>
              <a:xfrm>
                <a:off x="1145603" y="5380285"/>
                <a:ext cx="49827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R233H</a:t>
                </a:r>
              </a:p>
            </p:txBody>
          </p:sp>
          <p:sp>
            <p:nvSpPr>
              <p:cNvPr id="167" name="Textfeld 166"/>
              <p:cNvSpPr txBox="1"/>
              <p:nvPr/>
            </p:nvSpPr>
            <p:spPr>
              <a:xfrm>
                <a:off x="1598019" y="5380285"/>
                <a:ext cx="42794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R435Q</a:t>
                </a:r>
              </a:p>
            </p:txBody>
          </p:sp>
          <p:sp>
            <p:nvSpPr>
              <p:cNvPr id="175" name="Textfeld 174"/>
              <p:cNvSpPr txBox="1"/>
              <p:nvPr/>
            </p:nvSpPr>
            <p:spPr>
              <a:xfrm>
                <a:off x="2481291" y="5380285"/>
                <a:ext cx="38266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</a:p>
            </p:txBody>
          </p:sp>
          <p:sp>
            <p:nvSpPr>
              <p:cNvPr id="189" name="Textfeld 188"/>
              <p:cNvSpPr txBox="1"/>
              <p:nvPr/>
            </p:nvSpPr>
            <p:spPr>
              <a:xfrm>
                <a:off x="634126" y="5381096"/>
                <a:ext cx="17426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endParaRPr lang="en-GB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1" name="Textfeld 190"/>
              <p:cNvSpPr txBox="1"/>
              <p:nvPr/>
            </p:nvSpPr>
            <p:spPr>
              <a:xfrm>
                <a:off x="2437943" y="5536442"/>
                <a:ext cx="26621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03" name="Textfeld 202"/>
              <p:cNvSpPr txBox="1"/>
              <p:nvPr/>
            </p:nvSpPr>
            <p:spPr>
              <a:xfrm>
                <a:off x="2664857" y="5536442"/>
                <a:ext cx="24239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cxnSp>
            <p:nvCxnSpPr>
              <p:cNvPr id="228" name="Gerade Verbindung 14"/>
              <p:cNvCxnSpPr/>
              <p:nvPr/>
            </p:nvCxnSpPr>
            <p:spPr>
              <a:xfrm flipH="1">
                <a:off x="1197350" y="5535481"/>
                <a:ext cx="396000" cy="1182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9" name="Gerade Verbindung 14"/>
              <p:cNvCxnSpPr/>
              <p:nvPr/>
            </p:nvCxnSpPr>
            <p:spPr>
              <a:xfrm flipH="1">
                <a:off x="1620536" y="5535481"/>
                <a:ext cx="396000" cy="1182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0" name="Gerade Verbindung 14"/>
              <p:cNvCxnSpPr/>
              <p:nvPr/>
            </p:nvCxnSpPr>
            <p:spPr>
              <a:xfrm flipH="1">
                <a:off x="2044568" y="5535481"/>
                <a:ext cx="396000" cy="1182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1" name="Gerade Verbindung 14"/>
              <p:cNvCxnSpPr/>
              <p:nvPr/>
            </p:nvCxnSpPr>
            <p:spPr>
              <a:xfrm flipH="1">
                <a:off x="2472063" y="5535481"/>
                <a:ext cx="396000" cy="1182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32" name="Textfeld 231"/>
              <p:cNvSpPr txBox="1"/>
              <p:nvPr/>
            </p:nvSpPr>
            <p:spPr>
              <a:xfrm>
                <a:off x="2049888" y="5380285"/>
                <a:ext cx="38025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</p:grpSp>
      </p:grpSp>
      <p:grpSp>
        <p:nvGrpSpPr>
          <p:cNvPr id="233" name="Gruppieren 232"/>
          <p:cNvGrpSpPr/>
          <p:nvPr/>
        </p:nvGrpSpPr>
        <p:grpSpPr>
          <a:xfrm>
            <a:off x="3326995" y="5843939"/>
            <a:ext cx="3175087" cy="2005930"/>
            <a:chOff x="2910217" y="3688598"/>
            <a:chExt cx="3175087" cy="2005930"/>
          </a:xfrm>
        </p:grpSpPr>
        <p:graphicFrame>
          <p:nvGraphicFramePr>
            <p:cNvPr id="234" name="Diagramm 23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33795967"/>
                </p:ext>
              </p:extLst>
            </p:nvPr>
          </p:nvGraphicFramePr>
          <p:xfrm>
            <a:off x="3536812" y="3688598"/>
            <a:ext cx="252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4"/>
            </a:graphicData>
          </a:graphic>
        </p:graphicFrame>
        <p:grpSp>
          <p:nvGrpSpPr>
            <p:cNvPr id="235" name="Gruppieren 234"/>
            <p:cNvGrpSpPr/>
            <p:nvPr/>
          </p:nvGrpSpPr>
          <p:grpSpPr>
            <a:xfrm>
              <a:off x="2910217" y="5353705"/>
              <a:ext cx="3175087" cy="340823"/>
              <a:chOff x="2910217" y="5316461"/>
              <a:chExt cx="3175087" cy="340823"/>
            </a:xfrm>
          </p:grpSpPr>
          <p:sp>
            <p:nvSpPr>
              <p:cNvPr id="236" name="Textfeld 235"/>
              <p:cNvSpPr txBox="1"/>
              <p:nvPr/>
            </p:nvSpPr>
            <p:spPr>
              <a:xfrm>
                <a:off x="2910217" y="5472618"/>
                <a:ext cx="1022221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h CD95L [500 ng/ml]</a:t>
                </a:r>
              </a:p>
            </p:txBody>
          </p:sp>
          <p:cxnSp>
            <p:nvCxnSpPr>
              <p:cNvPr id="237" name="Gerade Verbindung 14"/>
              <p:cNvCxnSpPr/>
              <p:nvPr/>
            </p:nvCxnSpPr>
            <p:spPr>
              <a:xfrm flipH="1">
                <a:off x="3937872" y="5471657"/>
                <a:ext cx="396000" cy="1182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38" name="Textfeld 237"/>
              <p:cNvSpPr txBox="1"/>
              <p:nvPr/>
            </p:nvSpPr>
            <p:spPr>
              <a:xfrm>
                <a:off x="3958205" y="5472618"/>
                <a:ext cx="13319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39" name="Textfeld 238"/>
              <p:cNvSpPr txBox="1"/>
              <p:nvPr/>
            </p:nvSpPr>
            <p:spPr>
              <a:xfrm>
                <a:off x="4128932" y="5472618"/>
                <a:ext cx="24239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40" name="Textfeld 239"/>
              <p:cNvSpPr txBox="1"/>
              <p:nvPr/>
            </p:nvSpPr>
            <p:spPr>
              <a:xfrm>
                <a:off x="4329080" y="5472618"/>
                <a:ext cx="26621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41" name="Textfeld 240"/>
              <p:cNvSpPr txBox="1"/>
              <p:nvPr/>
            </p:nvSpPr>
            <p:spPr>
              <a:xfrm>
                <a:off x="4554420" y="5472618"/>
                <a:ext cx="24239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42" name="Textfeld 241"/>
              <p:cNvSpPr txBox="1"/>
              <p:nvPr/>
            </p:nvSpPr>
            <p:spPr>
              <a:xfrm>
                <a:off x="4749408" y="5472618"/>
                <a:ext cx="26621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43" name="Textfeld 242"/>
              <p:cNvSpPr txBox="1"/>
              <p:nvPr/>
            </p:nvSpPr>
            <p:spPr>
              <a:xfrm>
                <a:off x="4974017" y="5472618"/>
                <a:ext cx="24239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44" name="Textfeld 243"/>
              <p:cNvSpPr txBox="1"/>
              <p:nvPr/>
            </p:nvSpPr>
            <p:spPr>
              <a:xfrm>
                <a:off x="5189895" y="5472618"/>
                <a:ext cx="26621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45" name="Textfeld 244"/>
              <p:cNvSpPr txBox="1"/>
              <p:nvPr/>
            </p:nvSpPr>
            <p:spPr>
              <a:xfrm>
                <a:off x="5406220" y="5472618"/>
                <a:ext cx="24239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sp>
            <p:nvSpPr>
              <p:cNvPr id="246" name="Textfeld 245"/>
              <p:cNvSpPr txBox="1"/>
              <p:nvPr/>
            </p:nvSpPr>
            <p:spPr>
              <a:xfrm>
                <a:off x="3876144" y="5316461"/>
                <a:ext cx="45979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vector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7" name="Textfeld 246"/>
              <p:cNvSpPr txBox="1"/>
              <p:nvPr/>
            </p:nvSpPr>
            <p:spPr>
              <a:xfrm>
                <a:off x="4323658" y="5316461"/>
                <a:ext cx="49827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R233H</a:t>
                </a:r>
              </a:p>
            </p:txBody>
          </p:sp>
          <p:sp>
            <p:nvSpPr>
              <p:cNvPr id="248" name="Textfeld 247"/>
              <p:cNvSpPr txBox="1"/>
              <p:nvPr/>
            </p:nvSpPr>
            <p:spPr>
              <a:xfrm>
                <a:off x="4776074" y="5316461"/>
                <a:ext cx="42794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R435Q</a:t>
                </a:r>
              </a:p>
            </p:txBody>
          </p:sp>
          <p:sp>
            <p:nvSpPr>
              <p:cNvPr id="249" name="Textfeld 248"/>
              <p:cNvSpPr txBox="1"/>
              <p:nvPr/>
            </p:nvSpPr>
            <p:spPr>
              <a:xfrm>
                <a:off x="5659346" y="5316461"/>
                <a:ext cx="38266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KO</a:t>
                </a:r>
              </a:p>
            </p:txBody>
          </p:sp>
          <p:sp>
            <p:nvSpPr>
              <p:cNvPr id="250" name="Textfeld 249"/>
              <p:cNvSpPr txBox="1"/>
              <p:nvPr/>
            </p:nvSpPr>
            <p:spPr>
              <a:xfrm>
                <a:off x="3812181" y="5317272"/>
                <a:ext cx="17426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endParaRPr lang="en-GB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" name="Textfeld 250"/>
              <p:cNvSpPr txBox="1"/>
              <p:nvPr/>
            </p:nvSpPr>
            <p:spPr>
              <a:xfrm>
                <a:off x="5615998" y="5472618"/>
                <a:ext cx="26621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</a:p>
            </p:txBody>
          </p:sp>
          <p:sp>
            <p:nvSpPr>
              <p:cNvPr id="252" name="Textfeld 251"/>
              <p:cNvSpPr txBox="1"/>
              <p:nvPr/>
            </p:nvSpPr>
            <p:spPr>
              <a:xfrm>
                <a:off x="5842912" y="5472618"/>
                <a:ext cx="24239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</a:p>
            </p:txBody>
          </p:sp>
          <p:cxnSp>
            <p:nvCxnSpPr>
              <p:cNvPr id="253" name="Gerade Verbindung 14"/>
              <p:cNvCxnSpPr/>
              <p:nvPr/>
            </p:nvCxnSpPr>
            <p:spPr>
              <a:xfrm flipH="1">
                <a:off x="4375405" y="5471657"/>
                <a:ext cx="396000" cy="1182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4" name="Gerade Verbindung 14"/>
              <p:cNvCxnSpPr/>
              <p:nvPr/>
            </p:nvCxnSpPr>
            <p:spPr>
              <a:xfrm flipH="1">
                <a:off x="4798591" y="5471657"/>
                <a:ext cx="396000" cy="1182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5" name="Gerade Verbindung 14"/>
              <p:cNvCxnSpPr/>
              <p:nvPr/>
            </p:nvCxnSpPr>
            <p:spPr>
              <a:xfrm flipH="1">
                <a:off x="5222623" y="5471657"/>
                <a:ext cx="396000" cy="1182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56" name="Gerade Verbindung 14"/>
              <p:cNvCxnSpPr/>
              <p:nvPr/>
            </p:nvCxnSpPr>
            <p:spPr>
              <a:xfrm flipH="1">
                <a:off x="5650118" y="5471657"/>
                <a:ext cx="396000" cy="1182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57" name="Textfeld 256"/>
              <p:cNvSpPr txBox="1"/>
              <p:nvPr/>
            </p:nvSpPr>
            <p:spPr>
              <a:xfrm>
                <a:off x="5227943" y="5316461"/>
                <a:ext cx="38025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</p:grpSp>
      </p:grpSp>
      <p:pic>
        <p:nvPicPr>
          <p:cNvPr id="258" name="Grafik 257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00" t="32667" r="1338" b="14231"/>
          <a:stretch/>
        </p:blipFill>
        <p:spPr>
          <a:xfrm>
            <a:off x="4324960" y="1398874"/>
            <a:ext cx="1620000" cy="91708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9" name="Grafik 258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02" t="39902" b="22379"/>
          <a:stretch/>
        </p:blipFill>
        <p:spPr>
          <a:xfrm>
            <a:off x="4324960" y="2318436"/>
            <a:ext cx="1620000" cy="62712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0" name="Grafik 259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05" t="10924" r="1148" b="62379"/>
          <a:stretch/>
        </p:blipFill>
        <p:spPr>
          <a:xfrm>
            <a:off x="4324960" y="2948909"/>
            <a:ext cx="1620000" cy="4153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1" name="Grafik 260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76" t="36308" b="53803"/>
          <a:stretch/>
        </p:blipFill>
        <p:spPr>
          <a:xfrm>
            <a:off x="4324960" y="3371091"/>
            <a:ext cx="1620000" cy="18607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2" name="Textfeld 261"/>
          <p:cNvSpPr txBox="1"/>
          <p:nvPr/>
        </p:nvSpPr>
        <p:spPr>
          <a:xfrm>
            <a:off x="3364207" y="3353875"/>
            <a:ext cx="10152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*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65399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642938" y="-38615"/>
            <a:ext cx="1387569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63" dirty="0" smtClean="0">
                <a:latin typeface="Arial" panose="020B0604020202020204" pitchFamily="34" charset="0"/>
                <a:cs typeface="Arial" panose="020B0604020202020204" pitchFamily="34" charset="0"/>
              </a:rPr>
              <a:t>Fig.5 </a:t>
            </a:r>
            <a:endParaRPr lang="en-GB" sz="146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uppieren 1"/>
          <p:cNvGrpSpPr/>
          <p:nvPr/>
        </p:nvGrpSpPr>
        <p:grpSpPr>
          <a:xfrm>
            <a:off x="814226" y="494269"/>
            <a:ext cx="3512566" cy="2225612"/>
            <a:chOff x="-5610" y="4657909"/>
            <a:chExt cx="4323159" cy="2739215"/>
          </a:xfrm>
        </p:grpSpPr>
        <p:pic>
          <p:nvPicPr>
            <p:cNvPr id="50" name="Picture 2" descr="G:\AG_Lavrik\Fabian\Experimente\V20191029 Casp.8-Den.-IP with SKW cells and CD95 treatment\1.mme.r\Wohlfromm, Fabian 2019-11-05 10hr 09min_Exposure_3.0sec+marker.ti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31" t="17350" b="48816"/>
            <a:stretch/>
          </p:blipFill>
          <p:spPr bwMode="auto">
            <a:xfrm>
              <a:off x="1265404" y="5242726"/>
              <a:ext cx="2700000" cy="69952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1" name="Picture 3" descr="G:\AG_Lavrik\Fabian\Experimente\V20191029 Casp.8-Den.-IP with SKW cells and CD95 treatment\1.mme.r\Wohlfromm, Fabian 2019-11-05 10hr 11min_Exposure_19.8sec+marker.ti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122" r="241" b="47301"/>
            <a:stretch/>
          </p:blipFill>
          <p:spPr bwMode="auto">
            <a:xfrm>
              <a:off x="1265404" y="5942251"/>
              <a:ext cx="2700000" cy="79882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2" name="Grafik 51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0364" b="69765"/>
            <a:stretch/>
          </p:blipFill>
          <p:spPr>
            <a:xfrm>
              <a:off x="1265404" y="7184857"/>
              <a:ext cx="2700000" cy="18722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3" name="Grafik 52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4696" r="1867" b="41957"/>
            <a:stretch/>
          </p:blipFill>
          <p:spPr>
            <a:xfrm>
              <a:off x="1265404" y="6933916"/>
              <a:ext cx="2700000" cy="23921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4" name="Textfeld 53"/>
            <p:cNvSpPr txBox="1"/>
            <p:nvPr/>
          </p:nvSpPr>
          <p:spPr>
            <a:xfrm>
              <a:off x="1666480" y="4657909"/>
              <a:ext cx="1809499" cy="22728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166 </a:t>
              </a:r>
              <a:r>
                <a:rPr lang="de-DE" sz="6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ng</a:t>
              </a:r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/ml CD95L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feld 54"/>
            <p:cNvSpPr txBox="1"/>
            <p:nvPr/>
          </p:nvSpPr>
          <p:spPr>
            <a:xfrm>
              <a:off x="17432" y="5506817"/>
              <a:ext cx="1249497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nti-MMA WB (</a:t>
              </a:r>
              <a:r>
                <a:rPr lang="de-DE" sz="6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s.e</a:t>
              </a:r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.)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feld 55"/>
            <p:cNvSpPr txBox="1"/>
            <p:nvPr/>
          </p:nvSpPr>
          <p:spPr>
            <a:xfrm>
              <a:off x="1237703" y="4837296"/>
              <a:ext cx="533781" cy="22728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Input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feld 56"/>
            <p:cNvSpPr txBox="1"/>
            <p:nvPr/>
          </p:nvSpPr>
          <p:spPr>
            <a:xfrm>
              <a:off x="1619706" y="4837296"/>
              <a:ext cx="1041828" cy="22728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caspase-8-co-IP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8" name="Gerade Verbindung 14"/>
            <p:cNvCxnSpPr/>
            <p:nvPr/>
          </p:nvCxnSpPr>
          <p:spPr>
            <a:xfrm flipH="1">
              <a:off x="1273911" y="5047069"/>
              <a:ext cx="5040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59" name="Textfeld 58"/>
            <p:cNvSpPr txBox="1"/>
            <p:nvPr/>
          </p:nvSpPr>
          <p:spPr>
            <a:xfrm>
              <a:off x="1301983" y="5052334"/>
              <a:ext cx="163927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0" name="Textfeld 59"/>
            <p:cNvSpPr txBox="1"/>
            <p:nvPr/>
          </p:nvSpPr>
          <p:spPr>
            <a:xfrm>
              <a:off x="1333710" y="5052334"/>
              <a:ext cx="354812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61" name="Textfeld 60"/>
            <p:cNvSpPr txBox="1"/>
            <p:nvPr/>
          </p:nvSpPr>
          <p:spPr>
            <a:xfrm>
              <a:off x="2301891" y="5052334"/>
              <a:ext cx="298329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62" name="Textfeld 61"/>
            <p:cNvSpPr txBox="1"/>
            <p:nvPr/>
          </p:nvSpPr>
          <p:spPr>
            <a:xfrm>
              <a:off x="1562073" y="5052334"/>
              <a:ext cx="347615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63" name="Textfeld 62"/>
            <p:cNvSpPr txBox="1"/>
            <p:nvPr/>
          </p:nvSpPr>
          <p:spPr>
            <a:xfrm>
              <a:off x="221367" y="5052334"/>
              <a:ext cx="1071135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[min]</a:t>
              </a:r>
            </a:p>
          </p:txBody>
        </p:sp>
        <p:pic>
          <p:nvPicPr>
            <p:cNvPr id="64" name="Grafik 63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8" t="19166" b="69583"/>
            <a:stretch/>
          </p:blipFill>
          <p:spPr>
            <a:xfrm>
              <a:off x="1265404" y="6710262"/>
              <a:ext cx="2700000" cy="22002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5" name="Textfeld 64"/>
            <p:cNvSpPr txBox="1"/>
            <p:nvPr/>
          </p:nvSpPr>
          <p:spPr>
            <a:xfrm>
              <a:off x="1817557" y="5052334"/>
              <a:ext cx="170958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6" name="Textfeld 65"/>
            <p:cNvSpPr txBox="1"/>
            <p:nvPr/>
          </p:nvSpPr>
          <p:spPr>
            <a:xfrm>
              <a:off x="1883007" y="5052334"/>
              <a:ext cx="371753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67" name="Textfeld 66"/>
            <p:cNvSpPr txBox="1"/>
            <p:nvPr/>
          </p:nvSpPr>
          <p:spPr>
            <a:xfrm>
              <a:off x="2079885" y="5052334"/>
              <a:ext cx="357391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68" name="Textfeld 67"/>
            <p:cNvSpPr txBox="1"/>
            <p:nvPr/>
          </p:nvSpPr>
          <p:spPr>
            <a:xfrm>
              <a:off x="2474431" y="5052334"/>
              <a:ext cx="298329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cxnSp>
          <p:nvCxnSpPr>
            <p:cNvPr id="69" name="Gerade Verbindung 14"/>
            <p:cNvCxnSpPr/>
            <p:nvPr/>
          </p:nvCxnSpPr>
          <p:spPr>
            <a:xfrm flipH="1">
              <a:off x="1845575" y="5047069"/>
              <a:ext cx="6480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70" name="Gerade Verbindung 14"/>
            <p:cNvCxnSpPr/>
            <p:nvPr/>
          </p:nvCxnSpPr>
          <p:spPr>
            <a:xfrm flipH="1">
              <a:off x="2699755" y="5054858"/>
              <a:ext cx="5040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71" name="Textfeld 70"/>
            <p:cNvSpPr txBox="1"/>
            <p:nvPr/>
          </p:nvSpPr>
          <p:spPr>
            <a:xfrm>
              <a:off x="2727827" y="5060123"/>
              <a:ext cx="163927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2" name="Textfeld 71"/>
            <p:cNvSpPr txBox="1"/>
            <p:nvPr/>
          </p:nvSpPr>
          <p:spPr>
            <a:xfrm>
              <a:off x="2793279" y="5060123"/>
              <a:ext cx="351696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73" name="Textfeld 72"/>
            <p:cNvSpPr txBox="1"/>
            <p:nvPr/>
          </p:nvSpPr>
          <p:spPr>
            <a:xfrm>
              <a:off x="3727733" y="5060123"/>
              <a:ext cx="298329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74" name="Textfeld 73"/>
            <p:cNvSpPr txBox="1"/>
            <p:nvPr/>
          </p:nvSpPr>
          <p:spPr>
            <a:xfrm>
              <a:off x="2990180" y="5060123"/>
              <a:ext cx="349351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75" name="Textfeld 74"/>
            <p:cNvSpPr txBox="1"/>
            <p:nvPr/>
          </p:nvSpPr>
          <p:spPr>
            <a:xfrm>
              <a:off x="3243401" y="5060123"/>
              <a:ext cx="170958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6" name="Textfeld 75"/>
            <p:cNvSpPr txBox="1"/>
            <p:nvPr/>
          </p:nvSpPr>
          <p:spPr>
            <a:xfrm>
              <a:off x="3302180" y="5060123"/>
              <a:ext cx="373079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77" name="Textfeld 76"/>
            <p:cNvSpPr txBox="1"/>
            <p:nvPr/>
          </p:nvSpPr>
          <p:spPr>
            <a:xfrm>
              <a:off x="3502732" y="5060123"/>
              <a:ext cx="358380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cxnSp>
          <p:nvCxnSpPr>
            <p:cNvPr id="78" name="Gerade Verbindung 14"/>
            <p:cNvCxnSpPr/>
            <p:nvPr/>
          </p:nvCxnSpPr>
          <p:spPr>
            <a:xfrm flipH="1">
              <a:off x="3271419" y="5054858"/>
              <a:ext cx="648000" cy="0"/>
            </a:xfrm>
            <a:prstGeom prst="line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79" name="Textfeld 78"/>
            <p:cNvSpPr txBox="1"/>
            <p:nvPr/>
          </p:nvSpPr>
          <p:spPr>
            <a:xfrm>
              <a:off x="2668411" y="4846308"/>
              <a:ext cx="533781" cy="22728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Input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feld 79"/>
            <p:cNvSpPr txBox="1"/>
            <p:nvPr/>
          </p:nvSpPr>
          <p:spPr>
            <a:xfrm>
              <a:off x="3120128" y="4812187"/>
              <a:ext cx="972115" cy="227281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Den-C8-IP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feld 80"/>
            <p:cNvSpPr txBox="1"/>
            <p:nvPr/>
          </p:nvSpPr>
          <p:spPr>
            <a:xfrm>
              <a:off x="3895955" y="5198078"/>
              <a:ext cx="408302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75</a:t>
              </a:r>
            </a:p>
          </p:txBody>
        </p:sp>
        <p:sp>
          <p:nvSpPr>
            <p:cNvPr id="82" name="Textfeld 81"/>
            <p:cNvSpPr txBox="1"/>
            <p:nvPr/>
          </p:nvSpPr>
          <p:spPr>
            <a:xfrm>
              <a:off x="3895956" y="5095330"/>
              <a:ext cx="421593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feld 82"/>
            <p:cNvSpPr txBox="1"/>
            <p:nvPr/>
          </p:nvSpPr>
          <p:spPr>
            <a:xfrm>
              <a:off x="3895955" y="5378558"/>
              <a:ext cx="421591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</a:p>
          </p:txBody>
        </p:sp>
        <p:sp>
          <p:nvSpPr>
            <p:cNvPr id="84" name="Textfeld 83"/>
            <p:cNvSpPr txBox="1"/>
            <p:nvPr/>
          </p:nvSpPr>
          <p:spPr>
            <a:xfrm>
              <a:off x="3912242" y="5563449"/>
              <a:ext cx="405306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</a:p>
          </p:txBody>
        </p:sp>
        <p:sp>
          <p:nvSpPr>
            <p:cNvPr id="85" name="Textfeld 84"/>
            <p:cNvSpPr txBox="1"/>
            <p:nvPr/>
          </p:nvSpPr>
          <p:spPr>
            <a:xfrm>
              <a:off x="-5610" y="6060666"/>
              <a:ext cx="1249497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nti-MMA WB (</a:t>
              </a:r>
              <a:r>
                <a:rPr lang="de-DE" sz="6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l.e</a:t>
              </a:r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.)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feld 85"/>
            <p:cNvSpPr txBox="1"/>
            <p:nvPr/>
          </p:nvSpPr>
          <p:spPr>
            <a:xfrm>
              <a:off x="3895956" y="5876428"/>
              <a:ext cx="408300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75</a:t>
              </a:r>
            </a:p>
          </p:txBody>
        </p:sp>
        <p:sp>
          <p:nvSpPr>
            <p:cNvPr id="87" name="Textfeld 86"/>
            <p:cNvSpPr txBox="1"/>
            <p:nvPr/>
          </p:nvSpPr>
          <p:spPr>
            <a:xfrm>
              <a:off x="3895956" y="6037856"/>
              <a:ext cx="408300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</a:p>
          </p:txBody>
        </p:sp>
        <p:sp>
          <p:nvSpPr>
            <p:cNvPr id="88" name="Textfeld 87"/>
            <p:cNvSpPr txBox="1"/>
            <p:nvPr/>
          </p:nvSpPr>
          <p:spPr>
            <a:xfrm>
              <a:off x="3895956" y="6244797"/>
              <a:ext cx="421590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37</a:t>
              </a:r>
            </a:p>
          </p:txBody>
        </p:sp>
        <p:sp>
          <p:nvSpPr>
            <p:cNvPr id="89" name="Textfeld 88"/>
            <p:cNvSpPr txBox="1"/>
            <p:nvPr/>
          </p:nvSpPr>
          <p:spPr>
            <a:xfrm>
              <a:off x="3895956" y="6771592"/>
              <a:ext cx="408300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</a:p>
          </p:txBody>
        </p:sp>
        <p:sp>
          <p:nvSpPr>
            <p:cNvPr id="90" name="Textfeld 89"/>
            <p:cNvSpPr txBox="1"/>
            <p:nvPr/>
          </p:nvSpPr>
          <p:spPr>
            <a:xfrm>
              <a:off x="4070" y="6705589"/>
              <a:ext cx="1249497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procaspase-8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feld 90"/>
            <p:cNvSpPr txBox="1"/>
            <p:nvPr/>
          </p:nvSpPr>
          <p:spPr>
            <a:xfrm>
              <a:off x="3895956" y="6958486"/>
              <a:ext cx="421590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25</a:t>
              </a:r>
            </a:p>
          </p:txBody>
        </p:sp>
        <p:sp>
          <p:nvSpPr>
            <p:cNvPr id="92" name="Textfeld 91"/>
            <p:cNvSpPr txBox="1"/>
            <p:nvPr/>
          </p:nvSpPr>
          <p:spPr>
            <a:xfrm>
              <a:off x="-1164" y="6903050"/>
              <a:ext cx="1249497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FADD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feld 92"/>
            <p:cNvSpPr txBox="1"/>
            <p:nvPr/>
          </p:nvSpPr>
          <p:spPr>
            <a:xfrm>
              <a:off x="-1164" y="7169843"/>
              <a:ext cx="1249497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 err="1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actin</a:t>
              </a:r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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feld 93"/>
            <p:cNvSpPr txBox="1"/>
            <p:nvPr/>
          </p:nvSpPr>
          <p:spPr>
            <a:xfrm>
              <a:off x="3895956" y="7122158"/>
              <a:ext cx="408300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</a:rPr>
                <a:t>-50</a:t>
              </a:r>
            </a:p>
          </p:txBody>
        </p:sp>
      </p:grpSp>
      <p:grpSp>
        <p:nvGrpSpPr>
          <p:cNvPr id="225" name="Gruppieren 224"/>
          <p:cNvGrpSpPr/>
          <p:nvPr/>
        </p:nvGrpSpPr>
        <p:grpSpPr>
          <a:xfrm>
            <a:off x="1136721" y="3383874"/>
            <a:ext cx="2573589" cy="2841051"/>
            <a:chOff x="306568" y="538361"/>
            <a:chExt cx="3167492" cy="3496676"/>
          </a:xfrm>
        </p:grpSpPr>
        <p:grpSp>
          <p:nvGrpSpPr>
            <p:cNvPr id="3" name="Gruppieren 2"/>
            <p:cNvGrpSpPr/>
            <p:nvPr/>
          </p:nvGrpSpPr>
          <p:grpSpPr>
            <a:xfrm>
              <a:off x="306569" y="538361"/>
              <a:ext cx="3167491" cy="3496676"/>
              <a:chOff x="306569" y="538361"/>
              <a:chExt cx="3167491" cy="3496676"/>
            </a:xfrm>
          </p:grpSpPr>
          <p:sp>
            <p:nvSpPr>
              <p:cNvPr id="5" name="Textfeld 4"/>
              <p:cNvSpPr txBox="1"/>
              <p:nvPr/>
            </p:nvSpPr>
            <p:spPr>
              <a:xfrm>
                <a:off x="2988860" y="1224745"/>
                <a:ext cx="485200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75</a:t>
                </a:r>
              </a:p>
            </p:txBody>
          </p:sp>
          <p:sp>
            <p:nvSpPr>
              <p:cNvPr id="6" name="Textfeld 5"/>
              <p:cNvSpPr txBox="1"/>
              <p:nvPr/>
            </p:nvSpPr>
            <p:spPr>
              <a:xfrm>
                <a:off x="390768" y="1246754"/>
                <a:ext cx="940065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PRMT5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" name="Picture 2" descr="G:\AG_Lavrik\Fabian\Experimente\V20190305 MMA-IP with SKW 6.4 cells and CD05 stimulation\1.pRMT5\marker+Wohlfromm, Fabian 2019-03-13 10hr 14min_Exposure_8.0sec.tif"/>
              <p:cNvPicPr>
                <a:picLocks noChangeAspect="1" noChangeArrowheads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414" t="12201" r="4089" b="79445"/>
              <a:stretch/>
            </p:blipFill>
            <p:spPr bwMode="auto">
              <a:xfrm>
                <a:off x="1267231" y="1280763"/>
                <a:ext cx="1800000" cy="17096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8" name="Picture 3" descr="G:\AG_Lavrik\Fabian\Experimente\V20190305 MMA-IP with SKW 6.4 cells and CD05 stimulation\2.WD45\marker+Wohlfromm, Fabian 2019-03-14 10hr 35min_Exposure_9.0sec.tif"/>
              <p:cNvPicPr>
                <a:picLocks noChangeAspect="1" noChangeArrowheads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588" t="24191" r="1916" b="67734"/>
              <a:stretch/>
            </p:blipFill>
            <p:spPr bwMode="auto">
              <a:xfrm>
                <a:off x="1267231" y="1467852"/>
                <a:ext cx="1800000" cy="17214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9" name="Textfeld 8"/>
              <p:cNvSpPr txBox="1"/>
              <p:nvPr/>
            </p:nvSpPr>
            <p:spPr>
              <a:xfrm>
                <a:off x="2988860" y="1480963"/>
                <a:ext cx="485200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37</a:t>
                </a:r>
              </a:p>
            </p:txBody>
          </p:sp>
          <p:sp>
            <p:nvSpPr>
              <p:cNvPr id="10" name="Textfeld 9"/>
              <p:cNvSpPr txBox="1"/>
              <p:nvPr/>
            </p:nvSpPr>
            <p:spPr>
              <a:xfrm>
                <a:off x="390768" y="1420664"/>
                <a:ext cx="940065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WD45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1" name="Picture 4" descr="G:\AG_Lavrik\Fabian\Experimente\V20190305 MMA-IP with SKW 6.4 cells and CD05 stimulation\3.RIOK1\Wohlfromm, Fabian 2019-03-15 11hr 03min_Exposure_19.6sec+marker.tif"/>
              <p:cNvPicPr>
                <a:picLocks noChangeAspect="1" noChangeArrowheads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875" t="5593" r="3262" b="82650"/>
              <a:stretch/>
            </p:blipFill>
            <p:spPr bwMode="auto">
              <a:xfrm>
                <a:off x="1267231" y="1643409"/>
                <a:ext cx="1800000" cy="23232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2" name="Textfeld 11"/>
              <p:cNvSpPr txBox="1"/>
              <p:nvPr/>
            </p:nvSpPr>
            <p:spPr>
              <a:xfrm>
                <a:off x="390768" y="1648113"/>
                <a:ext cx="940065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RIOK1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feld 12"/>
              <p:cNvSpPr txBox="1"/>
              <p:nvPr/>
            </p:nvSpPr>
            <p:spPr>
              <a:xfrm>
                <a:off x="2988860" y="1701770"/>
                <a:ext cx="485200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75</a:t>
                </a:r>
              </a:p>
            </p:txBody>
          </p:sp>
          <p:pic>
            <p:nvPicPr>
              <p:cNvPr id="14" name="Picture 2" descr="G:\AG_Lavrik\Fabian\Experimente\V20190305 MMA-IP with SKW 6.4 cells and CD05 stimulation\4.MMA\marker+Wohlfromm, Fabian 2019-03-19 13hr 02min_Exposure_1.0sec.tif"/>
              <p:cNvPicPr>
                <a:picLocks noChangeAspect="1" noChangeArrowheads="1"/>
              </p:cNvPicPr>
              <p:nvPr/>
            </p:nvPicPr>
            <p:blipFill rotWithShape="1"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512" t="13138" r="2150" b="43073"/>
              <a:stretch/>
            </p:blipFill>
            <p:spPr bwMode="auto">
              <a:xfrm>
                <a:off x="1267231" y="2670782"/>
                <a:ext cx="1800000" cy="861486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15" name="Textfeld 14"/>
              <p:cNvSpPr txBox="1"/>
              <p:nvPr/>
            </p:nvSpPr>
            <p:spPr>
              <a:xfrm>
                <a:off x="306569" y="2904154"/>
                <a:ext cx="1024264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 Anti-MMA WB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feld 15"/>
              <p:cNvSpPr txBox="1"/>
              <p:nvPr/>
            </p:nvSpPr>
            <p:spPr>
              <a:xfrm>
                <a:off x="2988860" y="2129000"/>
                <a:ext cx="485200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37</a:t>
                </a:r>
              </a:p>
            </p:txBody>
          </p:sp>
          <p:sp>
            <p:nvSpPr>
              <p:cNvPr id="17" name="Textfeld 16"/>
              <p:cNvSpPr txBox="1"/>
              <p:nvPr/>
            </p:nvSpPr>
            <p:spPr>
              <a:xfrm>
                <a:off x="2988860" y="2796433"/>
                <a:ext cx="485200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50</a:t>
                </a:r>
              </a:p>
            </p:txBody>
          </p:sp>
          <p:sp>
            <p:nvSpPr>
              <p:cNvPr id="18" name="Textfeld 17"/>
              <p:cNvSpPr txBox="1"/>
              <p:nvPr/>
            </p:nvSpPr>
            <p:spPr>
              <a:xfrm>
                <a:off x="2988860" y="2454169"/>
                <a:ext cx="485200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25</a:t>
                </a:r>
              </a:p>
            </p:txBody>
          </p:sp>
          <p:pic>
            <p:nvPicPr>
              <p:cNvPr id="19" name="Picture 3" descr="G:\AG_Lavrik\Fabian\Experimente\V20190305 MMA-IP with SKW 6.4 cells and CD05 stimulation\5.Casp.8b\marker+Wohlfromm, Fabian 2019-03-20 10hr 28min_Exposure_63.6sec.tif"/>
              <p:cNvPicPr>
                <a:picLocks noChangeAspect="1" noChangeArrowheads="1"/>
              </p:cNvPicPr>
              <p:nvPr/>
            </p:nvPicPr>
            <p:blipFill rotWithShape="1"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720" t="17193" r="1487" b="43757"/>
              <a:stretch/>
            </p:blipFill>
            <p:spPr bwMode="auto">
              <a:xfrm>
                <a:off x="1267231" y="1884293"/>
                <a:ext cx="1800000" cy="78648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0" name="Textfeld 19"/>
              <p:cNvSpPr txBox="1"/>
              <p:nvPr/>
            </p:nvSpPr>
            <p:spPr>
              <a:xfrm>
                <a:off x="2988860" y="3011875"/>
                <a:ext cx="485200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37</a:t>
                </a:r>
              </a:p>
            </p:txBody>
          </p:sp>
          <p:sp>
            <p:nvSpPr>
              <p:cNvPr id="21" name="Textfeld 20"/>
              <p:cNvSpPr txBox="1"/>
              <p:nvPr/>
            </p:nvSpPr>
            <p:spPr>
              <a:xfrm>
                <a:off x="2988860" y="3310105"/>
                <a:ext cx="485200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25</a:t>
                </a:r>
              </a:p>
            </p:txBody>
          </p:sp>
          <p:sp>
            <p:nvSpPr>
              <p:cNvPr id="22" name="Textfeld 21"/>
              <p:cNvSpPr txBox="1"/>
              <p:nvPr/>
            </p:nvSpPr>
            <p:spPr>
              <a:xfrm>
                <a:off x="2988860" y="1938203"/>
                <a:ext cx="485200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50</a:t>
                </a:r>
              </a:p>
            </p:txBody>
          </p:sp>
          <p:pic>
            <p:nvPicPr>
              <p:cNvPr id="23" name="Picture 5" descr="G:\AG_Lavrik\Fabian\Experimente\V20190305 MMA-IP with SKW 6.4 cells and CD05 stimulation\7.GAPDH\Wohlfromm, Fabian 2019-03-22 09hr 47min_Exposure_47.6sec+marker.tif"/>
              <p:cNvPicPr>
                <a:picLocks noChangeAspect="1" noChangeArrowheads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545" t="35110" r="50292" b="53923"/>
              <a:stretch/>
            </p:blipFill>
            <p:spPr bwMode="auto">
              <a:xfrm>
                <a:off x="1267231" y="3802644"/>
                <a:ext cx="823182" cy="22583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4" name="Textfeld 23"/>
              <p:cNvSpPr txBox="1"/>
              <p:nvPr/>
            </p:nvSpPr>
            <p:spPr>
              <a:xfrm>
                <a:off x="2988860" y="3739980"/>
                <a:ext cx="485200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37</a:t>
                </a:r>
              </a:p>
            </p:txBody>
          </p:sp>
          <p:sp>
            <p:nvSpPr>
              <p:cNvPr id="25" name="Textfeld 24"/>
              <p:cNvSpPr txBox="1"/>
              <p:nvPr/>
            </p:nvSpPr>
            <p:spPr>
              <a:xfrm>
                <a:off x="390768" y="3807756"/>
                <a:ext cx="940065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GAPDH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6" name="Picture 2" descr="G:\AG_Lavrik\Fabian\Experimente\V20190305 MMA-IP with SKW 6.4 cells and CD05 stimulation\8.FADD\marker+Wohlfromm, Fabian 2019-03-26 10hr 17min_Exposure_76.2sec.tif"/>
              <p:cNvPicPr>
                <a:picLocks noChangeAspect="1" noChangeArrowheads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037" t="41762" r="9813" b="46641"/>
              <a:stretch/>
            </p:blipFill>
            <p:spPr bwMode="auto">
              <a:xfrm>
                <a:off x="1267231" y="3544330"/>
                <a:ext cx="1800000" cy="24787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27" name="Textfeld 26"/>
              <p:cNvSpPr txBox="1"/>
              <p:nvPr/>
            </p:nvSpPr>
            <p:spPr>
              <a:xfrm>
                <a:off x="390768" y="3541500"/>
                <a:ext cx="940065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FADD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feld 29"/>
              <p:cNvSpPr txBox="1"/>
              <p:nvPr/>
            </p:nvSpPr>
            <p:spPr>
              <a:xfrm>
                <a:off x="1202511" y="767494"/>
                <a:ext cx="792000" cy="227281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Input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feld 30"/>
              <p:cNvSpPr txBox="1"/>
              <p:nvPr/>
            </p:nvSpPr>
            <p:spPr>
              <a:xfrm>
                <a:off x="2052274" y="774182"/>
                <a:ext cx="972114" cy="227281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MMA-IP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2" name="Gerade Verbindung 14"/>
              <p:cNvCxnSpPr/>
              <p:nvPr/>
            </p:nvCxnSpPr>
            <p:spPr>
              <a:xfrm flipH="1" flipV="1">
                <a:off x="1202511" y="995545"/>
                <a:ext cx="79200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3" name="Textfeld 32"/>
              <p:cNvSpPr txBox="1"/>
              <p:nvPr/>
            </p:nvSpPr>
            <p:spPr>
              <a:xfrm>
                <a:off x="2988860" y="1111314"/>
                <a:ext cx="436788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feld 33"/>
              <p:cNvSpPr txBox="1"/>
              <p:nvPr/>
            </p:nvSpPr>
            <p:spPr>
              <a:xfrm>
                <a:off x="1230582" y="1063610"/>
                <a:ext cx="163927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35" name="Textfeld 34"/>
              <p:cNvSpPr txBox="1"/>
              <p:nvPr/>
            </p:nvSpPr>
            <p:spPr>
              <a:xfrm>
                <a:off x="1379941" y="1063610"/>
                <a:ext cx="363027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36" name="Textfeld 35"/>
              <p:cNvSpPr txBox="1"/>
              <p:nvPr/>
            </p:nvSpPr>
            <p:spPr>
              <a:xfrm>
                <a:off x="1608109" y="1063610"/>
                <a:ext cx="356353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37" name="Textfeld 36"/>
              <p:cNvSpPr txBox="1"/>
              <p:nvPr/>
            </p:nvSpPr>
            <p:spPr>
              <a:xfrm>
                <a:off x="2087808" y="1063610"/>
                <a:ext cx="163927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38" name="Textfeld 37"/>
              <p:cNvSpPr txBox="1"/>
              <p:nvPr/>
            </p:nvSpPr>
            <p:spPr>
              <a:xfrm>
                <a:off x="2185216" y="1063610"/>
                <a:ext cx="353792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39" name="Textfeld 38"/>
              <p:cNvSpPr txBox="1"/>
              <p:nvPr/>
            </p:nvSpPr>
            <p:spPr>
              <a:xfrm>
                <a:off x="2412967" y="1063610"/>
                <a:ext cx="348774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40" name="Textfeld 39"/>
              <p:cNvSpPr txBox="1"/>
              <p:nvPr/>
            </p:nvSpPr>
            <p:spPr>
              <a:xfrm>
                <a:off x="2599683" y="1063610"/>
                <a:ext cx="358580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41" name="Textfeld 40"/>
              <p:cNvSpPr txBox="1"/>
              <p:nvPr/>
            </p:nvSpPr>
            <p:spPr>
              <a:xfrm>
                <a:off x="2885123" y="1063610"/>
                <a:ext cx="123158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42" name="Textfeld 41"/>
              <p:cNvSpPr txBox="1"/>
              <p:nvPr/>
            </p:nvSpPr>
            <p:spPr>
              <a:xfrm>
                <a:off x="505307" y="1049930"/>
                <a:ext cx="825526" cy="227281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[min]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3" name="Gerade Verbindung 14"/>
              <p:cNvCxnSpPr/>
              <p:nvPr/>
            </p:nvCxnSpPr>
            <p:spPr>
              <a:xfrm flipH="1">
                <a:off x="2052276" y="995545"/>
                <a:ext cx="972115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4" name="Textfeld 43"/>
              <p:cNvSpPr txBox="1"/>
              <p:nvPr/>
            </p:nvSpPr>
            <p:spPr>
              <a:xfrm>
                <a:off x="1802189" y="1063610"/>
                <a:ext cx="349585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46" name="Textfeld 45"/>
              <p:cNvSpPr txBox="1"/>
              <p:nvPr/>
            </p:nvSpPr>
            <p:spPr>
              <a:xfrm>
                <a:off x="2988860" y="3602838"/>
                <a:ext cx="485200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-25</a:t>
                </a:r>
              </a:p>
            </p:txBody>
          </p:sp>
          <p:sp>
            <p:nvSpPr>
              <p:cNvPr id="47" name="Textfeld 46"/>
              <p:cNvSpPr txBox="1"/>
              <p:nvPr/>
            </p:nvSpPr>
            <p:spPr>
              <a:xfrm>
                <a:off x="1127576" y="538361"/>
                <a:ext cx="1996234" cy="227281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200 </a:t>
                </a:r>
                <a:r>
                  <a:rPr lang="de-DE" sz="600" dirty="0" err="1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ng</a:t>
                </a:r>
                <a:r>
                  <a:rPr lang="de-DE" sz="600" dirty="0">
                    <a:latin typeface="Arial" panose="020B0604020202020204" pitchFamily="34" charset="0"/>
                    <a:cs typeface="Arial" panose="020B0604020202020204" pitchFamily="34" charset="0"/>
                    <a:sym typeface="Wingdings" panose="05000000000000000000" pitchFamily="2" charset="2"/>
                  </a:rPr>
                  <a:t>/ml CD95L</a:t>
                </a:r>
                <a:endParaRPr lang="de-DE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84" name="Textfeld 183"/>
            <p:cNvSpPr txBox="1"/>
            <p:nvPr/>
          </p:nvSpPr>
          <p:spPr>
            <a:xfrm>
              <a:off x="306568" y="1897833"/>
              <a:ext cx="1024265" cy="2272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de-DE" sz="600" dirty="0">
                  <a:latin typeface="Arial" panose="020B060402020202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procaspase-8</a:t>
              </a:r>
              <a:endParaRPr lang="de-DE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88" name="Textfeld 187"/>
          <p:cNvSpPr txBox="1"/>
          <p:nvPr/>
        </p:nvSpPr>
        <p:spPr>
          <a:xfrm>
            <a:off x="949808" y="306870"/>
            <a:ext cx="892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19" name="Textfeld 218"/>
          <p:cNvSpPr txBox="1"/>
          <p:nvPr/>
        </p:nvSpPr>
        <p:spPr>
          <a:xfrm>
            <a:off x="863401" y="3021682"/>
            <a:ext cx="1742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22" name="Textfeld 221"/>
          <p:cNvSpPr txBox="1"/>
          <p:nvPr/>
        </p:nvSpPr>
        <p:spPr>
          <a:xfrm>
            <a:off x="828736" y="1087528"/>
            <a:ext cx="101521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 err="1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IgG</a:t>
            </a:r>
            <a:r>
              <a:rPr lang="de-DE" sz="600" baseline="-25000" dirty="0" err="1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H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</a:t>
            </a:r>
            <a:endParaRPr lang="de-DE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Textfeld 231"/>
          <p:cNvSpPr txBox="1"/>
          <p:nvPr/>
        </p:nvSpPr>
        <p:spPr>
          <a:xfrm>
            <a:off x="642938" y="1001280"/>
            <a:ext cx="124454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potential </a:t>
            </a:r>
            <a:r>
              <a:rPr lang="de-DE" sz="600" dirty="0" err="1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area</a:t>
            </a:r>
            <a:r>
              <a:rPr lang="de-DE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</a:t>
            </a:r>
            <a:r>
              <a:rPr lang="de-DE" sz="600" dirty="0" err="1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of</a:t>
            </a:r>
            <a:r>
              <a:rPr lang="de-DE" sz="6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  <a:sym typeface="Wingdings" panose="05000000000000000000" pitchFamily="2" charset="2"/>
              </a:rPr>
              <a:t> caspase-8</a:t>
            </a:r>
            <a:endParaRPr lang="de-DE" sz="6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Rechteck 235"/>
          <p:cNvSpPr/>
          <p:nvPr/>
        </p:nvSpPr>
        <p:spPr>
          <a:xfrm>
            <a:off x="1848164" y="1066150"/>
            <a:ext cx="2193750" cy="68852"/>
          </a:xfrm>
          <a:prstGeom prst="rect">
            <a:avLst/>
          </a:prstGeom>
          <a:noFill/>
          <a:ln>
            <a:solidFill>
              <a:srgbClr val="0070C0"/>
            </a:solidFill>
            <a:prstDash val="dashDot"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 sz="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feld 96"/>
          <p:cNvSpPr txBox="1"/>
          <p:nvPr/>
        </p:nvSpPr>
        <p:spPr>
          <a:xfrm>
            <a:off x="1833054" y="309166"/>
            <a:ext cx="220762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KW 6.4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feld 97"/>
          <p:cNvSpPr txBox="1"/>
          <p:nvPr/>
        </p:nvSpPr>
        <p:spPr>
          <a:xfrm>
            <a:off x="1917262" y="3229246"/>
            <a:ext cx="145681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KW 6.4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95702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Textfeld 31"/>
          <p:cNvSpPr txBox="1"/>
          <p:nvPr/>
        </p:nvSpPr>
        <p:spPr>
          <a:xfrm>
            <a:off x="642938" y="212968"/>
            <a:ext cx="1387569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63" dirty="0" smtClean="0">
                <a:latin typeface="Arial" panose="020B0604020202020204" pitchFamily="34" charset="0"/>
                <a:cs typeface="Arial" panose="020B0604020202020204" pitchFamily="34" charset="0"/>
              </a:rPr>
              <a:t>Fig. 6 </a:t>
            </a:r>
            <a:endParaRPr lang="en-GB" sz="146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uppieren 1"/>
          <p:cNvGrpSpPr/>
          <p:nvPr/>
        </p:nvGrpSpPr>
        <p:grpSpPr>
          <a:xfrm>
            <a:off x="885174" y="814792"/>
            <a:ext cx="2085860" cy="1689055"/>
            <a:chOff x="885174" y="1129108"/>
            <a:chExt cx="2085860" cy="1689055"/>
          </a:xfrm>
        </p:grpSpPr>
        <p:graphicFrame>
          <p:nvGraphicFramePr>
            <p:cNvPr id="103" name="Diagramm 10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4790457"/>
                </p:ext>
              </p:extLst>
            </p:nvPr>
          </p:nvGraphicFramePr>
          <p:xfrm>
            <a:off x="1251963" y="1129108"/>
            <a:ext cx="1440000" cy="14625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04" name="Textfeld 103"/>
            <p:cNvSpPr txBox="1"/>
            <p:nvPr/>
          </p:nvSpPr>
          <p:spPr>
            <a:xfrm>
              <a:off x="885174" y="2541164"/>
              <a:ext cx="20858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95L </a:t>
              </a:r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[250ng/ml</a:t>
              </a:r>
              <a:r>
                <a:rPr lang="en-GB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]  </a:t>
              </a:r>
              <a:r>
                <a:rPr lang="en-GB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-     +     -      </a:t>
              </a:r>
              <a:r>
                <a:rPr lang="en-GB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    -     +    +    </a:t>
              </a:r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AMI-5 [µM] </a:t>
              </a:r>
              <a:r>
                <a:rPr lang="en-GB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	            -     -	 10   50 100 </a:t>
              </a:r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10 </a:t>
              </a:r>
              <a:r>
                <a:rPr lang="en-GB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GB" sz="6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6" name="Gruppieren 105"/>
            <p:cNvGrpSpPr/>
            <p:nvPr/>
          </p:nvGrpSpPr>
          <p:grpSpPr>
            <a:xfrm>
              <a:off x="1795018" y="1316273"/>
              <a:ext cx="789750" cy="202763"/>
              <a:chOff x="1133482" y="5964286"/>
              <a:chExt cx="972000" cy="249554"/>
            </a:xfrm>
          </p:grpSpPr>
          <p:cxnSp>
            <p:nvCxnSpPr>
              <p:cNvPr id="107" name="Gerader Verbinder 106"/>
              <p:cNvCxnSpPr/>
              <p:nvPr/>
            </p:nvCxnSpPr>
            <p:spPr>
              <a:xfrm>
                <a:off x="1133482" y="6123099"/>
                <a:ext cx="97200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8" name="Gerader Verbinder 107"/>
              <p:cNvCxnSpPr/>
              <p:nvPr/>
            </p:nvCxnSpPr>
            <p:spPr>
              <a:xfrm>
                <a:off x="1141434" y="6123840"/>
                <a:ext cx="0" cy="9000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9" name="Textfeld 108"/>
              <p:cNvSpPr txBox="1"/>
              <p:nvPr/>
            </p:nvSpPr>
            <p:spPr>
              <a:xfrm>
                <a:off x="1451920" y="5964286"/>
                <a:ext cx="371193" cy="2272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110" name="Gerader Verbinder 109"/>
              <p:cNvCxnSpPr/>
              <p:nvPr/>
            </p:nvCxnSpPr>
            <p:spPr>
              <a:xfrm>
                <a:off x="2098040" y="6123840"/>
                <a:ext cx="0" cy="9000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</p:grpSp>
      <p:graphicFrame>
        <p:nvGraphicFramePr>
          <p:cNvPr id="37" name="Diagramm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06470526"/>
              </p:ext>
            </p:extLst>
          </p:nvPr>
        </p:nvGraphicFramePr>
        <p:xfrm>
          <a:off x="1103431" y="5616098"/>
          <a:ext cx="180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8" name="Textfeld 37"/>
          <p:cNvSpPr txBox="1"/>
          <p:nvPr/>
        </p:nvSpPr>
        <p:spPr>
          <a:xfrm>
            <a:off x="1638323" y="627147"/>
            <a:ext cx="96210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SKW 6.4</a:t>
            </a:r>
            <a:endParaRPr lang="en-GB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uppieren 2"/>
          <p:cNvGrpSpPr/>
          <p:nvPr/>
        </p:nvGrpSpPr>
        <p:grpSpPr>
          <a:xfrm>
            <a:off x="1069547" y="2993700"/>
            <a:ext cx="1800000" cy="2209386"/>
            <a:chOff x="1130507" y="3517453"/>
            <a:chExt cx="1800000" cy="2209386"/>
          </a:xfrm>
        </p:grpSpPr>
        <p:graphicFrame>
          <p:nvGraphicFramePr>
            <p:cNvPr id="11" name="Diagramm 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91644946"/>
                </p:ext>
              </p:extLst>
            </p:nvPr>
          </p:nvGraphicFramePr>
          <p:xfrm>
            <a:off x="1130507" y="3736359"/>
            <a:ext cx="1800000" cy="180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2" name="Textfeld 11"/>
            <p:cNvSpPr txBox="1"/>
            <p:nvPr/>
          </p:nvSpPr>
          <p:spPr>
            <a:xfrm>
              <a:off x="1327110" y="5449841"/>
              <a:ext cx="66674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untransfected</a:t>
              </a:r>
              <a:endParaRPr lang="en-GB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1928104" y="5449840"/>
              <a:ext cx="46928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b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2382139" y="5449839"/>
              <a:ext cx="4753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b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PRMT5</a:t>
              </a:r>
            </a:p>
          </p:txBody>
        </p:sp>
        <p:grpSp>
          <p:nvGrpSpPr>
            <p:cNvPr id="15" name="Gruppieren 14"/>
            <p:cNvGrpSpPr/>
            <p:nvPr/>
          </p:nvGrpSpPr>
          <p:grpSpPr>
            <a:xfrm>
              <a:off x="2251227" y="4181571"/>
              <a:ext cx="443312" cy="217851"/>
              <a:chOff x="4719971" y="3024851"/>
              <a:chExt cx="468001" cy="217851"/>
            </a:xfrm>
          </p:grpSpPr>
          <p:sp>
            <p:nvSpPr>
              <p:cNvPr id="16" name="Textfeld 15"/>
              <p:cNvSpPr txBox="1"/>
              <p:nvPr/>
            </p:nvSpPr>
            <p:spPr>
              <a:xfrm>
                <a:off x="4719971" y="3024851"/>
                <a:ext cx="40447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</a:p>
            </p:txBody>
          </p:sp>
          <p:cxnSp>
            <p:nvCxnSpPr>
              <p:cNvPr id="17" name="Gerader Verbinder 16"/>
              <p:cNvCxnSpPr/>
              <p:nvPr/>
            </p:nvCxnSpPr>
            <p:spPr>
              <a:xfrm flipV="1">
                <a:off x="4719972" y="3170702"/>
                <a:ext cx="468000" cy="1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8" name="Gerader Verbinder 17"/>
              <p:cNvCxnSpPr/>
              <p:nvPr/>
            </p:nvCxnSpPr>
            <p:spPr>
              <a:xfrm>
                <a:off x="5182681" y="3170702"/>
                <a:ext cx="0" cy="7200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9" name="Gerader Verbinder 18"/>
              <p:cNvCxnSpPr/>
              <p:nvPr/>
            </p:nvCxnSpPr>
            <p:spPr>
              <a:xfrm>
                <a:off x="4719972" y="3170702"/>
                <a:ext cx="0" cy="7200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0" name="Gruppieren 19"/>
            <p:cNvGrpSpPr/>
            <p:nvPr/>
          </p:nvGrpSpPr>
          <p:grpSpPr>
            <a:xfrm>
              <a:off x="1804055" y="4030718"/>
              <a:ext cx="888048" cy="234465"/>
              <a:chOff x="4270178" y="2870928"/>
              <a:chExt cx="909931" cy="234465"/>
            </a:xfrm>
          </p:grpSpPr>
          <p:sp>
            <p:nvSpPr>
              <p:cNvPr id="21" name="Textfeld 20"/>
              <p:cNvSpPr txBox="1"/>
              <p:nvPr/>
            </p:nvSpPr>
            <p:spPr>
              <a:xfrm>
                <a:off x="4520821" y="2870928"/>
                <a:ext cx="39830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</a:p>
            </p:txBody>
          </p:sp>
          <p:cxnSp>
            <p:nvCxnSpPr>
              <p:cNvPr id="22" name="Gerader Verbinder 21"/>
              <p:cNvCxnSpPr/>
              <p:nvPr/>
            </p:nvCxnSpPr>
            <p:spPr>
              <a:xfrm flipV="1">
                <a:off x="4270178" y="3031266"/>
                <a:ext cx="907200" cy="1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3" name="Gerader Verbinder 22"/>
              <p:cNvCxnSpPr/>
              <p:nvPr/>
            </p:nvCxnSpPr>
            <p:spPr>
              <a:xfrm>
                <a:off x="5180109" y="3024725"/>
                <a:ext cx="0" cy="7200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4" name="Gerader Verbinder 23"/>
              <p:cNvCxnSpPr/>
              <p:nvPr/>
            </p:nvCxnSpPr>
            <p:spPr>
              <a:xfrm>
                <a:off x="4271031" y="3033393"/>
                <a:ext cx="0" cy="7200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uppieren 24"/>
            <p:cNvGrpSpPr/>
            <p:nvPr/>
          </p:nvGrpSpPr>
          <p:grpSpPr>
            <a:xfrm>
              <a:off x="1455555" y="3962524"/>
              <a:ext cx="485619" cy="211171"/>
              <a:chOff x="5976449" y="5627932"/>
              <a:chExt cx="380290" cy="211171"/>
            </a:xfrm>
          </p:grpSpPr>
          <p:cxnSp>
            <p:nvCxnSpPr>
              <p:cNvPr id="26" name="Gerader Verbinder 25"/>
              <p:cNvCxnSpPr/>
              <p:nvPr/>
            </p:nvCxnSpPr>
            <p:spPr>
              <a:xfrm>
                <a:off x="6076516" y="5767104"/>
                <a:ext cx="18000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" name="Gerader Verbinder 26"/>
              <p:cNvCxnSpPr/>
              <p:nvPr/>
            </p:nvCxnSpPr>
            <p:spPr>
              <a:xfrm>
                <a:off x="6252994" y="5767103"/>
                <a:ext cx="0" cy="7200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" name="Gerader Verbinder 27"/>
              <p:cNvCxnSpPr/>
              <p:nvPr/>
            </p:nvCxnSpPr>
            <p:spPr>
              <a:xfrm>
                <a:off x="6079595" y="5767103"/>
                <a:ext cx="0" cy="7200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9" name="Textfeld 28"/>
              <p:cNvSpPr txBox="1"/>
              <p:nvPr/>
            </p:nvSpPr>
            <p:spPr>
              <a:xfrm>
                <a:off x="5976449" y="5627932"/>
                <a:ext cx="38029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  <p:grpSp>
          <p:nvGrpSpPr>
            <p:cNvPr id="30" name="Gruppieren 29"/>
            <p:cNvGrpSpPr/>
            <p:nvPr/>
          </p:nvGrpSpPr>
          <p:grpSpPr>
            <a:xfrm>
              <a:off x="2449257" y="4328209"/>
              <a:ext cx="311973" cy="234465"/>
              <a:chOff x="4054064" y="2870928"/>
              <a:chExt cx="1434352" cy="234465"/>
            </a:xfrm>
          </p:grpSpPr>
          <p:sp>
            <p:nvSpPr>
              <p:cNvPr id="31" name="Textfeld 30"/>
              <p:cNvSpPr txBox="1"/>
              <p:nvPr/>
            </p:nvSpPr>
            <p:spPr>
              <a:xfrm>
                <a:off x="4054064" y="2870928"/>
                <a:ext cx="143435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cxnSp>
            <p:nvCxnSpPr>
              <p:cNvPr id="33" name="Gerader Verbinder 32"/>
              <p:cNvCxnSpPr/>
              <p:nvPr/>
            </p:nvCxnSpPr>
            <p:spPr>
              <a:xfrm flipV="1">
                <a:off x="4270178" y="3031266"/>
                <a:ext cx="907200" cy="1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4" name="Gerader Verbinder 33"/>
              <p:cNvCxnSpPr/>
              <p:nvPr/>
            </p:nvCxnSpPr>
            <p:spPr>
              <a:xfrm>
                <a:off x="5180109" y="3024725"/>
                <a:ext cx="0" cy="7200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5" name="Gerader Verbinder 34"/>
              <p:cNvCxnSpPr/>
              <p:nvPr/>
            </p:nvCxnSpPr>
            <p:spPr>
              <a:xfrm>
                <a:off x="4271031" y="3033393"/>
                <a:ext cx="0" cy="7200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6" name="Textfeld 35"/>
            <p:cNvSpPr txBox="1"/>
            <p:nvPr/>
          </p:nvSpPr>
          <p:spPr>
            <a:xfrm>
              <a:off x="1583338" y="3517453"/>
              <a:ext cx="96210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600" dirty="0">
                  <a:latin typeface="Arial" panose="020B0604020202020204" pitchFamily="34" charset="0"/>
                  <a:cs typeface="Arial" panose="020B0604020202020204" pitchFamily="34" charset="0"/>
                </a:rPr>
                <a:t>HeLa-CD95</a:t>
              </a:r>
            </a:p>
          </p:txBody>
        </p:sp>
        <p:grpSp>
          <p:nvGrpSpPr>
            <p:cNvPr id="39" name="Gruppieren 38"/>
            <p:cNvGrpSpPr/>
            <p:nvPr/>
          </p:nvGrpSpPr>
          <p:grpSpPr>
            <a:xfrm>
              <a:off x="1919937" y="3874299"/>
              <a:ext cx="485619" cy="211171"/>
              <a:chOff x="5976449" y="5627932"/>
              <a:chExt cx="380290" cy="211171"/>
            </a:xfrm>
          </p:grpSpPr>
          <p:cxnSp>
            <p:nvCxnSpPr>
              <p:cNvPr id="40" name="Gerader Verbinder 39"/>
              <p:cNvCxnSpPr/>
              <p:nvPr/>
            </p:nvCxnSpPr>
            <p:spPr>
              <a:xfrm>
                <a:off x="6076516" y="5767104"/>
                <a:ext cx="180000" cy="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1" name="Gerader Verbinder 40"/>
              <p:cNvCxnSpPr/>
              <p:nvPr/>
            </p:nvCxnSpPr>
            <p:spPr>
              <a:xfrm>
                <a:off x="6252994" y="5767103"/>
                <a:ext cx="0" cy="7200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2" name="Gerader Verbinder 41"/>
              <p:cNvCxnSpPr/>
              <p:nvPr/>
            </p:nvCxnSpPr>
            <p:spPr>
              <a:xfrm>
                <a:off x="6079595" y="5767103"/>
                <a:ext cx="0" cy="72000"/>
              </a:xfrm>
              <a:prstGeom prst="line">
                <a:avLst/>
              </a:prstGeom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3" name="Textfeld 42"/>
              <p:cNvSpPr txBox="1"/>
              <p:nvPr/>
            </p:nvSpPr>
            <p:spPr>
              <a:xfrm>
                <a:off x="5976449" y="5627932"/>
                <a:ext cx="38029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****</a:t>
                </a:r>
              </a:p>
            </p:txBody>
          </p:sp>
        </p:grpSp>
      </p:grpSp>
      <p:sp>
        <p:nvSpPr>
          <p:cNvPr id="45" name="Textfeld 44"/>
          <p:cNvSpPr txBox="1"/>
          <p:nvPr/>
        </p:nvSpPr>
        <p:spPr>
          <a:xfrm>
            <a:off x="1490205" y="5390851"/>
            <a:ext cx="96210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HeLa-CD95</a:t>
            </a:r>
          </a:p>
        </p:txBody>
      </p:sp>
      <p:sp>
        <p:nvSpPr>
          <p:cNvPr id="47" name="Textfeld 46"/>
          <p:cNvSpPr txBox="1"/>
          <p:nvPr/>
        </p:nvSpPr>
        <p:spPr>
          <a:xfrm>
            <a:off x="863401" y="2623472"/>
            <a:ext cx="174269" cy="2674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38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8" name="Textfeld 47"/>
          <p:cNvSpPr txBox="1"/>
          <p:nvPr/>
        </p:nvSpPr>
        <p:spPr>
          <a:xfrm>
            <a:off x="863401" y="5257128"/>
            <a:ext cx="174269" cy="2674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38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9" name="Textfeld 48"/>
          <p:cNvSpPr txBox="1"/>
          <p:nvPr/>
        </p:nvSpPr>
        <p:spPr>
          <a:xfrm>
            <a:off x="863401" y="483637"/>
            <a:ext cx="174269" cy="2674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138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13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04394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73</Words>
  <Application>Microsoft Office PowerPoint</Application>
  <PresentationFormat>A4-Papier (210 x 297 mm)</PresentationFormat>
  <Paragraphs>436</Paragraphs>
  <Slides>6</Slides>
  <Notes>3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Wingdings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MM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ohlfromm, Fabian</dc:creator>
  <cp:lastModifiedBy>Wohlfromm, Fabian</cp:lastModifiedBy>
  <cp:revision>164</cp:revision>
  <cp:lastPrinted>2024-01-23T11:42:37Z</cp:lastPrinted>
  <dcterms:created xsi:type="dcterms:W3CDTF">2022-10-24T14:11:18Z</dcterms:created>
  <dcterms:modified xsi:type="dcterms:W3CDTF">2024-03-26T12:16:18Z</dcterms:modified>
</cp:coreProperties>
</file>